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10.xml" ContentType="application/vnd.openxmlformats-officedocument.presentationml.notesSlide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26"/>
  </p:notesMasterIdLst>
  <p:sldIdLst>
    <p:sldId id="594" r:id="rId2"/>
    <p:sldId id="595" r:id="rId3"/>
    <p:sldId id="262" r:id="rId4"/>
    <p:sldId id="263" r:id="rId5"/>
    <p:sldId id="591" r:id="rId6"/>
    <p:sldId id="588" r:id="rId7"/>
    <p:sldId id="589" r:id="rId8"/>
    <p:sldId id="590" r:id="rId9"/>
    <p:sldId id="261" r:id="rId10"/>
    <p:sldId id="587" r:id="rId11"/>
    <p:sldId id="592" r:id="rId12"/>
    <p:sldId id="257" r:id="rId13"/>
    <p:sldId id="259" r:id="rId14"/>
    <p:sldId id="260" r:id="rId15"/>
    <p:sldId id="593" r:id="rId16"/>
    <p:sldId id="598" r:id="rId17"/>
    <p:sldId id="596" r:id="rId18"/>
    <p:sldId id="693" r:id="rId19"/>
    <p:sldId id="599" r:id="rId20"/>
    <p:sldId id="597" r:id="rId21"/>
    <p:sldId id="694" r:id="rId22"/>
    <p:sldId id="695" r:id="rId23"/>
    <p:sldId id="601" r:id="rId24"/>
    <p:sldId id="264" r:id="rId2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5D78D8C-B54E-46C2-B55D-78ED6F6588E0}" v="1" dt="2022-12-16T20:57:26.21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965" autoAdjust="0"/>
    <p:restoredTop sz="78261" autoAdjust="0"/>
  </p:normalViewPr>
  <p:slideViewPr>
    <p:cSldViewPr snapToGrid="0">
      <p:cViewPr>
        <p:scale>
          <a:sx n="89" d="100"/>
          <a:sy n="89" d="100"/>
        </p:scale>
        <p:origin x="211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microsoft.com/office/2015/10/relationships/revisionInfo" Target="revisionInfo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Xiang,Jenny Jing" userId="c0b1da7b-7211-47b3-b357-9d3cb7ffc9fa" providerId="ADAL" clId="{55D78D8C-B54E-46C2-B55D-78ED6F6588E0}"/>
    <pc:docChg chg="undo custSel modSld sldOrd modMainMaster modNotesMaster">
      <pc:chgData name="Xiang,Jenny Jing" userId="c0b1da7b-7211-47b3-b357-9d3cb7ffc9fa" providerId="ADAL" clId="{55D78D8C-B54E-46C2-B55D-78ED6F6588E0}" dt="2022-12-16T21:05:53.041" v="45" actId="20578"/>
      <pc:docMkLst>
        <pc:docMk/>
      </pc:docMkLst>
      <pc:sldChg chg="modSp mod modNotes">
        <pc:chgData name="Xiang,Jenny Jing" userId="c0b1da7b-7211-47b3-b357-9d3cb7ffc9fa" providerId="ADAL" clId="{55D78D8C-B54E-46C2-B55D-78ED6F6588E0}" dt="2022-12-16T20:58:16.864" v="18" actId="27636"/>
        <pc:sldMkLst>
          <pc:docMk/>
          <pc:sldMk cId="1546438354" sldId="257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1546438354" sldId="257"/>
            <ac:spMk id="2" creationId="{B4381E50-9BF1-401B-9650-71E965C97915}"/>
          </ac:spMkLst>
        </pc:spChg>
        <pc:spChg chg="mod">
          <ac:chgData name="Xiang,Jenny Jing" userId="c0b1da7b-7211-47b3-b357-9d3cb7ffc9fa" providerId="ADAL" clId="{55D78D8C-B54E-46C2-B55D-78ED6F6588E0}" dt="2022-12-16T20:58:16.864" v="18" actId="27636"/>
          <ac:spMkLst>
            <pc:docMk/>
            <pc:sldMk cId="1546438354" sldId="257"/>
            <ac:spMk id="3" creationId="{4559872E-C6F3-470B-AEF1-339AEE629E5D}"/>
          </ac:spMkLst>
        </pc:spChg>
      </pc:sldChg>
      <pc:sldChg chg="modSp mod modNotes">
        <pc:chgData name="Xiang,Jenny Jing" userId="c0b1da7b-7211-47b3-b357-9d3cb7ffc9fa" providerId="ADAL" clId="{55D78D8C-B54E-46C2-B55D-78ED6F6588E0}" dt="2022-12-16T20:57:26.325" v="2" actId="27636"/>
        <pc:sldMkLst>
          <pc:docMk/>
          <pc:sldMk cId="1663587394" sldId="259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1663587394" sldId="259"/>
            <ac:spMk id="2" creationId="{A71F4507-F350-4790-AAFD-71A05FAA5B71}"/>
          </ac:spMkLst>
        </pc:spChg>
        <pc:spChg chg="mod">
          <ac:chgData name="Xiang,Jenny Jing" userId="c0b1da7b-7211-47b3-b357-9d3cb7ffc9fa" providerId="ADAL" clId="{55D78D8C-B54E-46C2-B55D-78ED6F6588E0}" dt="2022-12-16T20:57:26.325" v="2" actId="27636"/>
          <ac:spMkLst>
            <pc:docMk/>
            <pc:sldMk cId="1663587394" sldId="259"/>
            <ac:spMk id="3" creationId="{59A4EF3D-C460-432A-9CB7-76D89FE51DFF}"/>
          </ac:spMkLst>
        </pc:spChg>
      </pc:sldChg>
      <pc:sldChg chg="modSp">
        <pc:chgData name="Xiang,Jenny Jing" userId="c0b1da7b-7211-47b3-b357-9d3cb7ffc9fa" providerId="ADAL" clId="{55D78D8C-B54E-46C2-B55D-78ED6F6588E0}" dt="2022-12-16T20:57:26.213" v="1"/>
        <pc:sldMkLst>
          <pc:docMk/>
          <pc:sldMk cId="874212496" sldId="260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874212496" sldId="260"/>
            <ac:spMk id="2" creationId="{DD8B2317-557E-4A07-827F-6E1DCD06FE0B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874212496" sldId="260"/>
            <ac:spMk id="3" creationId="{E6F7FD96-9E4D-4349-BA4C-5CB7B9A82B0F}"/>
          </ac:spMkLst>
        </pc:spChg>
      </pc:sldChg>
      <pc:sldChg chg="modSp mod">
        <pc:chgData name="Xiang,Jenny Jing" userId="c0b1da7b-7211-47b3-b357-9d3cb7ffc9fa" providerId="ADAL" clId="{55D78D8C-B54E-46C2-B55D-78ED6F6588E0}" dt="2022-12-16T20:57:26.341" v="4" actId="27636"/>
        <pc:sldMkLst>
          <pc:docMk/>
          <pc:sldMk cId="2831911539" sldId="261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831911539" sldId="261"/>
            <ac:spMk id="2" creationId="{32DE273B-FDFC-4BA5-B094-32B7B338676E}"/>
          </ac:spMkLst>
        </pc:spChg>
        <pc:spChg chg="mod">
          <ac:chgData name="Xiang,Jenny Jing" userId="c0b1da7b-7211-47b3-b357-9d3cb7ffc9fa" providerId="ADAL" clId="{55D78D8C-B54E-46C2-B55D-78ED6F6588E0}" dt="2022-12-16T20:57:26.341" v="4" actId="27636"/>
          <ac:spMkLst>
            <pc:docMk/>
            <pc:sldMk cId="2831911539" sldId="261"/>
            <ac:spMk id="3" creationId="{8B7381EA-D022-470B-B3C6-C6ACB87A0E22}"/>
          </ac:spMkLst>
        </pc:spChg>
      </pc:sldChg>
      <pc:sldChg chg="modSp modNotes">
        <pc:chgData name="Xiang,Jenny Jing" userId="c0b1da7b-7211-47b3-b357-9d3cb7ffc9fa" providerId="ADAL" clId="{55D78D8C-B54E-46C2-B55D-78ED6F6588E0}" dt="2022-12-16T20:57:26.213" v="1"/>
        <pc:sldMkLst>
          <pc:docMk/>
          <pc:sldMk cId="153106354" sldId="262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153106354" sldId="262"/>
            <ac:spMk id="2" creationId="{DFBCE94E-4C92-47B4-9966-65BFEC4AD962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153106354" sldId="262"/>
            <ac:spMk id="3" creationId="{9B31F109-1BAF-4EFB-879D-8E00C1F52948}"/>
          </ac:spMkLst>
        </pc:spChg>
      </pc:sldChg>
      <pc:sldChg chg="modSp">
        <pc:chgData name="Xiang,Jenny Jing" userId="c0b1da7b-7211-47b3-b357-9d3cb7ffc9fa" providerId="ADAL" clId="{55D78D8C-B54E-46C2-B55D-78ED6F6588E0}" dt="2022-12-16T20:57:26.213" v="1"/>
        <pc:sldMkLst>
          <pc:docMk/>
          <pc:sldMk cId="2353079142" sldId="263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353079142" sldId="263"/>
            <ac:spMk id="2" creationId="{8AEBA709-337B-4344-A4AA-C9D34C97DF3E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353079142" sldId="263"/>
            <ac:spMk id="3" creationId="{326BE5B8-83E9-4AD0-80CD-1575CFCB4418}"/>
          </ac:spMkLst>
        </pc:spChg>
      </pc:sldChg>
      <pc:sldChg chg="modSp mod">
        <pc:chgData name="Xiang,Jenny Jing" userId="c0b1da7b-7211-47b3-b357-9d3cb7ffc9fa" providerId="ADAL" clId="{55D78D8C-B54E-46C2-B55D-78ED6F6588E0}" dt="2022-12-16T20:59:36.385" v="39" actId="20577"/>
        <pc:sldMkLst>
          <pc:docMk/>
          <pc:sldMk cId="2880831955" sldId="264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880831955" sldId="264"/>
            <ac:spMk id="2" creationId="{857531B8-E1AC-4298-A96E-6C2F9A30DE00}"/>
          </ac:spMkLst>
        </pc:spChg>
        <pc:spChg chg="mod">
          <ac:chgData name="Xiang,Jenny Jing" userId="c0b1da7b-7211-47b3-b357-9d3cb7ffc9fa" providerId="ADAL" clId="{55D78D8C-B54E-46C2-B55D-78ED6F6588E0}" dt="2022-12-16T20:59:15.128" v="32" actId="1076"/>
          <ac:spMkLst>
            <pc:docMk/>
            <pc:sldMk cId="2880831955" sldId="264"/>
            <ac:spMk id="6" creationId="{B6DB7B22-95ED-4721-9F72-E9A90D04D1D0}"/>
          </ac:spMkLst>
        </pc:spChg>
        <pc:graphicFrameChg chg="mod modGraphic">
          <ac:chgData name="Xiang,Jenny Jing" userId="c0b1da7b-7211-47b3-b357-9d3cb7ffc9fa" providerId="ADAL" clId="{55D78D8C-B54E-46C2-B55D-78ED6F6588E0}" dt="2022-12-16T20:59:36.385" v="39" actId="20577"/>
          <ac:graphicFrameMkLst>
            <pc:docMk/>
            <pc:sldMk cId="2880831955" sldId="264"/>
            <ac:graphicFrameMk id="5" creationId="{4D9B1045-1508-4CB4-953B-46E6DC494CB9}"/>
          </ac:graphicFrameMkLst>
        </pc:graphicFrameChg>
      </pc:sldChg>
      <pc:sldChg chg="modSp mod modNotes">
        <pc:chgData name="Xiang,Jenny Jing" userId="c0b1da7b-7211-47b3-b357-9d3cb7ffc9fa" providerId="ADAL" clId="{55D78D8C-B54E-46C2-B55D-78ED6F6588E0}" dt="2022-12-16T20:58:00.988" v="13" actId="120"/>
        <pc:sldMkLst>
          <pc:docMk/>
          <pc:sldMk cId="2879419097" sldId="587"/>
        </pc:sldMkLst>
        <pc:spChg chg="mod">
          <ac:chgData name="Xiang,Jenny Jing" userId="c0b1da7b-7211-47b3-b357-9d3cb7ffc9fa" providerId="ADAL" clId="{55D78D8C-B54E-46C2-B55D-78ED6F6588E0}" dt="2022-12-16T20:58:00.988" v="13" actId="120"/>
          <ac:spMkLst>
            <pc:docMk/>
            <pc:sldMk cId="2879419097" sldId="587"/>
            <ac:spMk id="2" creationId="{00000000-0000-0000-0000-000000000000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879419097" sldId="587"/>
            <ac:spMk id="3" creationId="{00000000-0000-0000-0000-000000000000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879419097" sldId="587"/>
            <ac:spMk id="10" creationId="{00000000-0000-0000-0000-000000000000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879419097" sldId="587"/>
            <ac:spMk id="11" creationId="{00000000-0000-0000-0000-000000000000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879419097" sldId="587"/>
            <ac:spMk id="12" creationId="{00000000-0000-0000-0000-000000000000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879419097" sldId="587"/>
            <ac:spMk id="13" creationId="{00000000-0000-0000-0000-000000000000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879419097" sldId="587"/>
            <ac:spMk id="14" creationId="{00000000-0000-0000-0000-000000000000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879419097" sldId="587"/>
            <ac:spMk id="24" creationId="{00000000-0000-0000-0000-000000000000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879419097" sldId="587"/>
            <ac:spMk id="26" creationId="{00000000-0000-0000-0000-000000000000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879419097" sldId="587"/>
            <ac:spMk id="29" creationId="{00000000-0000-0000-0000-000000000000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879419097" sldId="587"/>
            <ac:spMk id="30" creationId="{00000000-0000-0000-0000-000000000000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879419097" sldId="587"/>
            <ac:spMk id="34" creationId="{00000000-0000-0000-0000-000000000000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879419097" sldId="587"/>
            <ac:spMk id="35" creationId="{00000000-0000-0000-0000-000000000000}"/>
          </ac:spMkLst>
        </pc:spChg>
        <pc:cxnChg chg="mod">
          <ac:chgData name="Xiang,Jenny Jing" userId="c0b1da7b-7211-47b3-b357-9d3cb7ffc9fa" providerId="ADAL" clId="{55D78D8C-B54E-46C2-B55D-78ED6F6588E0}" dt="2022-12-16T20:57:26.213" v="1"/>
          <ac:cxnSpMkLst>
            <pc:docMk/>
            <pc:sldMk cId="2879419097" sldId="587"/>
            <ac:cxnSpMk id="4" creationId="{00000000-0000-0000-0000-000000000000}"/>
          </ac:cxnSpMkLst>
        </pc:cxnChg>
        <pc:cxnChg chg="mod">
          <ac:chgData name="Xiang,Jenny Jing" userId="c0b1da7b-7211-47b3-b357-9d3cb7ffc9fa" providerId="ADAL" clId="{55D78D8C-B54E-46C2-B55D-78ED6F6588E0}" dt="2022-12-16T20:57:26.213" v="1"/>
          <ac:cxnSpMkLst>
            <pc:docMk/>
            <pc:sldMk cId="2879419097" sldId="587"/>
            <ac:cxnSpMk id="6" creationId="{00000000-0000-0000-0000-000000000000}"/>
          </ac:cxnSpMkLst>
        </pc:cxnChg>
        <pc:cxnChg chg="mod">
          <ac:chgData name="Xiang,Jenny Jing" userId="c0b1da7b-7211-47b3-b357-9d3cb7ffc9fa" providerId="ADAL" clId="{55D78D8C-B54E-46C2-B55D-78ED6F6588E0}" dt="2022-12-16T20:57:26.213" v="1"/>
          <ac:cxnSpMkLst>
            <pc:docMk/>
            <pc:sldMk cId="2879419097" sldId="587"/>
            <ac:cxnSpMk id="7" creationId="{00000000-0000-0000-0000-000000000000}"/>
          </ac:cxnSpMkLst>
        </pc:cxnChg>
        <pc:cxnChg chg="mod">
          <ac:chgData name="Xiang,Jenny Jing" userId="c0b1da7b-7211-47b3-b357-9d3cb7ffc9fa" providerId="ADAL" clId="{55D78D8C-B54E-46C2-B55D-78ED6F6588E0}" dt="2022-12-16T20:57:26.213" v="1"/>
          <ac:cxnSpMkLst>
            <pc:docMk/>
            <pc:sldMk cId="2879419097" sldId="587"/>
            <ac:cxnSpMk id="8" creationId="{00000000-0000-0000-0000-000000000000}"/>
          </ac:cxnSpMkLst>
        </pc:cxnChg>
        <pc:cxnChg chg="mod">
          <ac:chgData name="Xiang,Jenny Jing" userId="c0b1da7b-7211-47b3-b357-9d3cb7ffc9fa" providerId="ADAL" clId="{55D78D8C-B54E-46C2-B55D-78ED6F6588E0}" dt="2022-12-16T20:57:26.213" v="1"/>
          <ac:cxnSpMkLst>
            <pc:docMk/>
            <pc:sldMk cId="2879419097" sldId="587"/>
            <ac:cxnSpMk id="9" creationId="{00000000-0000-0000-0000-000000000000}"/>
          </ac:cxnSpMkLst>
        </pc:cxnChg>
        <pc:cxnChg chg="mod">
          <ac:chgData name="Xiang,Jenny Jing" userId="c0b1da7b-7211-47b3-b357-9d3cb7ffc9fa" providerId="ADAL" clId="{55D78D8C-B54E-46C2-B55D-78ED6F6588E0}" dt="2022-12-16T20:57:26.213" v="1"/>
          <ac:cxnSpMkLst>
            <pc:docMk/>
            <pc:sldMk cId="2879419097" sldId="587"/>
            <ac:cxnSpMk id="19" creationId="{00000000-0000-0000-0000-000000000000}"/>
          </ac:cxnSpMkLst>
        </pc:cxnChg>
        <pc:cxnChg chg="mod">
          <ac:chgData name="Xiang,Jenny Jing" userId="c0b1da7b-7211-47b3-b357-9d3cb7ffc9fa" providerId="ADAL" clId="{55D78D8C-B54E-46C2-B55D-78ED6F6588E0}" dt="2022-12-16T20:57:26.213" v="1"/>
          <ac:cxnSpMkLst>
            <pc:docMk/>
            <pc:sldMk cId="2879419097" sldId="587"/>
            <ac:cxnSpMk id="22" creationId="{00000000-0000-0000-0000-000000000000}"/>
          </ac:cxnSpMkLst>
        </pc:cxnChg>
        <pc:cxnChg chg="mod">
          <ac:chgData name="Xiang,Jenny Jing" userId="c0b1da7b-7211-47b3-b357-9d3cb7ffc9fa" providerId="ADAL" clId="{55D78D8C-B54E-46C2-B55D-78ED6F6588E0}" dt="2022-12-16T20:57:26.213" v="1"/>
          <ac:cxnSpMkLst>
            <pc:docMk/>
            <pc:sldMk cId="2879419097" sldId="587"/>
            <ac:cxnSpMk id="23" creationId="{00000000-0000-0000-0000-000000000000}"/>
          </ac:cxnSpMkLst>
        </pc:cxnChg>
        <pc:cxnChg chg="mod">
          <ac:chgData name="Xiang,Jenny Jing" userId="c0b1da7b-7211-47b3-b357-9d3cb7ffc9fa" providerId="ADAL" clId="{55D78D8C-B54E-46C2-B55D-78ED6F6588E0}" dt="2022-12-16T20:57:26.213" v="1"/>
          <ac:cxnSpMkLst>
            <pc:docMk/>
            <pc:sldMk cId="2879419097" sldId="587"/>
            <ac:cxnSpMk id="33" creationId="{00000000-0000-0000-0000-000000000000}"/>
          </ac:cxnSpMkLst>
        </pc:cxnChg>
        <pc:cxnChg chg="mod">
          <ac:chgData name="Xiang,Jenny Jing" userId="c0b1da7b-7211-47b3-b357-9d3cb7ffc9fa" providerId="ADAL" clId="{55D78D8C-B54E-46C2-B55D-78ED6F6588E0}" dt="2022-12-16T20:57:26.213" v="1"/>
          <ac:cxnSpMkLst>
            <pc:docMk/>
            <pc:sldMk cId="2879419097" sldId="587"/>
            <ac:cxnSpMk id="43" creationId="{00000000-0000-0000-0000-000000000000}"/>
          </ac:cxnSpMkLst>
        </pc:cxnChg>
        <pc:cxnChg chg="mod">
          <ac:chgData name="Xiang,Jenny Jing" userId="c0b1da7b-7211-47b3-b357-9d3cb7ffc9fa" providerId="ADAL" clId="{55D78D8C-B54E-46C2-B55D-78ED6F6588E0}" dt="2022-12-16T20:57:26.213" v="1"/>
          <ac:cxnSpMkLst>
            <pc:docMk/>
            <pc:sldMk cId="2879419097" sldId="587"/>
            <ac:cxnSpMk id="78" creationId="{00000000-0000-0000-0000-000000000000}"/>
          </ac:cxnSpMkLst>
        </pc:cxnChg>
      </pc:sldChg>
      <pc:sldChg chg="modSp mod modNotes">
        <pc:chgData name="Xiang,Jenny Jing" userId="c0b1da7b-7211-47b3-b357-9d3cb7ffc9fa" providerId="ADAL" clId="{55D78D8C-B54E-46C2-B55D-78ED6F6588E0}" dt="2022-12-16T20:57:35.953" v="6" actId="14100"/>
        <pc:sldMkLst>
          <pc:docMk/>
          <pc:sldMk cId="4085207515" sldId="588"/>
        </pc:sldMkLst>
        <pc:spChg chg="mod">
          <ac:chgData name="Xiang,Jenny Jing" userId="c0b1da7b-7211-47b3-b357-9d3cb7ffc9fa" providerId="ADAL" clId="{55D78D8C-B54E-46C2-B55D-78ED6F6588E0}" dt="2022-12-16T20:57:35.953" v="6" actId="14100"/>
          <ac:spMkLst>
            <pc:docMk/>
            <pc:sldMk cId="4085207515" sldId="588"/>
            <ac:spMk id="2" creationId="{BD41A195-AE29-4CBF-95E5-9FC1CE33AE3D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4085207515" sldId="588"/>
            <ac:spMk id="3" creationId="{EE7FC2F0-E573-4E11-A227-A642A015096E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4085207515" sldId="588"/>
            <ac:spMk id="6" creationId="{EA2AC3E8-ABA5-4CFB-AD88-41D0F439CA4D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4085207515" sldId="588"/>
            <ac:spMk id="7" creationId="{EE59F035-AACF-4D6F-8891-98048144DC1D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4085207515" sldId="588"/>
            <ac:spMk id="8" creationId="{F82C1AC3-D7FC-4969-9071-2FB9B3DBE591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4085207515" sldId="588"/>
            <ac:spMk id="9" creationId="{AD5F2C0D-FF7C-49BF-B3A8-C7E6BCFD581F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4085207515" sldId="588"/>
            <ac:spMk id="10" creationId="{1AD0ADEC-B0E3-433B-9A9E-E0A372E48EE5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4085207515" sldId="588"/>
            <ac:spMk id="11" creationId="{B184B9C0-4D55-4A16-9BFA-4C869550CAFA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4085207515" sldId="588"/>
            <ac:spMk id="12" creationId="{B4D899EB-1A69-4417-B054-6C31077D8485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4085207515" sldId="588"/>
            <ac:spMk id="13" creationId="{DD9C22F6-9F04-4CC6-BEF5-010550D9B7DE}"/>
          </ac:spMkLst>
        </pc:spChg>
      </pc:sldChg>
      <pc:sldChg chg="modSp mod modNotes">
        <pc:chgData name="Xiang,Jenny Jing" userId="c0b1da7b-7211-47b3-b357-9d3cb7ffc9fa" providerId="ADAL" clId="{55D78D8C-B54E-46C2-B55D-78ED6F6588E0}" dt="2022-12-16T20:57:49.610" v="11" actId="1076"/>
        <pc:sldMkLst>
          <pc:docMk/>
          <pc:sldMk cId="1816235156" sldId="589"/>
        </pc:sldMkLst>
        <pc:spChg chg="mod">
          <ac:chgData name="Xiang,Jenny Jing" userId="c0b1da7b-7211-47b3-b357-9d3cb7ffc9fa" providerId="ADAL" clId="{55D78D8C-B54E-46C2-B55D-78ED6F6588E0}" dt="2022-12-16T20:57:45.678" v="10" actId="1076"/>
          <ac:spMkLst>
            <pc:docMk/>
            <pc:sldMk cId="1816235156" sldId="589"/>
            <ac:spMk id="3" creationId="{4BED164F-5C7F-4196-B3D0-AA9D8FF5F0F8}"/>
          </ac:spMkLst>
        </pc:spChg>
        <pc:spChg chg="mod">
          <ac:chgData name="Xiang,Jenny Jing" userId="c0b1da7b-7211-47b3-b357-9d3cb7ffc9fa" providerId="ADAL" clId="{55D78D8C-B54E-46C2-B55D-78ED6F6588E0}" dt="2022-12-16T20:57:39.283" v="7" actId="1076"/>
          <ac:spMkLst>
            <pc:docMk/>
            <pc:sldMk cId="1816235156" sldId="589"/>
            <ac:spMk id="4" creationId="{892D2F56-1EA5-4810-ACE3-34AEFF122D6B}"/>
          </ac:spMkLst>
        </pc:spChg>
        <pc:spChg chg="mod">
          <ac:chgData name="Xiang,Jenny Jing" userId="c0b1da7b-7211-47b3-b357-9d3cb7ffc9fa" providerId="ADAL" clId="{55D78D8C-B54E-46C2-B55D-78ED6F6588E0}" dt="2022-12-16T20:57:49.610" v="11" actId="1076"/>
          <ac:spMkLst>
            <pc:docMk/>
            <pc:sldMk cId="1816235156" sldId="589"/>
            <ac:spMk id="5" creationId="{D7E85303-2934-4F2D-9129-D9124F06A07B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1816235156" sldId="589"/>
            <ac:spMk id="6" creationId="{F983E1A3-4820-4EFB-A7A0-C7C90D1C191E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1816235156" sldId="589"/>
            <ac:spMk id="7" creationId="{8C22146B-E93A-40E8-AE3D-4F6FD46641F7}"/>
          </ac:spMkLst>
        </pc:spChg>
        <pc:spChg chg="mod">
          <ac:chgData name="Xiang,Jenny Jing" userId="c0b1da7b-7211-47b3-b357-9d3cb7ffc9fa" providerId="ADAL" clId="{55D78D8C-B54E-46C2-B55D-78ED6F6588E0}" dt="2022-12-16T20:57:45.678" v="10" actId="1076"/>
          <ac:spMkLst>
            <pc:docMk/>
            <pc:sldMk cId="1816235156" sldId="589"/>
            <ac:spMk id="8" creationId="{FCDAAA64-8A70-40E4-88F7-5B540A4E848E}"/>
          </ac:spMkLst>
        </pc:spChg>
        <pc:spChg chg="mod">
          <ac:chgData name="Xiang,Jenny Jing" userId="c0b1da7b-7211-47b3-b357-9d3cb7ffc9fa" providerId="ADAL" clId="{55D78D8C-B54E-46C2-B55D-78ED6F6588E0}" dt="2022-12-16T20:57:49.610" v="11" actId="1076"/>
          <ac:spMkLst>
            <pc:docMk/>
            <pc:sldMk cId="1816235156" sldId="589"/>
            <ac:spMk id="9" creationId="{FEB8B133-C8A8-4652-8B2D-B781B082E764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1816235156" sldId="589"/>
            <ac:spMk id="10" creationId="{81571A5C-3BD2-4145-AD6D-CFE40CC23084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1816235156" sldId="589"/>
            <ac:spMk id="11" creationId="{BF8B3654-C97F-40A1-BB1C-369EE24611FD}"/>
          </ac:spMkLst>
        </pc:spChg>
      </pc:sldChg>
      <pc:sldChg chg="modSp">
        <pc:chgData name="Xiang,Jenny Jing" userId="c0b1da7b-7211-47b3-b357-9d3cb7ffc9fa" providerId="ADAL" clId="{55D78D8C-B54E-46C2-B55D-78ED6F6588E0}" dt="2022-12-16T20:57:26.213" v="1"/>
        <pc:sldMkLst>
          <pc:docMk/>
          <pc:sldMk cId="733008049" sldId="590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733008049" sldId="590"/>
            <ac:spMk id="2" creationId="{D5FB0763-CADD-4B6F-BF93-531BAD60B424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733008049" sldId="590"/>
            <ac:spMk id="3" creationId="{285688F2-5EA8-4F54-A45C-4335C2CE5C99}"/>
          </ac:spMkLst>
        </pc:spChg>
      </pc:sldChg>
      <pc:sldChg chg="modSp">
        <pc:chgData name="Xiang,Jenny Jing" userId="c0b1da7b-7211-47b3-b357-9d3cb7ffc9fa" providerId="ADAL" clId="{55D78D8C-B54E-46C2-B55D-78ED6F6588E0}" dt="2022-12-16T20:57:26.213" v="1"/>
        <pc:sldMkLst>
          <pc:docMk/>
          <pc:sldMk cId="2403052001" sldId="591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403052001" sldId="591"/>
            <ac:spMk id="2" creationId="{737983E1-3FE6-4C94-9BC0-10F1DC07DEDE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403052001" sldId="591"/>
            <ac:spMk id="3" creationId="{4CCFCF94-3BA6-41AE-B22D-D5D07D3A0F6D}"/>
          </ac:spMkLst>
        </pc:spChg>
      </pc:sldChg>
      <pc:sldChg chg="modSp">
        <pc:chgData name="Xiang,Jenny Jing" userId="c0b1da7b-7211-47b3-b357-9d3cb7ffc9fa" providerId="ADAL" clId="{55D78D8C-B54E-46C2-B55D-78ED6F6588E0}" dt="2022-12-16T20:57:26.213" v="1"/>
        <pc:sldMkLst>
          <pc:docMk/>
          <pc:sldMk cId="2453089826" sldId="592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453089826" sldId="592"/>
            <ac:spMk id="2" creationId="{F0EF7991-A039-4D47-B6E7-D336858B6514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453089826" sldId="592"/>
            <ac:spMk id="3" creationId="{4DC907D5-8802-42FA-8CF5-5DB1A00A8FDA}"/>
          </ac:spMkLst>
        </pc:spChg>
      </pc:sldChg>
      <pc:sldChg chg="modSp modNotes">
        <pc:chgData name="Xiang,Jenny Jing" userId="c0b1da7b-7211-47b3-b357-9d3cb7ffc9fa" providerId="ADAL" clId="{55D78D8C-B54E-46C2-B55D-78ED6F6588E0}" dt="2022-12-16T20:57:26.213" v="1"/>
        <pc:sldMkLst>
          <pc:docMk/>
          <pc:sldMk cId="735069791" sldId="593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735069791" sldId="593"/>
            <ac:spMk id="2" creationId="{95DECAA5-3EE8-4F0A-8F50-01720E860A2A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735069791" sldId="593"/>
            <ac:spMk id="3" creationId="{705A87C4-191C-496E-A17E-F8AAEC97EAC8}"/>
          </ac:spMkLst>
        </pc:spChg>
      </pc:sldChg>
      <pc:sldChg chg="modSp">
        <pc:chgData name="Xiang,Jenny Jing" userId="c0b1da7b-7211-47b3-b357-9d3cb7ffc9fa" providerId="ADAL" clId="{55D78D8C-B54E-46C2-B55D-78ED6F6588E0}" dt="2022-12-16T20:57:26.213" v="1"/>
        <pc:sldMkLst>
          <pc:docMk/>
          <pc:sldMk cId="1805949012" sldId="594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1805949012" sldId="594"/>
            <ac:spMk id="2" creationId="{ECBCFE67-9421-48DE-A489-F9101ABE6234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1805949012" sldId="594"/>
            <ac:spMk id="3" creationId="{01826B1C-68F3-4E6D-A865-BC32F1066801}"/>
          </ac:spMkLst>
        </pc:spChg>
      </pc:sldChg>
      <pc:sldChg chg="modSp mod">
        <pc:chgData name="Xiang,Jenny Jing" userId="c0b1da7b-7211-47b3-b357-9d3cb7ffc9fa" providerId="ADAL" clId="{55D78D8C-B54E-46C2-B55D-78ED6F6588E0}" dt="2022-12-16T20:57:26.341" v="3" actId="27636"/>
        <pc:sldMkLst>
          <pc:docMk/>
          <pc:sldMk cId="2334726003" sldId="595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334726003" sldId="595"/>
            <ac:spMk id="2" creationId="{0C64C770-6551-4C6E-8216-C58DB160C914}"/>
          </ac:spMkLst>
        </pc:spChg>
        <pc:spChg chg="mod">
          <ac:chgData name="Xiang,Jenny Jing" userId="c0b1da7b-7211-47b3-b357-9d3cb7ffc9fa" providerId="ADAL" clId="{55D78D8C-B54E-46C2-B55D-78ED6F6588E0}" dt="2022-12-16T20:57:26.341" v="3" actId="27636"/>
          <ac:spMkLst>
            <pc:docMk/>
            <pc:sldMk cId="2334726003" sldId="595"/>
            <ac:spMk id="3" creationId="{5A1B9184-5B0B-4A38-A490-E04F7C26ED3C}"/>
          </ac:spMkLst>
        </pc:spChg>
      </pc:sldChg>
      <pc:sldChg chg="modSp mod modNotes">
        <pc:chgData name="Xiang,Jenny Jing" userId="c0b1da7b-7211-47b3-b357-9d3cb7ffc9fa" providerId="ADAL" clId="{55D78D8C-B54E-46C2-B55D-78ED6F6588E0}" dt="2022-12-16T20:58:38.890" v="21" actId="14100"/>
        <pc:sldMkLst>
          <pc:docMk/>
          <pc:sldMk cId="2377506136" sldId="596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377506136" sldId="596"/>
            <ac:spMk id="2" creationId="{F0118DDA-0AA3-443C-A3C0-D25C9C178890}"/>
          </ac:spMkLst>
        </pc:spChg>
        <pc:spChg chg="mod">
          <ac:chgData name="Xiang,Jenny Jing" userId="c0b1da7b-7211-47b3-b357-9d3cb7ffc9fa" providerId="ADAL" clId="{55D78D8C-B54E-46C2-B55D-78ED6F6588E0}" dt="2022-12-16T20:58:38.890" v="21" actId="14100"/>
          <ac:spMkLst>
            <pc:docMk/>
            <pc:sldMk cId="2377506136" sldId="596"/>
            <ac:spMk id="3" creationId="{5B97EEDA-0E99-4C53-937C-D97BD8D801DE}"/>
          </ac:spMkLst>
        </pc:spChg>
      </pc:sldChg>
      <pc:sldChg chg="modSp mod modNotes">
        <pc:chgData name="Xiang,Jenny Jing" userId="c0b1da7b-7211-47b3-b357-9d3cb7ffc9fa" providerId="ADAL" clId="{55D78D8C-B54E-46C2-B55D-78ED6F6588E0}" dt="2022-12-16T20:58:53.792" v="29" actId="27636"/>
        <pc:sldMkLst>
          <pc:docMk/>
          <pc:sldMk cId="4260075427" sldId="597"/>
        </pc:sldMkLst>
        <pc:spChg chg="mod">
          <ac:chgData name="Xiang,Jenny Jing" userId="c0b1da7b-7211-47b3-b357-9d3cb7ffc9fa" providerId="ADAL" clId="{55D78D8C-B54E-46C2-B55D-78ED6F6588E0}" dt="2022-12-16T20:58:53.792" v="29" actId="27636"/>
          <ac:spMkLst>
            <pc:docMk/>
            <pc:sldMk cId="4260075427" sldId="597"/>
            <ac:spMk id="2" creationId="{CFECC9D7-A050-4061-9951-CBBB9014FFF6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4260075427" sldId="597"/>
            <ac:spMk id="5" creationId="{5EB70A46-2BB6-477C-ACD6-632167C5BE6C}"/>
          </ac:spMkLst>
        </pc:spChg>
        <pc:graphicFrameChg chg="mod modGraphic">
          <ac:chgData name="Xiang,Jenny Jing" userId="c0b1da7b-7211-47b3-b357-9d3cb7ffc9fa" providerId="ADAL" clId="{55D78D8C-B54E-46C2-B55D-78ED6F6588E0}" dt="2022-12-16T20:58:49.550" v="24" actId="14100"/>
          <ac:graphicFrameMkLst>
            <pc:docMk/>
            <pc:sldMk cId="4260075427" sldId="597"/>
            <ac:graphicFrameMk id="4" creationId="{CB15BA40-E47B-4570-BD50-4F3A9799884C}"/>
          </ac:graphicFrameMkLst>
        </pc:graphicFrameChg>
      </pc:sldChg>
      <pc:sldChg chg="delSp modSp mod delDesignElem">
        <pc:chgData name="Xiang,Jenny Jing" userId="c0b1da7b-7211-47b3-b357-9d3cb7ffc9fa" providerId="ADAL" clId="{55D78D8C-B54E-46C2-B55D-78ED6F6588E0}" dt="2022-12-16T20:58:27.945" v="19" actId="1076"/>
        <pc:sldMkLst>
          <pc:docMk/>
          <pc:sldMk cId="3042998543" sldId="598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3042998543" sldId="598"/>
            <ac:spMk id="4" creationId="{2A191536-20A9-46DA-9B76-EDFE97E67859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3042998543" sldId="598"/>
            <ac:spMk id="48" creationId="{F19A4A0F-1B59-4DB0-9764-D10936E98770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3042998543" sldId="598"/>
            <ac:spMk id="49" creationId="{F399A70F-F8CD-4992-9EF5-6CF15472E73F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3042998543" sldId="598"/>
            <ac:spMk id="50" creationId="{48F4FEDC-6D80-458C-A665-075D9B9500FD}"/>
          </ac:spMkLst>
        </pc:spChg>
        <pc:spChg chg="del mod">
          <ac:chgData name="Xiang,Jenny Jing" userId="c0b1da7b-7211-47b3-b357-9d3cb7ffc9fa" providerId="ADAL" clId="{55D78D8C-B54E-46C2-B55D-78ED6F6588E0}" dt="2022-12-16T20:57:26.213" v="1"/>
          <ac:spMkLst>
            <pc:docMk/>
            <pc:sldMk cId="3042998543" sldId="598"/>
            <ac:spMk id="51" creationId="{F0AED851-54B9-4765-92D2-F0BE443BEC91}"/>
          </ac:spMkLst>
        </pc:spChg>
        <pc:spChg chg="del mod">
          <ac:chgData name="Xiang,Jenny Jing" userId="c0b1da7b-7211-47b3-b357-9d3cb7ffc9fa" providerId="ADAL" clId="{55D78D8C-B54E-46C2-B55D-78ED6F6588E0}" dt="2022-12-16T20:57:26.213" v="1"/>
          <ac:spMkLst>
            <pc:docMk/>
            <pc:sldMk cId="3042998543" sldId="598"/>
            <ac:spMk id="52" creationId="{B81933D1-5615-42C7-9C0B-4EB7105CCE2D}"/>
          </ac:spMkLst>
        </pc:spChg>
        <pc:spChg chg="del mod">
          <ac:chgData name="Xiang,Jenny Jing" userId="c0b1da7b-7211-47b3-b357-9d3cb7ffc9fa" providerId="ADAL" clId="{55D78D8C-B54E-46C2-B55D-78ED6F6588E0}" dt="2022-12-16T20:57:26.213" v="1"/>
          <ac:spMkLst>
            <pc:docMk/>
            <pc:sldMk cId="3042998543" sldId="598"/>
            <ac:spMk id="53" creationId="{19C9EAEA-39D0-4B0E-A0EB-51E7B26740B1}"/>
          </ac:spMkLst>
        </pc:spChg>
        <pc:grpChg chg="del mod">
          <ac:chgData name="Xiang,Jenny Jing" userId="c0b1da7b-7211-47b3-b357-9d3cb7ffc9fa" providerId="ADAL" clId="{55D78D8C-B54E-46C2-B55D-78ED6F6588E0}" dt="2022-12-16T20:57:26.213" v="1"/>
          <ac:grpSpMkLst>
            <pc:docMk/>
            <pc:sldMk cId="3042998543" sldId="598"/>
            <ac:grpSpMk id="54" creationId="{032D8612-31EB-44CF-A1D0-14FD4C705424}"/>
          </ac:grpSpMkLst>
        </pc:grpChg>
        <pc:picChg chg="mod">
          <ac:chgData name="Xiang,Jenny Jing" userId="c0b1da7b-7211-47b3-b357-9d3cb7ffc9fa" providerId="ADAL" clId="{55D78D8C-B54E-46C2-B55D-78ED6F6588E0}" dt="2022-12-16T20:58:27.945" v="19" actId="1076"/>
          <ac:picMkLst>
            <pc:docMk/>
            <pc:sldMk cId="3042998543" sldId="598"/>
            <ac:picMk id="8" creationId="{7D55107B-1146-411D-B3F0-8F13C8B6006F}"/>
          </ac:picMkLst>
        </pc:picChg>
      </pc:sldChg>
      <pc:sldChg chg="modSp">
        <pc:chgData name="Xiang,Jenny Jing" userId="c0b1da7b-7211-47b3-b357-9d3cb7ffc9fa" providerId="ADAL" clId="{55D78D8C-B54E-46C2-B55D-78ED6F6588E0}" dt="2022-12-16T20:57:26.213" v="1"/>
        <pc:sldMkLst>
          <pc:docMk/>
          <pc:sldMk cId="2470900624" sldId="599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470900624" sldId="599"/>
            <ac:spMk id="2" creationId="{FFF1BBE3-B09E-4E3C-8CC9-E21900808CEA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2470900624" sldId="599"/>
            <ac:spMk id="5" creationId="{BA327DF6-97F4-4254-A023-A9839F23BAFD}"/>
          </ac:spMkLst>
        </pc:spChg>
      </pc:sldChg>
      <pc:sldChg chg="modSp">
        <pc:chgData name="Xiang,Jenny Jing" userId="c0b1da7b-7211-47b3-b357-9d3cb7ffc9fa" providerId="ADAL" clId="{55D78D8C-B54E-46C2-B55D-78ED6F6588E0}" dt="2022-12-16T20:57:26.213" v="1"/>
        <pc:sldMkLst>
          <pc:docMk/>
          <pc:sldMk cId="1334186340" sldId="601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1334186340" sldId="601"/>
            <ac:spMk id="2" creationId="{0B974541-9964-44B2-A33A-F829AC78ED2A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1334186340" sldId="601"/>
            <ac:spMk id="3" creationId="{F705DE93-6709-4A43-84CF-BB3437951949}"/>
          </ac:spMkLst>
        </pc:spChg>
      </pc:sldChg>
      <pc:sldChg chg="modSp modNotes">
        <pc:chgData name="Xiang,Jenny Jing" userId="c0b1da7b-7211-47b3-b357-9d3cb7ffc9fa" providerId="ADAL" clId="{55D78D8C-B54E-46C2-B55D-78ED6F6588E0}" dt="2022-12-16T20:57:26.213" v="1"/>
        <pc:sldMkLst>
          <pc:docMk/>
          <pc:sldMk cId="1399029974" sldId="693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1399029974" sldId="693"/>
            <ac:spMk id="5" creationId="{81AC9894-436A-4DD7-B09A-80862FFB2557}"/>
          </ac:spMkLst>
        </pc:spChg>
        <pc:graphicFrameChg chg="mod">
          <ac:chgData name="Xiang,Jenny Jing" userId="c0b1da7b-7211-47b3-b357-9d3cb7ffc9fa" providerId="ADAL" clId="{55D78D8C-B54E-46C2-B55D-78ED6F6588E0}" dt="2022-12-16T20:57:26.213" v="1"/>
          <ac:graphicFrameMkLst>
            <pc:docMk/>
            <pc:sldMk cId="1399029974" sldId="693"/>
            <ac:graphicFrameMk id="4" creationId="{7728BC96-295D-4C6A-9BD1-6955248CD9AB}"/>
          </ac:graphicFrameMkLst>
        </pc:graphicFrameChg>
      </pc:sldChg>
      <pc:sldChg chg="modSp mod">
        <pc:chgData name="Xiang,Jenny Jing" userId="c0b1da7b-7211-47b3-b357-9d3cb7ffc9fa" providerId="ADAL" clId="{55D78D8C-B54E-46C2-B55D-78ED6F6588E0}" dt="2022-12-16T20:59:02.744" v="30" actId="1076"/>
        <pc:sldMkLst>
          <pc:docMk/>
          <pc:sldMk cId="725602526" sldId="694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725602526" sldId="694"/>
            <ac:spMk id="2" creationId="{69B8AC6E-2751-4224-818C-89F30D6689A0}"/>
          </ac:spMkLst>
        </pc:spChg>
        <pc:graphicFrameChg chg="mod">
          <ac:chgData name="Xiang,Jenny Jing" userId="c0b1da7b-7211-47b3-b357-9d3cb7ffc9fa" providerId="ADAL" clId="{55D78D8C-B54E-46C2-B55D-78ED6F6588E0}" dt="2022-12-16T20:59:02.744" v="30" actId="1076"/>
          <ac:graphicFrameMkLst>
            <pc:docMk/>
            <pc:sldMk cId="725602526" sldId="694"/>
            <ac:graphicFrameMk id="7" creationId="{DF79CF7D-0513-4D93-B76B-F19FB5C67E55}"/>
          </ac:graphicFrameMkLst>
        </pc:graphicFrameChg>
      </pc:sldChg>
      <pc:sldChg chg="modSp mod ord">
        <pc:chgData name="Xiang,Jenny Jing" userId="c0b1da7b-7211-47b3-b357-9d3cb7ffc9fa" providerId="ADAL" clId="{55D78D8C-B54E-46C2-B55D-78ED6F6588E0}" dt="2022-12-16T21:05:53.041" v="45" actId="20578"/>
        <pc:sldMkLst>
          <pc:docMk/>
          <pc:sldMk cId="1035078364" sldId="695"/>
        </pc:sld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k cId="1035078364" sldId="695"/>
            <ac:spMk id="4" creationId="{2A191536-20A9-46DA-9B76-EDFE97E67859}"/>
          </ac:spMkLst>
        </pc:spChg>
        <pc:picChg chg="mod">
          <ac:chgData name="Xiang,Jenny Jing" userId="c0b1da7b-7211-47b3-b357-9d3cb7ffc9fa" providerId="ADAL" clId="{55D78D8C-B54E-46C2-B55D-78ED6F6588E0}" dt="2022-12-16T20:59:08.181" v="31" actId="1076"/>
          <ac:picMkLst>
            <pc:docMk/>
            <pc:sldMk cId="1035078364" sldId="695"/>
            <ac:picMk id="8" creationId="{7D55107B-1146-411D-B3F0-8F13C8B6006F}"/>
          </ac:picMkLst>
        </pc:picChg>
      </pc:sldChg>
      <pc:sldMasterChg chg="modSp modSldLayout">
        <pc:chgData name="Xiang,Jenny Jing" userId="c0b1da7b-7211-47b3-b357-9d3cb7ffc9fa" providerId="ADAL" clId="{55D78D8C-B54E-46C2-B55D-78ED6F6588E0}" dt="2022-12-16T20:57:26.213" v="1"/>
        <pc:sldMasterMkLst>
          <pc:docMk/>
          <pc:sldMasterMk cId="715307605" sldId="2147483648"/>
        </pc:sldMasterMkLst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asterMk cId="715307605" sldId="2147483648"/>
            <ac:spMk id="2" creationId="{B777219D-F9A2-49A2-806E-1977A1522B9B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asterMk cId="715307605" sldId="2147483648"/>
            <ac:spMk id="3" creationId="{73AC961D-DC0B-4DC4-BC1A-56F651702CA9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asterMk cId="715307605" sldId="2147483648"/>
            <ac:spMk id="4" creationId="{064EC875-9A8C-4C33-99BF-806711DF043C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asterMk cId="715307605" sldId="2147483648"/>
            <ac:spMk id="5" creationId="{1BC3C7EC-7743-4D79-B431-8E1C33E2C9AC}"/>
          </ac:spMkLst>
        </pc:spChg>
        <pc:spChg chg="mod">
          <ac:chgData name="Xiang,Jenny Jing" userId="c0b1da7b-7211-47b3-b357-9d3cb7ffc9fa" providerId="ADAL" clId="{55D78D8C-B54E-46C2-B55D-78ED6F6588E0}" dt="2022-12-16T20:57:26.213" v="1"/>
          <ac:spMkLst>
            <pc:docMk/>
            <pc:sldMasterMk cId="715307605" sldId="2147483648"/>
            <ac:spMk id="6" creationId="{02036499-E53F-489C-94CC-DB74D6FA57D4}"/>
          </ac:spMkLst>
        </pc:spChg>
        <pc:sldLayoutChg chg="modSp">
          <pc:chgData name="Xiang,Jenny Jing" userId="c0b1da7b-7211-47b3-b357-9d3cb7ffc9fa" providerId="ADAL" clId="{55D78D8C-B54E-46C2-B55D-78ED6F6588E0}" dt="2022-12-16T20:57:26.213" v="1"/>
          <pc:sldLayoutMkLst>
            <pc:docMk/>
            <pc:sldMasterMk cId="715307605" sldId="2147483648"/>
            <pc:sldLayoutMk cId="392394927" sldId="2147483649"/>
          </pc:sldLayoutMkLst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392394927" sldId="2147483649"/>
              <ac:spMk id="2" creationId="{32320B12-447A-4DAD-A825-0336B5D6D96C}"/>
            </ac:spMkLst>
          </pc:spChg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392394927" sldId="2147483649"/>
              <ac:spMk id="3" creationId="{90AF5F89-14DC-4F8C-BB5B-81DBEC662230}"/>
            </ac:spMkLst>
          </pc:spChg>
        </pc:sldLayoutChg>
        <pc:sldLayoutChg chg="modSp">
          <pc:chgData name="Xiang,Jenny Jing" userId="c0b1da7b-7211-47b3-b357-9d3cb7ffc9fa" providerId="ADAL" clId="{55D78D8C-B54E-46C2-B55D-78ED6F6588E0}" dt="2022-12-16T20:57:26.213" v="1"/>
          <pc:sldLayoutMkLst>
            <pc:docMk/>
            <pc:sldMasterMk cId="715307605" sldId="2147483648"/>
            <pc:sldLayoutMk cId="3628740791" sldId="2147483651"/>
          </pc:sldLayoutMkLst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3628740791" sldId="2147483651"/>
              <ac:spMk id="2" creationId="{A13027D8-A198-4C3E-9A6D-C257A29FFD0F}"/>
            </ac:spMkLst>
          </pc:spChg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3628740791" sldId="2147483651"/>
              <ac:spMk id="3" creationId="{4CA40031-BFBA-441A-985B-6437DE4488AC}"/>
            </ac:spMkLst>
          </pc:spChg>
        </pc:sldLayoutChg>
        <pc:sldLayoutChg chg="modSp">
          <pc:chgData name="Xiang,Jenny Jing" userId="c0b1da7b-7211-47b3-b357-9d3cb7ffc9fa" providerId="ADAL" clId="{55D78D8C-B54E-46C2-B55D-78ED6F6588E0}" dt="2022-12-16T20:57:26.213" v="1"/>
          <pc:sldLayoutMkLst>
            <pc:docMk/>
            <pc:sldMasterMk cId="715307605" sldId="2147483648"/>
            <pc:sldLayoutMk cId="848419043" sldId="2147483652"/>
          </pc:sldLayoutMkLst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848419043" sldId="2147483652"/>
              <ac:spMk id="3" creationId="{72024B38-87F1-4778-A561-FB84400F28D1}"/>
            </ac:spMkLst>
          </pc:spChg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848419043" sldId="2147483652"/>
              <ac:spMk id="4" creationId="{7DE42ABD-F212-4FA3-8162-DBDFA0D1679D}"/>
            </ac:spMkLst>
          </pc:spChg>
        </pc:sldLayoutChg>
        <pc:sldLayoutChg chg="modSp">
          <pc:chgData name="Xiang,Jenny Jing" userId="c0b1da7b-7211-47b3-b357-9d3cb7ffc9fa" providerId="ADAL" clId="{55D78D8C-B54E-46C2-B55D-78ED6F6588E0}" dt="2022-12-16T20:57:26.213" v="1"/>
          <pc:sldLayoutMkLst>
            <pc:docMk/>
            <pc:sldMasterMk cId="715307605" sldId="2147483648"/>
            <pc:sldLayoutMk cId="474231664" sldId="2147483653"/>
          </pc:sldLayoutMkLst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474231664" sldId="2147483653"/>
              <ac:spMk id="2" creationId="{38C6F03E-25AA-4E1F-BEBF-8F9127CBFF88}"/>
            </ac:spMkLst>
          </pc:spChg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474231664" sldId="2147483653"/>
              <ac:spMk id="3" creationId="{1F237B43-FF07-4D0C-94F9-51B78C7F00DC}"/>
            </ac:spMkLst>
          </pc:spChg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474231664" sldId="2147483653"/>
              <ac:spMk id="4" creationId="{DEA20308-6A7A-48C6-BFCC-A87DAD5B76CB}"/>
            </ac:spMkLst>
          </pc:spChg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474231664" sldId="2147483653"/>
              <ac:spMk id="5" creationId="{1A547A36-AFEC-43BF-B5C7-264F5A1C93FE}"/>
            </ac:spMkLst>
          </pc:spChg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474231664" sldId="2147483653"/>
              <ac:spMk id="6" creationId="{18A40B78-47DB-4574-B98E-4DCBB46B3E8A}"/>
            </ac:spMkLst>
          </pc:spChg>
        </pc:sldLayoutChg>
        <pc:sldLayoutChg chg="modSp">
          <pc:chgData name="Xiang,Jenny Jing" userId="c0b1da7b-7211-47b3-b357-9d3cb7ffc9fa" providerId="ADAL" clId="{55D78D8C-B54E-46C2-B55D-78ED6F6588E0}" dt="2022-12-16T20:57:26.213" v="1"/>
          <pc:sldLayoutMkLst>
            <pc:docMk/>
            <pc:sldMasterMk cId="715307605" sldId="2147483648"/>
            <pc:sldLayoutMk cId="2007118176" sldId="2147483656"/>
          </pc:sldLayoutMkLst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2007118176" sldId="2147483656"/>
              <ac:spMk id="2" creationId="{5A1B0B97-BC8E-4362-B364-84DEED2DCA45}"/>
            </ac:spMkLst>
          </pc:spChg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2007118176" sldId="2147483656"/>
              <ac:spMk id="3" creationId="{44DD4E1A-C7FC-4011-A75C-8F2A60EB0FF6}"/>
            </ac:spMkLst>
          </pc:spChg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2007118176" sldId="2147483656"/>
              <ac:spMk id="4" creationId="{BA9FDD06-B7CF-45FD-BC9E-7B9A26D0271A}"/>
            </ac:spMkLst>
          </pc:spChg>
        </pc:sldLayoutChg>
        <pc:sldLayoutChg chg="modSp">
          <pc:chgData name="Xiang,Jenny Jing" userId="c0b1da7b-7211-47b3-b357-9d3cb7ffc9fa" providerId="ADAL" clId="{55D78D8C-B54E-46C2-B55D-78ED6F6588E0}" dt="2022-12-16T20:57:26.213" v="1"/>
          <pc:sldLayoutMkLst>
            <pc:docMk/>
            <pc:sldMasterMk cId="715307605" sldId="2147483648"/>
            <pc:sldLayoutMk cId="1971614637" sldId="2147483657"/>
          </pc:sldLayoutMkLst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1971614637" sldId="2147483657"/>
              <ac:spMk id="2" creationId="{F5F77224-6DFD-4645-8D45-D491788C825A}"/>
            </ac:spMkLst>
          </pc:spChg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1971614637" sldId="2147483657"/>
              <ac:spMk id="3" creationId="{44B9BB0A-901B-49FB-A134-86C4C9671596}"/>
            </ac:spMkLst>
          </pc:spChg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1971614637" sldId="2147483657"/>
              <ac:spMk id="4" creationId="{8D9D3C1C-27C9-4E3B-BCD4-EC6F77F275D8}"/>
            </ac:spMkLst>
          </pc:spChg>
        </pc:sldLayoutChg>
        <pc:sldLayoutChg chg="modSp">
          <pc:chgData name="Xiang,Jenny Jing" userId="c0b1da7b-7211-47b3-b357-9d3cb7ffc9fa" providerId="ADAL" clId="{55D78D8C-B54E-46C2-B55D-78ED6F6588E0}" dt="2022-12-16T20:57:26.213" v="1"/>
          <pc:sldLayoutMkLst>
            <pc:docMk/>
            <pc:sldMasterMk cId="715307605" sldId="2147483648"/>
            <pc:sldLayoutMk cId="3725124816" sldId="2147483659"/>
          </pc:sldLayoutMkLst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3725124816" sldId="2147483659"/>
              <ac:spMk id="2" creationId="{AC062B46-06EC-4532-A6F1-7B83CEA3E983}"/>
            </ac:spMkLst>
          </pc:spChg>
          <pc:spChg chg="mod">
            <ac:chgData name="Xiang,Jenny Jing" userId="c0b1da7b-7211-47b3-b357-9d3cb7ffc9fa" providerId="ADAL" clId="{55D78D8C-B54E-46C2-B55D-78ED6F6588E0}" dt="2022-12-16T20:57:26.213" v="1"/>
            <ac:spMkLst>
              <pc:docMk/>
              <pc:sldMasterMk cId="715307605" sldId="2147483648"/>
              <pc:sldLayoutMk cId="3725124816" sldId="2147483659"/>
              <ac:spMk id="3" creationId="{F2EE6998-B72F-41DD-9C70-7ADEF3AEE13A}"/>
            </ac:spMkLst>
          </pc:spChg>
        </pc:sldLayoutChg>
      </pc:sldMasterChg>
    </pc:docChg>
  </pc:docChgLst>
</pc:chgInfo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5FADC20E-C9DF-4CB4-AABB-9E3DE9224552}" type="doc">
      <dgm:prSet loTypeId="urn:microsoft.com/office/officeart/2005/8/layout/default" loCatId="list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US"/>
        </a:p>
      </dgm:t>
    </dgm:pt>
    <dgm:pt modelId="{7682C20C-8924-40CA-B775-FEAEDA428E2A}">
      <dgm:prSet phldrT="[Text]"/>
      <dgm:spPr/>
      <dgm:t>
        <a:bodyPr/>
        <a:lstStyle/>
        <a:p>
          <a:r>
            <a:rPr lang="en-US" dirty="0"/>
            <a:t>Eliminate Waste</a:t>
          </a:r>
        </a:p>
      </dgm:t>
    </dgm:pt>
    <dgm:pt modelId="{E5BD4D00-171C-4B90-A48F-A901DC3002FD}" type="parTrans" cxnId="{A8789E05-10D7-480D-A73C-DBF535A9EF29}">
      <dgm:prSet/>
      <dgm:spPr/>
      <dgm:t>
        <a:bodyPr/>
        <a:lstStyle/>
        <a:p>
          <a:endParaRPr lang="en-US"/>
        </a:p>
      </dgm:t>
    </dgm:pt>
    <dgm:pt modelId="{5C6FD6C9-422C-4FE3-A051-BDCD15929A4F}" type="sibTrans" cxnId="{A8789E05-10D7-480D-A73C-DBF535A9EF29}">
      <dgm:prSet/>
      <dgm:spPr/>
      <dgm:t>
        <a:bodyPr/>
        <a:lstStyle/>
        <a:p>
          <a:endParaRPr lang="en-US"/>
        </a:p>
      </dgm:t>
    </dgm:pt>
    <dgm:pt modelId="{6B8618BD-9985-47CF-9C47-84E84B3D1E16}">
      <dgm:prSet phldrT="[Text]"/>
      <dgm:spPr/>
      <dgm:t>
        <a:bodyPr/>
        <a:lstStyle/>
        <a:p>
          <a:r>
            <a:rPr lang="en-US" dirty="0"/>
            <a:t>Improve workflow</a:t>
          </a:r>
        </a:p>
      </dgm:t>
    </dgm:pt>
    <dgm:pt modelId="{13AE8895-23E5-4158-A389-FB3D704CBBC4}" type="parTrans" cxnId="{2F1EA7C1-6A9C-4F13-984B-094A9C7FAC0A}">
      <dgm:prSet/>
      <dgm:spPr/>
      <dgm:t>
        <a:bodyPr/>
        <a:lstStyle/>
        <a:p>
          <a:endParaRPr lang="en-US"/>
        </a:p>
      </dgm:t>
    </dgm:pt>
    <dgm:pt modelId="{3DABDFC9-CFAA-4353-8B91-B9F12DFAECC1}" type="sibTrans" cxnId="{2F1EA7C1-6A9C-4F13-984B-094A9C7FAC0A}">
      <dgm:prSet/>
      <dgm:spPr/>
      <dgm:t>
        <a:bodyPr/>
        <a:lstStyle/>
        <a:p>
          <a:endParaRPr lang="en-US"/>
        </a:p>
      </dgm:t>
    </dgm:pt>
    <dgm:pt modelId="{00F6C655-0D08-472A-B3C5-BB8B82D549A5}">
      <dgm:prSet phldrT="[Text]"/>
      <dgm:spPr/>
      <dgm:t>
        <a:bodyPr/>
        <a:lstStyle/>
        <a:p>
          <a:r>
            <a:rPr lang="en-US" dirty="0"/>
            <a:t>Optimize inventory</a:t>
          </a:r>
        </a:p>
      </dgm:t>
    </dgm:pt>
    <dgm:pt modelId="{DA8A460B-D481-47AC-9951-68F7A7724A32}" type="parTrans" cxnId="{743B1B76-1EFA-45E7-AFF4-110631AF1FED}">
      <dgm:prSet/>
      <dgm:spPr/>
      <dgm:t>
        <a:bodyPr/>
        <a:lstStyle/>
        <a:p>
          <a:endParaRPr lang="en-US"/>
        </a:p>
      </dgm:t>
    </dgm:pt>
    <dgm:pt modelId="{300995DB-4B55-4555-9DE2-52C1AD9B7135}" type="sibTrans" cxnId="{743B1B76-1EFA-45E7-AFF4-110631AF1FED}">
      <dgm:prSet/>
      <dgm:spPr/>
      <dgm:t>
        <a:bodyPr/>
        <a:lstStyle/>
        <a:p>
          <a:endParaRPr lang="en-US"/>
        </a:p>
      </dgm:t>
    </dgm:pt>
    <dgm:pt modelId="{B00EE8FB-9530-4DCA-ADFA-D22432CE2F7B}">
      <dgm:prSet phldrT="[Text]"/>
      <dgm:spPr/>
      <dgm:t>
        <a:bodyPr/>
        <a:lstStyle/>
        <a:p>
          <a:r>
            <a:rPr lang="en-US" dirty="0"/>
            <a:t>Enhance producer/customer relationship</a:t>
          </a:r>
        </a:p>
      </dgm:t>
    </dgm:pt>
    <dgm:pt modelId="{C2E4B01A-680A-43FC-96C5-681EB67E6CAD}" type="parTrans" cxnId="{196CC16C-73EC-44E1-A35B-4C4A431896FC}">
      <dgm:prSet/>
      <dgm:spPr/>
      <dgm:t>
        <a:bodyPr/>
        <a:lstStyle/>
        <a:p>
          <a:endParaRPr lang="en-US"/>
        </a:p>
      </dgm:t>
    </dgm:pt>
    <dgm:pt modelId="{A3FFEF87-D80A-4043-9874-8DCCBFE77B92}" type="sibTrans" cxnId="{196CC16C-73EC-44E1-A35B-4C4A431896FC}">
      <dgm:prSet/>
      <dgm:spPr/>
      <dgm:t>
        <a:bodyPr/>
        <a:lstStyle/>
        <a:p>
          <a:endParaRPr lang="en-US"/>
        </a:p>
      </dgm:t>
    </dgm:pt>
    <dgm:pt modelId="{06353922-588A-45B9-B7FF-730F0D1DE96D}">
      <dgm:prSet phldrT="[Text]"/>
      <dgm:spPr/>
      <dgm:t>
        <a:bodyPr/>
        <a:lstStyle/>
        <a:p>
          <a:r>
            <a:rPr lang="en-US" dirty="0"/>
            <a:t>Change the work environment</a:t>
          </a:r>
        </a:p>
      </dgm:t>
    </dgm:pt>
    <dgm:pt modelId="{15A536BF-AD56-4189-88A2-1F312B60B1A5}" type="parTrans" cxnId="{65033DC7-D6EE-4344-8CAE-AD91294580A2}">
      <dgm:prSet/>
      <dgm:spPr/>
      <dgm:t>
        <a:bodyPr/>
        <a:lstStyle/>
        <a:p>
          <a:endParaRPr lang="en-US"/>
        </a:p>
      </dgm:t>
    </dgm:pt>
    <dgm:pt modelId="{54762541-29AE-48F8-9539-25CF6C031A97}" type="sibTrans" cxnId="{65033DC7-D6EE-4344-8CAE-AD91294580A2}">
      <dgm:prSet/>
      <dgm:spPr/>
      <dgm:t>
        <a:bodyPr/>
        <a:lstStyle/>
        <a:p>
          <a:endParaRPr lang="en-US"/>
        </a:p>
      </dgm:t>
    </dgm:pt>
    <dgm:pt modelId="{BC743F00-A522-414F-8560-3904F0831C6C}">
      <dgm:prSet phldrT="[Text]"/>
      <dgm:spPr/>
      <dgm:t>
        <a:bodyPr/>
        <a:lstStyle/>
        <a:p>
          <a:r>
            <a:rPr lang="en-US" dirty="0"/>
            <a:t>Manage time</a:t>
          </a:r>
        </a:p>
      </dgm:t>
    </dgm:pt>
    <dgm:pt modelId="{3D73CB71-1590-4C7E-AAB3-A2A8AC1E15D3}" type="parTrans" cxnId="{9D3E9FB2-62F7-4C8E-AC3F-BCB44E8A82FF}">
      <dgm:prSet/>
      <dgm:spPr/>
      <dgm:t>
        <a:bodyPr/>
        <a:lstStyle/>
        <a:p>
          <a:endParaRPr lang="en-US"/>
        </a:p>
      </dgm:t>
    </dgm:pt>
    <dgm:pt modelId="{27871C02-9965-48EA-9488-E30A772B3772}" type="sibTrans" cxnId="{9D3E9FB2-62F7-4C8E-AC3F-BCB44E8A82FF}">
      <dgm:prSet/>
      <dgm:spPr/>
      <dgm:t>
        <a:bodyPr/>
        <a:lstStyle/>
        <a:p>
          <a:endParaRPr lang="en-US"/>
        </a:p>
      </dgm:t>
    </dgm:pt>
    <dgm:pt modelId="{396BBE83-52C2-4B9A-B040-85BF87E97796}">
      <dgm:prSet phldrT="[Text]"/>
      <dgm:spPr/>
      <dgm:t>
        <a:bodyPr/>
        <a:lstStyle/>
        <a:p>
          <a:r>
            <a:rPr lang="en-US" dirty="0"/>
            <a:t>Manage variation</a:t>
          </a:r>
        </a:p>
      </dgm:t>
    </dgm:pt>
    <dgm:pt modelId="{9AD4F53B-B66C-4887-8207-B0A7298E1281}" type="parTrans" cxnId="{7490A9ED-22E0-48D5-8125-48A36FF866A7}">
      <dgm:prSet/>
      <dgm:spPr/>
      <dgm:t>
        <a:bodyPr/>
        <a:lstStyle/>
        <a:p>
          <a:endParaRPr lang="en-US"/>
        </a:p>
      </dgm:t>
    </dgm:pt>
    <dgm:pt modelId="{FFC53DB5-A158-4AEA-9ADD-5A4AB1C7EECD}" type="sibTrans" cxnId="{7490A9ED-22E0-48D5-8125-48A36FF866A7}">
      <dgm:prSet/>
      <dgm:spPr/>
      <dgm:t>
        <a:bodyPr/>
        <a:lstStyle/>
        <a:p>
          <a:endParaRPr lang="en-US"/>
        </a:p>
      </dgm:t>
    </dgm:pt>
    <dgm:pt modelId="{B2C607CC-B49F-4B53-9745-8EAF6A479C11}">
      <dgm:prSet phldrT="[Text]"/>
      <dgm:spPr/>
      <dgm:t>
        <a:bodyPr/>
        <a:lstStyle/>
        <a:p>
          <a:r>
            <a:rPr lang="en-US" dirty="0"/>
            <a:t>Design systems to avoid mistakes </a:t>
          </a:r>
        </a:p>
      </dgm:t>
    </dgm:pt>
    <dgm:pt modelId="{2475DE57-C19D-495A-8757-1C37FF02FB79}" type="parTrans" cxnId="{E4712C03-CD8A-4910-A51F-5B7F249300FB}">
      <dgm:prSet/>
      <dgm:spPr/>
      <dgm:t>
        <a:bodyPr/>
        <a:lstStyle/>
        <a:p>
          <a:endParaRPr lang="en-US"/>
        </a:p>
      </dgm:t>
    </dgm:pt>
    <dgm:pt modelId="{3E549FED-A68F-41C2-B709-4E11994F743A}" type="sibTrans" cxnId="{E4712C03-CD8A-4910-A51F-5B7F249300FB}">
      <dgm:prSet/>
      <dgm:spPr/>
      <dgm:t>
        <a:bodyPr/>
        <a:lstStyle/>
        <a:p>
          <a:endParaRPr lang="en-US"/>
        </a:p>
      </dgm:t>
    </dgm:pt>
    <dgm:pt modelId="{6453D5FE-166F-4F1B-8733-CCD3FF67A84D}">
      <dgm:prSet phldrT="[Text]"/>
      <dgm:spPr/>
      <dgm:t>
        <a:bodyPr/>
        <a:lstStyle/>
        <a:p>
          <a:r>
            <a:rPr lang="en-US" dirty="0"/>
            <a:t>Focus on product design/services </a:t>
          </a:r>
        </a:p>
      </dgm:t>
    </dgm:pt>
    <dgm:pt modelId="{07CA0927-DAF5-4865-91B9-F04AD23D54DF}" type="parTrans" cxnId="{1F538843-03A4-4AD4-A22F-4645D143652C}">
      <dgm:prSet/>
      <dgm:spPr/>
      <dgm:t>
        <a:bodyPr/>
        <a:lstStyle/>
        <a:p>
          <a:endParaRPr lang="en-US"/>
        </a:p>
      </dgm:t>
    </dgm:pt>
    <dgm:pt modelId="{20BE1716-D068-47CB-BFD0-06B002A60016}" type="sibTrans" cxnId="{1F538843-03A4-4AD4-A22F-4645D143652C}">
      <dgm:prSet/>
      <dgm:spPr/>
      <dgm:t>
        <a:bodyPr/>
        <a:lstStyle/>
        <a:p>
          <a:endParaRPr lang="en-US"/>
        </a:p>
      </dgm:t>
    </dgm:pt>
    <dgm:pt modelId="{337DC814-2468-4978-B158-30B29C5EF5FF}" type="pres">
      <dgm:prSet presAssocID="{5FADC20E-C9DF-4CB4-AABB-9E3DE9224552}" presName="diagram" presStyleCnt="0">
        <dgm:presLayoutVars>
          <dgm:dir/>
          <dgm:resizeHandles val="exact"/>
        </dgm:presLayoutVars>
      </dgm:prSet>
      <dgm:spPr/>
    </dgm:pt>
    <dgm:pt modelId="{1DE0C7A9-0447-486A-A288-1419834CC8C2}" type="pres">
      <dgm:prSet presAssocID="{7682C20C-8924-40CA-B775-FEAEDA428E2A}" presName="node" presStyleLbl="node1" presStyleIdx="0" presStyleCnt="9">
        <dgm:presLayoutVars>
          <dgm:bulletEnabled val="1"/>
        </dgm:presLayoutVars>
      </dgm:prSet>
      <dgm:spPr/>
    </dgm:pt>
    <dgm:pt modelId="{325D26FA-2561-481E-B683-317AA6F31ED7}" type="pres">
      <dgm:prSet presAssocID="{5C6FD6C9-422C-4FE3-A051-BDCD15929A4F}" presName="sibTrans" presStyleCnt="0"/>
      <dgm:spPr/>
    </dgm:pt>
    <dgm:pt modelId="{278DAD2A-5B15-4CDC-9B63-D234D22341C3}" type="pres">
      <dgm:prSet presAssocID="{6B8618BD-9985-47CF-9C47-84E84B3D1E16}" presName="node" presStyleLbl="node1" presStyleIdx="1" presStyleCnt="9">
        <dgm:presLayoutVars>
          <dgm:bulletEnabled val="1"/>
        </dgm:presLayoutVars>
      </dgm:prSet>
      <dgm:spPr/>
    </dgm:pt>
    <dgm:pt modelId="{738AFB30-E06C-4163-8A3F-49A9AF9372E2}" type="pres">
      <dgm:prSet presAssocID="{3DABDFC9-CFAA-4353-8B91-B9F12DFAECC1}" presName="sibTrans" presStyleCnt="0"/>
      <dgm:spPr/>
    </dgm:pt>
    <dgm:pt modelId="{DF9F290A-1A73-4129-BFA1-04F5A0E8B08C}" type="pres">
      <dgm:prSet presAssocID="{00F6C655-0D08-472A-B3C5-BB8B82D549A5}" presName="node" presStyleLbl="node1" presStyleIdx="2" presStyleCnt="9">
        <dgm:presLayoutVars>
          <dgm:bulletEnabled val="1"/>
        </dgm:presLayoutVars>
      </dgm:prSet>
      <dgm:spPr/>
    </dgm:pt>
    <dgm:pt modelId="{DC359FD9-2474-4375-8EDC-DD33E257393C}" type="pres">
      <dgm:prSet presAssocID="{300995DB-4B55-4555-9DE2-52C1AD9B7135}" presName="sibTrans" presStyleCnt="0"/>
      <dgm:spPr/>
    </dgm:pt>
    <dgm:pt modelId="{1F8BA1AE-074D-4299-955B-957B10487CC6}" type="pres">
      <dgm:prSet presAssocID="{B00EE8FB-9530-4DCA-ADFA-D22432CE2F7B}" presName="node" presStyleLbl="node1" presStyleIdx="3" presStyleCnt="9">
        <dgm:presLayoutVars>
          <dgm:bulletEnabled val="1"/>
        </dgm:presLayoutVars>
      </dgm:prSet>
      <dgm:spPr/>
    </dgm:pt>
    <dgm:pt modelId="{6E9880F6-6ED7-45D5-815E-5A42B4085F45}" type="pres">
      <dgm:prSet presAssocID="{A3FFEF87-D80A-4043-9874-8DCCBFE77B92}" presName="sibTrans" presStyleCnt="0"/>
      <dgm:spPr/>
    </dgm:pt>
    <dgm:pt modelId="{03DFE8C5-1E48-4011-9705-54ACAAA760A6}" type="pres">
      <dgm:prSet presAssocID="{06353922-588A-45B9-B7FF-730F0D1DE96D}" presName="node" presStyleLbl="node1" presStyleIdx="4" presStyleCnt="9">
        <dgm:presLayoutVars>
          <dgm:bulletEnabled val="1"/>
        </dgm:presLayoutVars>
      </dgm:prSet>
      <dgm:spPr/>
    </dgm:pt>
    <dgm:pt modelId="{D3888DCC-F4C9-4E75-8A69-FE410434D73F}" type="pres">
      <dgm:prSet presAssocID="{54762541-29AE-48F8-9539-25CF6C031A97}" presName="sibTrans" presStyleCnt="0"/>
      <dgm:spPr/>
    </dgm:pt>
    <dgm:pt modelId="{B52470B3-DA97-4CCD-A5CD-50501862C37A}" type="pres">
      <dgm:prSet presAssocID="{BC743F00-A522-414F-8560-3904F0831C6C}" presName="node" presStyleLbl="node1" presStyleIdx="5" presStyleCnt="9">
        <dgm:presLayoutVars>
          <dgm:bulletEnabled val="1"/>
        </dgm:presLayoutVars>
      </dgm:prSet>
      <dgm:spPr/>
    </dgm:pt>
    <dgm:pt modelId="{2F656B78-035A-4019-9482-1C9647A622A2}" type="pres">
      <dgm:prSet presAssocID="{27871C02-9965-48EA-9488-E30A772B3772}" presName="sibTrans" presStyleCnt="0"/>
      <dgm:spPr/>
    </dgm:pt>
    <dgm:pt modelId="{F7805876-F745-4BE3-AF89-5C20A630E278}" type="pres">
      <dgm:prSet presAssocID="{396BBE83-52C2-4B9A-B040-85BF87E97796}" presName="node" presStyleLbl="node1" presStyleIdx="6" presStyleCnt="9">
        <dgm:presLayoutVars>
          <dgm:bulletEnabled val="1"/>
        </dgm:presLayoutVars>
      </dgm:prSet>
      <dgm:spPr/>
    </dgm:pt>
    <dgm:pt modelId="{7FCE477A-CB8D-4656-B97C-EA8F5FE819C0}" type="pres">
      <dgm:prSet presAssocID="{FFC53DB5-A158-4AEA-9ADD-5A4AB1C7EECD}" presName="sibTrans" presStyleCnt="0"/>
      <dgm:spPr/>
    </dgm:pt>
    <dgm:pt modelId="{92E2E38B-456D-4D16-BDD2-A713F61F5E1D}" type="pres">
      <dgm:prSet presAssocID="{B2C607CC-B49F-4B53-9745-8EAF6A479C11}" presName="node" presStyleLbl="node1" presStyleIdx="7" presStyleCnt="9">
        <dgm:presLayoutVars>
          <dgm:bulletEnabled val="1"/>
        </dgm:presLayoutVars>
      </dgm:prSet>
      <dgm:spPr/>
    </dgm:pt>
    <dgm:pt modelId="{7427845C-3171-43FC-BEAF-36C1B25C9C5D}" type="pres">
      <dgm:prSet presAssocID="{3E549FED-A68F-41C2-B709-4E11994F743A}" presName="sibTrans" presStyleCnt="0"/>
      <dgm:spPr/>
    </dgm:pt>
    <dgm:pt modelId="{D99B5DBA-C3D5-4D03-9885-F4C47F08B48D}" type="pres">
      <dgm:prSet presAssocID="{6453D5FE-166F-4F1B-8733-CCD3FF67A84D}" presName="node" presStyleLbl="node1" presStyleIdx="8" presStyleCnt="9">
        <dgm:presLayoutVars>
          <dgm:bulletEnabled val="1"/>
        </dgm:presLayoutVars>
      </dgm:prSet>
      <dgm:spPr/>
    </dgm:pt>
  </dgm:ptLst>
  <dgm:cxnLst>
    <dgm:cxn modelId="{E4712C03-CD8A-4910-A51F-5B7F249300FB}" srcId="{5FADC20E-C9DF-4CB4-AABB-9E3DE9224552}" destId="{B2C607CC-B49F-4B53-9745-8EAF6A479C11}" srcOrd="7" destOrd="0" parTransId="{2475DE57-C19D-495A-8757-1C37FF02FB79}" sibTransId="{3E549FED-A68F-41C2-B709-4E11994F743A}"/>
    <dgm:cxn modelId="{A8789E05-10D7-480D-A73C-DBF535A9EF29}" srcId="{5FADC20E-C9DF-4CB4-AABB-9E3DE9224552}" destId="{7682C20C-8924-40CA-B775-FEAEDA428E2A}" srcOrd="0" destOrd="0" parTransId="{E5BD4D00-171C-4B90-A48F-A901DC3002FD}" sibTransId="{5C6FD6C9-422C-4FE3-A051-BDCD15929A4F}"/>
    <dgm:cxn modelId="{1F538843-03A4-4AD4-A22F-4645D143652C}" srcId="{5FADC20E-C9DF-4CB4-AABB-9E3DE9224552}" destId="{6453D5FE-166F-4F1B-8733-CCD3FF67A84D}" srcOrd="8" destOrd="0" parTransId="{07CA0927-DAF5-4865-91B9-F04AD23D54DF}" sibTransId="{20BE1716-D068-47CB-BFD0-06B002A60016}"/>
    <dgm:cxn modelId="{AD171D4B-9177-4B91-B14A-4F3A165FB521}" type="presOf" srcId="{396BBE83-52C2-4B9A-B040-85BF87E97796}" destId="{F7805876-F745-4BE3-AF89-5C20A630E278}" srcOrd="0" destOrd="0" presId="urn:microsoft.com/office/officeart/2005/8/layout/default"/>
    <dgm:cxn modelId="{196CC16C-73EC-44E1-A35B-4C4A431896FC}" srcId="{5FADC20E-C9DF-4CB4-AABB-9E3DE9224552}" destId="{B00EE8FB-9530-4DCA-ADFA-D22432CE2F7B}" srcOrd="3" destOrd="0" parTransId="{C2E4B01A-680A-43FC-96C5-681EB67E6CAD}" sibTransId="{A3FFEF87-D80A-4043-9874-8DCCBFE77B92}"/>
    <dgm:cxn modelId="{743B1B76-1EFA-45E7-AFF4-110631AF1FED}" srcId="{5FADC20E-C9DF-4CB4-AABB-9E3DE9224552}" destId="{00F6C655-0D08-472A-B3C5-BB8B82D549A5}" srcOrd="2" destOrd="0" parTransId="{DA8A460B-D481-47AC-9951-68F7A7724A32}" sibTransId="{300995DB-4B55-4555-9DE2-52C1AD9B7135}"/>
    <dgm:cxn modelId="{654DCD82-93D1-427F-A04C-09C2E10E9D25}" type="presOf" srcId="{B2C607CC-B49F-4B53-9745-8EAF6A479C11}" destId="{92E2E38B-456D-4D16-BDD2-A713F61F5E1D}" srcOrd="0" destOrd="0" presId="urn:microsoft.com/office/officeart/2005/8/layout/default"/>
    <dgm:cxn modelId="{88EC179A-5A94-4D26-A5F9-318CBB24E126}" type="presOf" srcId="{6B8618BD-9985-47CF-9C47-84E84B3D1E16}" destId="{278DAD2A-5B15-4CDC-9B63-D234D22341C3}" srcOrd="0" destOrd="0" presId="urn:microsoft.com/office/officeart/2005/8/layout/default"/>
    <dgm:cxn modelId="{982B619C-B5F6-4DC7-A59D-036BB46EF09A}" type="presOf" srcId="{B00EE8FB-9530-4DCA-ADFA-D22432CE2F7B}" destId="{1F8BA1AE-074D-4299-955B-957B10487CC6}" srcOrd="0" destOrd="0" presId="urn:microsoft.com/office/officeart/2005/8/layout/default"/>
    <dgm:cxn modelId="{570F67A7-75FE-4514-9749-2D9FD5B2495F}" type="presOf" srcId="{00F6C655-0D08-472A-B3C5-BB8B82D549A5}" destId="{DF9F290A-1A73-4129-BFA1-04F5A0E8B08C}" srcOrd="0" destOrd="0" presId="urn:microsoft.com/office/officeart/2005/8/layout/default"/>
    <dgm:cxn modelId="{A48DF4AF-A1B5-4503-BCCC-4F3D62C5F950}" type="presOf" srcId="{5FADC20E-C9DF-4CB4-AABB-9E3DE9224552}" destId="{337DC814-2468-4978-B158-30B29C5EF5FF}" srcOrd="0" destOrd="0" presId="urn:microsoft.com/office/officeart/2005/8/layout/default"/>
    <dgm:cxn modelId="{04B438B1-CB2A-43A7-B826-9CC8A9B4F579}" type="presOf" srcId="{06353922-588A-45B9-B7FF-730F0D1DE96D}" destId="{03DFE8C5-1E48-4011-9705-54ACAAA760A6}" srcOrd="0" destOrd="0" presId="urn:microsoft.com/office/officeart/2005/8/layout/default"/>
    <dgm:cxn modelId="{9D3E9FB2-62F7-4C8E-AC3F-BCB44E8A82FF}" srcId="{5FADC20E-C9DF-4CB4-AABB-9E3DE9224552}" destId="{BC743F00-A522-414F-8560-3904F0831C6C}" srcOrd="5" destOrd="0" parTransId="{3D73CB71-1590-4C7E-AAB3-A2A8AC1E15D3}" sibTransId="{27871C02-9965-48EA-9488-E30A772B3772}"/>
    <dgm:cxn modelId="{2F1EA7C1-6A9C-4F13-984B-094A9C7FAC0A}" srcId="{5FADC20E-C9DF-4CB4-AABB-9E3DE9224552}" destId="{6B8618BD-9985-47CF-9C47-84E84B3D1E16}" srcOrd="1" destOrd="0" parTransId="{13AE8895-23E5-4158-A389-FB3D704CBBC4}" sibTransId="{3DABDFC9-CFAA-4353-8B91-B9F12DFAECC1}"/>
    <dgm:cxn modelId="{220FFAC5-2C47-48E7-81DE-8D194FC0483C}" type="presOf" srcId="{BC743F00-A522-414F-8560-3904F0831C6C}" destId="{B52470B3-DA97-4CCD-A5CD-50501862C37A}" srcOrd="0" destOrd="0" presId="urn:microsoft.com/office/officeart/2005/8/layout/default"/>
    <dgm:cxn modelId="{65033DC7-D6EE-4344-8CAE-AD91294580A2}" srcId="{5FADC20E-C9DF-4CB4-AABB-9E3DE9224552}" destId="{06353922-588A-45B9-B7FF-730F0D1DE96D}" srcOrd="4" destOrd="0" parTransId="{15A536BF-AD56-4189-88A2-1F312B60B1A5}" sibTransId="{54762541-29AE-48F8-9539-25CF6C031A97}"/>
    <dgm:cxn modelId="{C23176C7-F962-4C5C-B8AD-AA3FB8166B84}" type="presOf" srcId="{6453D5FE-166F-4F1B-8733-CCD3FF67A84D}" destId="{D99B5DBA-C3D5-4D03-9885-F4C47F08B48D}" srcOrd="0" destOrd="0" presId="urn:microsoft.com/office/officeart/2005/8/layout/default"/>
    <dgm:cxn modelId="{7490A9ED-22E0-48D5-8125-48A36FF866A7}" srcId="{5FADC20E-C9DF-4CB4-AABB-9E3DE9224552}" destId="{396BBE83-52C2-4B9A-B040-85BF87E97796}" srcOrd="6" destOrd="0" parTransId="{9AD4F53B-B66C-4887-8207-B0A7298E1281}" sibTransId="{FFC53DB5-A158-4AEA-9ADD-5A4AB1C7EECD}"/>
    <dgm:cxn modelId="{A08AE0FE-FDF8-4A8C-BC17-DFF55407B11F}" type="presOf" srcId="{7682C20C-8924-40CA-B775-FEAEDA428E2A}" destId="{1DE0C7A9-0447-486A-A288-1419834CC8C2}" srcOrd="0" destOrd="0" presId="urn:microsoft.com/office/officeart/2005/8/layout/default"/>
    <dgm:cxn modelId="{13DB1611-E1AB-44DF-9473-E215F49ED6CE}" type="presParOf" srcId="{337DC814-2468-4978-B158-30B29C5EF5FF}" destId="{1DE0C7A9-0447-486A-A288-1419834CC8C2}" srcOrd="0" destOrd="0" presId="urn:microsoft.com/office/officeart/2005/8/layout/default"/>
    <dgm:cxn modelId="{5E3BE519-44E4-415B-AF3A-3CB6D13E2DE9}" type="presParOf" srcId="{337DC814-2468-4978-B158-30B29C5EF5FF}" destId="{325D26FA-2561-481E-B683-317AA6F31ED7}" srcOrd="1" destOrd="0" presId="urn:microsoft.com/office/officeart/2005/8/layout/default"/>
    <dgm:cxn modelId="{C540253B-2E91-4DC8-991B-1C6A61A2B588}" type="presParOf" srcId="{337DC814-2468-4978-B158-30B29C5EF5FF}" destId="{278DAD2A-5B15-4CDC-9B63-D234D22341C3}" srcOrd="2" destOrd="0" presId="urn:microsoft.com/office/officeart/2005/8/layout/default"/>
    <dgm:cxn modelId="{912570F9-5049-4F1A-B41B-AB863B7B8132}" type="presParOf" srcId="{337DC814-2468-4978-B158-30B29C5EF5FF}" destId="{738AFB30-E06C-4163-8A3F-49A9AF9372E2}" srcOrd="3" destOrd="0" presId="urn:microsoft.com/office/officeart/2005/8/layout/default"/>
    <dgm:cxn modelId="{BB7539E4-B27C-4280-A780-D9B80C7DD9B5}" type="presParOf" srcId="{337DC814-2468-4978-B158-30B29C5EF5FF}" destId="{DF9F290A-1A73-4129-BFA1-04F5A0E8B08C}" srcOrd="4" destOrd="0" presId="urn:microsoft.com/office/officeart/2005/8/layout/default"/>
    <dgm:cxn modelId="{47E385EE-0CE9-4FFC-8473-EC71677BD15F}" type="presParOf" srcId="{337DC814-2468-4978-B158-30B29C5EF5FF}" destId="{DC359FD9-2474-4375-8EDC-DD33E257393C}" srcOrd="5" destOrd="0" presId="urn:microsoft.com/office/officeart/2005/8/layout/default"/>
    <dgm:cxn modelId="{5BA75FB2-335B-4A1A-AD37-9A6811EEFBD0}" type="presParOf" srcId="{337DC814-2468-4978-B158-30B29C5EF5FF}" destId="{1F8BA1AE-074D-4299-955B-957B10487CC6}" srcOrd="6" destOrd="0" presId="urn:microsoft.com/office/officeart/2005/8/layout/default"/>
    <dgm:cxn modelId="{798917A2-C93B-458A-BE23-8AA05A5CEF56}" type="presParOf" srcId="{337DC814-2468-4978-B158-30B29C5EF5FF}" destId="{6E9880F6-6ED7-45D5-815E-5A42B4085F45}" srcOrd="7" destOrd="0" presId="urn:microsoft.com/office/officeart/2005/8/layout/default"/>
    <dgm:cxn modelId="{E84C5A28-DF9C-46D4-9730-E0D5327DD06A}" type="presParOf" srcId="{337DC814-2468-4978-B158-30B29C5EF5FF}" destId="{03DFE8C5-1E48-4011-9705-54ACAAA760A6}" srcOrd="8" destOrd="0" presId="urn:microsoft.com/office/officeart/2005/8/layout/default"/>
    <dgm:cxn modelId="{3A08B899-B721-40EA-84D8-5077BC17F2E3}" type="presParOf" srcId="{337DC814-2468-4978-B158-30B29C5EF5FF}" destId="{D3888DCC-F4C9-4E75-8A69-FE410434D73F}" srcOrd="9" destOrd="0" presId="urn:microsoft.com/office/officeart/2005/8/layout/default"/>
    <dgm:cxn modelId="{FEFFE52D-1B82-45A3-84AC-AD645FDCC77E}" type="presParOf" srcId="{337DC814-2468-4978-B158-30B29C5EF5FF}" destId="{B52470B3-DA97-4CCD-A5CD-50501862C37A}" srcOrd="10" destOrd="0" presId="urn:microsoft.com/office/officeart/2005/8/layout/default"/>
    <dgm:cxn modelId="{402DCE70-06AB-4AD0-8AA7-D5D1A54F1DEB}" type="presParOf" srcId="{337DC814-2468-4978-B158-30B29C5EF5FF}" destId="{2F656B78-035A-4019-9482-1C9647A622A2}" srcOrd="11" destOrd="0" presId="urn:microsoft.com/office/officeart/2005/8/layout/default"/>
    <dgm:cxn modelId="{9D1AF80C-79AF-4A24-8A69-987DA394906C}" type="presParOf" srcId="{337DC814-2468-4978-B158-30B29C5EF5FF}" destId="{F7805876-F745-4BE3-AF89-5C20A630E278}" srcOrd="12" destOrd="0" presId="urn:microsoft.com/office/officeart/2005/8/layout/default"/>
    <dgm:cxn modelId="{B47B385A-17B3-4A4E-A47C-A31D484AB7BC}" type="presParOf" srcId="{337DC814-2468-4978-B158-30B29C5EF5FF}" destId="{7FCE477A-CB8D-4656-B97C-EA8F5FE819C0}" srcOrd="13" destOrd="0" presId="urn:microsoft.com/office/officeart/2005/8/layout/default"/>
    <dgm:cxn modelId="{42F11C30-6136-402F-AC76-2C13DA9A1065}" type="presParOf" srcId="{337DC814-2468-4978-B158-30B29C5EF5FF}" destId="{92E2E38B-456D-4D16-BDD2-A713F61F5E1D}" srcOrd="14" destOrd="0" presId="urn:microsoft.com/office/officeart/2005/8/layout/default"/>
    <dgm:cxn modelId="{CE117B79-250E-4F28-BB06-ACF576BE2463}" type="presParOf" srcId="{337DC814-2468-4978-B158-30B29C5EF5FF}" destId="{7427845C-3171-43FC-BEAF-36C1B25C9C5D}" srcOrd="15" destOrd="0" presId="urn:microsoft.com/office/officeart/2005/8/layout/default"/>
    <dgm:cxn modelId="{400F0FB3-DC48-42A8-A40D-E65FA0ECEB90}" type="presParOf" srcId="{337DC814-2468-4978-B158-30B29C5EF5FF}" destId="{D99B5DBA-C3D5-4D03-9885-F4C47F08B48D}" srcOrd="16" destOrd="0" presId="urn:microsoft.com/office/officeart/2005/8/layout/default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F3535B61-D9DD-4C98-B161-0E01D692D463}" type="doc">
      <dgm:prSet loTypeId="urn:microsoft.com/office/officeart/2005/8/layout/hList1" loCatId="list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481C1A3B-8343-45F1-AABE-99E97A73C9FA}">
      <dgm:prSet phldrT="[Text]"/>
      <dgm:spPr/>
      <dgm:t>
        <a:bodyPr/>
        <a:lstStyle/>
        <a:p>
          <a:r>
            <a:rPr lang="en-US" dirty="0"/>
            <a:t>Stronger Actions</a:t>
          </a:r>
        </a:p>
      </dgm:t>
    </dgm:pt>
    <dgm:pt modelId="{203E1457-7A2F-40BD-81FD-BBF6DDD53442}" type="parTrans" cxnId="{E4CF7678-4AB9-4863-803E-053E81B5B73A}">
      <dgm:prSet/>
      <dgm:spPr/>
      <dgm:t>
        <a:bodyPr/>
        <a:lstStyle/>
        <a:p>
          <a:endParaRPr lang="en-US"/>
        </a:p>
      </dgm:t>
    </dgm:pt>
    <dgm:pt modelId="{3B8CC567-78C7-4E93-AEAB-42A13E704DAD}" type="sibTrans" cxnId="{E4CF7678-4AB9-4863-803E-053E81B5B73A}">
      <dgm:prSet/>
      <dgm:spPr/>
      <dgm:t>
        <a:bodyPr/>
        <a:lstStyle/>
        <a:p>
          <a:endParaRPr lang="en-US"/>
        </a:p>
      </dgm:t>
    </dgm:pt>
    <dgm:pt modelId="{5C61A1C0-2244-48FF-95BF-3C6AB3A7B167}">
      <dgm:prSet phldrT="[Text]"/>
      <dgm:spPr/>
      <dgm:t>
        <a:bodyPr/>
        <a:lstStyle/>
        <a:p>
          <a:endParaRPr lang="en-US" b="1" dirty="0"/>
        </a:p>
      </dgm:t>
    </dgm:pt>
    <dgm:pt modelId="{911BE409-CB2A-4D29-8212-4B33B0C56BB3}" type="parTrans" cxnId="{0CBE9442-D680-4AF1-950A-CEEC10E61C7D}">
      <dgm:prSet/>
      <dgm:spPr/>
      <dgm:t>
        <a:bodyPr/>
        <a:lstStyle/>
        <a:p>
          <a:endParaRPr lang="en-US"/>
        </a:p>
      </dgm:t>
    </dgm:pt>
    <dgm:pt modelId="{41B909FA-B188-434A-A438-7A5D99CDE39C}" type="sibTrans" cxnId="{0CBE9442-D680-4AF1-950A-CEEC10E61C7D}">
      <dgm:prSet/>
      <dgm:spPr/>
      <dgm:t>
        <a:bodyPr/>
        <a:lstStyle/>
        <a:p>
          <a:endParaRPr lang="en-US"/>
        </a:p>
      </dgm:t>
    </dgm:pt>
    <dgm:pt modelId="{FE77C3D8-6F5C-4F4D-A077-48ED142FABDE}">
      <dgm:prSet phldrT="[Text]"/>
      <dgm:spPr/>
      <dgm:t>
        <a:bodyPr/>
        <a:lstStyle/>
        <a:p>
          <a:r>
            <a:rPr lang="en-US" dirty="0"/>
            <a:t>Intermediate Actions </a:t>
          </a:r>
        </a:p>
      </dgm:t>
    </dgm:pt>
    <dgm:pt modelId="{DF1D5FC5-2AA0-485B-83E3-B5BD450CBB63}" type="parTrans" cxnId="{3603C382-1B1A-4371-8548-360E76A1EDC8}">
      <dgm:prSet/>
      <dgm:spPr/>
      <dgm:t>
        <a:bodyPr/>
        <a:lstStyle/>
        <a:p>
          <a:endParaRPr lang="en-US"/>
        </a:p>
      </dgm:t>
    </dgm:pt>
    <dgm:pt modelId="{44105281-7BB0-4CC5-A492-F76346402014}" type="sibTrans" cxnId="{3603C382-1B1A-4371-8548-360E76A1EDC8}">
      <dgm:prSet/>
      <dgm:spPr/>
      <dgm:t>
        <a:bodyPr/>
        <a:lstStyle/>
        <a:p>
          <a:endParaRPr lang="en-US"/>
        </a:p>
      </dgm:t>
    </dgm:pt>
    <dgm:pt modelId="{CAB7823E-7D8A-4126-8252-A455C375FEB2}">
      <dgm:prSet phldrT="[Text]"/>
      <dgm:spPr/>
      <dgm:t>
        <a:bodyPr/>
        <a:lstStyle/>
        <a:p>
          <a:r>
            <a:rPr lang="en-US" dirty="0"/>
            <a:t>Weaker Actions </a:t>
          </a:r>
        </a:p>
      </dgm:t>
    </dgm:pt>
    <dgm:pt modelId="{FE235FAF-B8D0-4631-8886-A1642B65D90C}" type="parTrans" cxnId="{31EF7147-4CAC-4155-B7F9-06F0654A3C8D}">
      <dgm:prSet/>
      <dgm:spPr/>
      <dgm:t>
        <a:bodyPr/>
        <a:lstStyle/>
        <a:p>
          <a:endParaRPr lang="en-US"/>
        </a:p>
      </dgm:t>
    </dgm:pt>
    <dgm:pt modelId="{311030D4-1C70-4A6B-9FAF-49E540092F53}" type="sibTrans" cxnId="{31EF7147-4CAC-4155-B7F9-06F0654A3C8D}">
      <dgm:prSet/>
      <dgm:spPr/>
      <dgm:t>
        <a:bodyPr/>
        <a:lstStyle/>
        <a:p>
          <a:endParaRPr lang="en-US"/>
        </a:p>
      </dgm:t>
    </dgm:pt>
    <dgm:pt modelId="{66B2B98F-ECB2-4C5C-8531-973D662291E3}">
      <dgm:prSet phldrT="[Text]"/>
      <dgm:spPr/>
      <dgm:t>
        <a:bodyPr/>
        <a:lstStyle/>
        <a:p>
          <a:endParaRPr lang="en-US" dirty="0"/>
        </a:p>
      </dgm:t>
    </dgm:pt>
    <dgm:pt modelId="{179B1341-14BA-4A5F-9964-4E9C2AB07308}" type="parTrans" cxnId="{7BD3780B-829C-4D84-BA24-94A019E6F09A}">
      <dgm:prSet/>
      <dgm:spPr/>
      <dgm:t>
        <a:bodyPr/>
        <a:lstStyle/>
        <a:p>
          <a:endParaRPr lang="en-US"/>
        </a:p>
      </dgm:t>
    </dgm:pt>
    <dgm:pt modelId="{B3E23CB4-7DD0-4A00-96D1-54CAE6CA0421}" type="sibTrans" cxnId="{7BD3780B-829C-4D84-BA24-94A019E6F09A}">
      <dgm:prSet/>
      <dgm:spPr/>
      <dgm:t>
        <a:bodyPr/>
        <a:lstStyle/>
        <a:p>
          <a:endParaRPr lang="en-US"/>
        </a:p>
      </dgm:t>
    </dgm:pt>
    <dgm:pt modelId="{D4B60A04-DC56-46DC-BA23-610D30422B58}">
      <dgm:prSet phldrT="[Text]"/>
      <dgm:spPr/>
      <dgm:t>
        <a:bodyPr/>
        <a:lstStyle/>
        <a:p>
          <a:endParaRPr lang="en-US" dirty="0"/>
        </a:p>
      </dgm:t>
    </dgm:pt>
    <dgm:pt modelId="{5260062C-8946-49C8-9DDC-BBD5C696AA62}" type="parTrans" cxnId="{64BF367F-AE28-429A-91B7-DD211E4091AB}">
      <dgm:prSet/>
      <dgm:spPr/>
      <dgm:t>
        <a:bodyPr/>
        <a:lstStyle/>
        <a:p>
          <a:endParaRPr lang="en-US"/>
        </a:p>
      </dgm:t>
    </dgm:pt>
    <dgm:pt modelId="{3BA1732E-9D88-4B39-BE27-F28828684AE8}" type="sibTrans" cxnId="{64BF367F-AE28-429A-91B7-DD211E4091AB}">
      <dgm:prSet/>
      <dgm:spPr/>
      <dgm:t>
        <a:bodyPr/>
        <a:lstStyle/>
        <a:p>
          <a:endParaRPr lang="en-US"/>
        </a:p>
      </dgm:t>
    </dgm:pt>
    <dgm:pt modelId="{F8894363-4AA4-4004-BF04-85E3B745EBCD}">
      <dgm:prSet phldrT="[Text]"/>
      <dgm:spPr/>
      <dgm:t>
        <a:bodyPr/>
        <a:lstStyle/>
        <a:p>
          <a:endParaRPr lang="en-US" b="1" dirty="0"/>
        </a:p>
      </dgm:t>
    </dgm:pt>
    <dgm:pt modelId="{B9410CF8-400E-47DE-BC52-931B2DEDE6A1}" type="parTrans" cxnId="{DBB2DBC0-711C-4C1C-B93B-F1BA9DADE0B9}">
      <dgm:prSet/>
      <dgm:spPr/>
      <dgm:t>
        <a:bodyPr/>
        <a:lstStyle/>
        <a:p>
          <a:endParaRPr lang="en-US"/>
        </a:p>
      </dgm:t>
    </dgm:pt>
    <dgm:pt modelId="{50F41BEE-29A3-4AD8-BDD8-3F744BC79FBC}" type="sibTrans" cxnId="{DBB2DBC0-711C-4C1C-B93B-F1BA9DADE0B9}">
      <dgm:prSet/>
      <dgm:spPr/>
      <dgm:t>
        <a:bodyPr/>
        <a:lstStyle/>
        <a:p>
          <a:endParaRPr lang="en-US"/>
        </a:p>
      </dgm:t>
    </dgm:pt>
    <dgm:pt modelId="{FB40A6D0-5CAB-4EC7-8676-C29265706744}">
      <dgm:prSet phldrT="[Text]"/>
      <dgm:spPr/>
      <dgm:t>
        <a:bodyPr/>
        <a:lstStyle/>
        <a:p>
          <a:endParaRPr lang="en-US" b="1" dirty="0"/>
        </a:p>
      </dgm:t>
    </dgm:pt>
    <dgm:pt modelId="{438DD9A8-F1DC-4AEF-AD1A-2CD4C6F962C1}" type="parTrans" cxnId="{F74CCB1E-CAB2-4006-8772-639FBCB0B1B1}">
      <dgm:prSet/>
      <dgm:spPr/>
      <dgm:t>
        <a:bodyPr/>
        <a:lstStyle/>
        <a:p>
          <a:endParaRPr lang="en-US"/>
        </a:p>
      </dgm:t>
    </dgm:pt>
    <dgm:pt modelId="{E3CCE48A-CA92-44DA-BE32-E708346856C4}" type="sibTrans" cxnId="{F74CCB1E-CAB2-4006-8772-639FBCB0B1B1}">
      <dgm:prSet/>
      <dgm:spPr/>
      <dgm:t>
        <a:bodyPr/>
        <a:lstStyle/>
        <a:p>
          <a:endParaRPr lang="en-US"/>
        </a:p>
      </dgm:t>
    </dgm:pt>
    <dgm:pt modelId="{DAE4AB64-09E1-49DA-B3AB-6C37E7AE96EF}">
      <dgm:prSet phldrT="[Text]"/>
      <dgm:spPr/>
      <dgm:t>
        <a:bodyPr/>
        <a:lstStyle/>
        <a:p>
          <a:endParaRPr lang="en-US" b="1" dirty="0"/>
        </a:p>
      </dgm:t>
    </dgm:pt>
    <dgm:pt modelId="{578002FC-053D-4DC8-8020-FF646763BB22}" type="parTrans" cxnId="{9E6A43AA-1CC4-476F-9050-EC3CE6300F77}">
      <dgm:prSet/>
      <dgm:spPr/>
      <dgm:t>
        <a:bodyPr/>
        <a:lstStyle/>
        <a:p>
          <a:endParaRPr lang="en-US"/>
        </a:p>
      </dgm:t>
    </dgm:pt>
    <dgm:pt modelId="{88EBEA3A-EB77-4A0D-8AC8-7770FF772E6E}" type="sibTrans" cxnId="{9E6A43AA-1CC4-476F-9050-EC3CE6300F77}">
      <dgm:prSet/>
      <dgm:spPr/>
      <dgm:t>
        <a:bodyPr/>
        <a:lstStyle/>
        <a:p>
          <a:endParaRPr lang="en-US"/>
        </a:p>
      </dgm:t>
    </dgm:pt>
    <dgm:pt modelId="{FD583905-05EC-481F-813B-621CD90BBA5F}">
      <dgm:prSet phldrT="[Text]"/>
      <dgm:spPr/>
      <dgm:t>
        <a:bodyPr/>
        <a:lstStyle/>
        <a:p>
          <a:endParaRPr lang="en-US" b="1" dirty="0"/>
        </a:p>
      </dgm:t>
    </dgm:pt>
    <dgm:pt modelId="{B576AAE1-D0A8-4CD5-A49E-177E34AE4FF1}" type="parTrans" cxnId="{F5A21E56-68E5-4B60-A75E-BDCA3240D190}">
      <dgm:prSet/>
      <dgm:spPr/>
      <dgm:t>
        <a:bodyPr/>
        <a:lstStyle/>
        <a:p>
          <a:endParaRPr lang="en-US"/>
        </a:p>
      </dgm:t>
    </dgm:pt>
    <dgm:pt modelId="{14504585-82EE-46CC-BB9F-A148F596EAE9}" type="sibTrans" cxnId="{F5A21E56-68E5-4B60-A75E-BDCA3240D190}">
      <dgm:prSet/>
      <dgm:spPr/>
      <dgm:t>
        <a:bodyPr/>
        <a:lstStyle/>
        <a:p>
          <a:endParaRPr lang="en-US"/>
        </a:p>
      </dgm:t>
    </dgm:pt>
    <dgm:pt modelId="{B6E290CA-6412-4564-99E6-B9048ABC67A9}">
      <dgm:prSet phldrT="[Text]"/>
      <dgm:spPr/>
      <dgm:t>
        <a:bodyPr/>
        <a:lstStyle/>
        <a:p>
          <a:endParaRPr lang="en-US" dirty="0"/>
        </a:p>
      </dgm:t>
    </dgm:pt>
    <dgm:pt modelId="{987FED23-DAF9-44DC-AB4E-FC3452891FFF}" type="parTrans" cxnId="{27DC7D28-ED44-4435-9696-92D5A89ED525}">
      <dgm:prSet/>
      <dgm:spPr/>
      <dgm:t>
        <a:bodyPr/>
        <a:lstStyle/>
        <a:p>
          <a:endParaRPr lang="en-US"/>
        </a:p>
      </dgm:t>
    </dgm:pt>
    <dgm:pt modelId="{D3A19A83-5011-4B5E-82B8-CC55D810EF5F}" type="sibTrans" cxnId="{27DC7D28-ED44-4435-9696-92D5A89ED525}">
      <dgm:prSet/>
      <dgm:spPr/>
      <dgm:t>
        <a:bodyPr/>
        <a:lstStyle/>
        <a:p>
          <a:endParaRPr lang="en-US"/>
        </a:p>
      </dgm:t>
    </dgm:pt>
    <dgm:pt modelId="{59CC4922-B66F-45A2-A623-1F6773F0EC43}">
      <dgm:prSet phldrT="[Text]"/>
      <dgm:spPr/>
      <dgm:t>
        <a:bodyPr/>
        <a:lstStyle/>
        <a:p>
          <a:endParaRPr lang="en-US" dirty="0"/>
        </a:p>
      </dgm:t>
    </dgm:pt>
    <dgm:pt modelId="{9F7F131F-575B-4CF4-A323-59D324F80B2F}" type="parTrans" cxnId="{45762193-42B3-4CDA-A4C6-BBB2C281934E}">
      <dgm:prSet/>
      <dgm:spPr/>
      <dgm:t>
        <a:bodyPr/>
        <a:lstStyle/>
        <a:p>
          <a:endParaRPr lang="en-US"/>
        </a:p>
      </dgm:t>
    </dgm:pt>
    <dgm:pt modelId="{23F3FF27-4FE7-4CC4-8B0F-0CF4F0FF2122}" type="sibTrans" cxnId="{45762193-42B3-4CDA-A4C6-BBB2C281934E}">
      <dgm:prSet/>
      <dgm:spPr/>
      <dgm:t>
        <a:bodyPr/>
        <a:lstStyle/>
        <a:p>
          <a:endParaRPr lang="en-US"/>
        </a:p>
      </dgm:t>
    </dgm:pt>
    <dgm:pt modelId="{DE524263-C7BD-40D0-9C90-14361DD8D3D8}">
      <dgm:prSet phldrT="[Text]"/>
      <dgm:spPr/>
      <dgm:t>
        <a:bodyPr/>
        <a:lstStyle/>
        <a:p>
          <a:endParaRPr lang="en-US" dirty="0"/>
        </a:p>
      </dgm:t>
    </dgm:pt>
    <dgm:pt modelId="{DA2A1A29-0818-41F5-98AE-2DDE46661A32}" type="parTrans" cxnId="{35306492-E882-4E5E-9D30-837E8189C28B}">
      <dgm:prSet/>
      <dgm:spPr/>
      <dgm:t>
        <a:bodyPr/>
        <a:lstStyle/>
        <a:p>
          <a:endParaRPr lang="en-US"/>
        </a:p>
      </dgm:t>
    </dgm:pt>
    <dgm:pt modelId="{EB8BCB5C-050A-4657-953D-EE77D5E6C630}" type="sibTrans" cxnId="{35306492-E882-4E5E-9D30-837E8189C28B}">
      <dgm:prSet/>
      <dgm:spPr/>
      <dgm:t>
        <a:bodyPr/>
        <a:lstStyle/>
        <a:p>
          <a:endParaRPr lang="en-US"/>
        </a:p>
      </dgm:t>
    </dgm:pt>
    <dgm:pt modelId="{81038C20-09BE-4A2B-8554-5A347DCA6CBB}">
      <dgm:prSet phldrT="[Text]"/>
      <dgm:spPr/>
      <dgm:t>
        <a:bodyPr/>
        <a:lstStyle/>
        <a:p>
          <a:endParaRPr lang="en-US" dirty="0"/>
        </a:p>
      </dgm:t>
    </dgm:pt>
    <dgm:pt modelId="{D1F40FF6-1303-4E61-955A-CF7C76AB37B7}" type="parTrans" cxnId="{13045343-766E-49C8-9648-FCF03DBB4FD2}">
      <dgm:prSet/>
      <dgm:spPr/>
      <dgm:t>
        <a:bodyPr/>
        <a:lstStyle/>
        <a:p>
          <a:endParaRPr lang="en-US"/>
        </a:p>
      </dgm:t>
    </dgm:pt>
    <dgm:pt modelId="{AC0C0DD0-8D79-43DE-85B7-44FFF1FD15BA}" type="sibTrans" cxnId="{13045343-766E-49C8-9648-FCF03DBB4FD2}">
      <dgm:prSet/>
      <dgm:spPr/>
      <dgm:t>
        <a:bodyPr/>
        <a:lstStyle/>
        <a:p>
          <a:endParaRPr lang="en-US"/>
        </a:p>
      </dgm:t>
    </dgm:pt>
    <dgm:pt modelId="{7E358B95-84A0-4369-B420-52FFEE719FB3}" type="pres">
      <dgm:prSet presAssocID="{F3535B61-D9DD-4C98-B161-0E01D692D463}" presName="Name0" presStyleCnt="0">
        <dgm:presLayoutVars>
          <dgm:dir/>
          <dgm:animLvl val="lvl"/>
          <dgm:resizeHandles val="exact"/>
        </dgm:presLayoutVars>
      </dgm:prSet>
      <dgm:spPr/>
    </dgm:pt>
    <dgm:pt modelId="{163E047A-1F0F-42CB-9FD6-EB3A99299721}" type="pres">
      <dgm:prSet presAssocID="{481C1A3B-8343-45F1-AABE-99E97A73C9FA}" presName="composite" presStyleCnt="0"/>
      <dgm:spPr/>
    </dgm:pt>
    <dgm:pt modelId="{6CF1F402-DBDE-4B65-A3EC-65CD0C60188F}" type="pres">
      <dgm:prSet presAssocID="{481C1A3B-8343-45F1-AABE-99E97A73C9FA}" presName="parTx" presStyleLbl="alignNode1" presStyleIdx="0" presStyleCnt="3">
        <dgm:presLayoutVars>
          <dgm:chMax val="0"/>
          <dgm:chPref val="0"/>
          <dgm:bulletEnabled val="1"/>
        </dgm:presLayoutVars>
      </dgm:prSet>
      <dgm:spPr/>
    </dgm:pt>
    <dgm:pt modelId="{ABF04535-9598-4334-84C2-E23ACD5D63D1}" type="pres">
      <dgm:prSet presAssocID="{481C1A3B-8343-45F1-AABE-99E97A73C9FA}" presName="desTx" presStyleLbl="alignAccFollowNode1" presStyleIdx="0" presStyleCnt="3">
        <dgm:presLayoutVars>
          <dgm:bulletEnabled val="1"/>
        </dgm:presLayoutVars>
      </dgm:prSet>
      <dgm:spPr/>
    </dgm:pt>
    <dgm:pt modelId="{BCE6E13B-6D6D-4D68-B979-122E63F8CECA}" type="pres">
      <dgm:prSet presAssocID="{3B8CC567-78C7-4E93-AEAB-42A13E704DAD}" presName="space" presStyleCnt="0"/>
      <dgm:spPr/>
    </dgm:pt>
    <dgm:pt modelId="{25A715E1-FEFD-4C38-BD05-09F3582E18F4}" type="pres">
      <dgm:prSet presAssocID="{FE77C3D8-6F5C-4F4D-A077-48ED142FABDE}" presName="composite" presStyleCnt="0"/>
      <dgm:spPr/>
    </dgm:pt>
    <dgm:pt modelId="{49FCB5CD-8986-406F-BC29-CA83CE891801}" type="pres">
      <dgm:prSet presAssocID="{FE77C3D8-6F5C-4F4D-A077-48ED142FABDE}" presName="parTx" presStyleLbl="alignNode1" presStyleIdx="1" presStyleCnt="3">
        <dgm:presLayoutVars>
          <dgm:chMax val="0"/>
          <dgm:chPref val="0"/>
          <dgm:bulletEnabled val="1"/>
        </dgm:presLayoutVars>
      </dgm:prSet>
      <dgm:spPr/>
    </dgm:pt>
    <dgm:pt modelId="{139A6F0D-B8EF-4250-8F75-78B939F3583F}" type="pres">
      <dgm:prSet presAssocID="{FE77C3D8-6F5C-4F4D-A077-48ED142FABDE}" presName="desTx" presStyleLbl="alignAccFollowNode1" presStyleIdx="1" presStyleCnt="3">
        <dgm:presLayoutVars>
          <dgm:bulletEnabled val="1"/>
        </dgm:presLayoutVars>
      </dgm:prSet>
      <dgm:spPr/>
    </dgm:pt>
    <dgm:pt modelId="{5E1917A8-20E1-467D-8B45-29F730E73B43}" type="pres">
      <dgm:prSet presAssocID="{44105281-7BB0-4CC5-A492-F76346402014}" presName="space" presStyleCnt="0"/>
      <dgm:spPr/>
    </dgm:pt>
    <dgm:pt modelId="{824201A5-325A-4B8E-94FC-B39A9E0A6393}" type="pres">
      <dgm:prSet presAssocID="{CAB7823E-7D8A-4126-8252-A455C375FEB2}" presName="composite" presStyleCnt="0"/>
      <dgm:spPr/>
    </dgm:pt>
    <dgm:pt modelId="{4CEBF87C-734E-4E67-91D9-411F1F25C6A0}" type="pres">
      <dgm:prSet presAssocID="{CAB7823E-7D8A-4126-8252-A455C375FEB2}" presName="parTx" presStyleLbl="alignNode1" presStyleIdx="2" presStyleCnt="3">
        <dgm:presLayoutVars>
          <dgm:chMax val="0"/>
          <dgm:chPref val="0"/>
          <dgm:bulletEnabled val="1"/>
        </dgm:presLayoutVars>
      </dgm:prSet>
      <dgm:spPr/>
    </dgm:pt>
    <dgm:pt modelId="{78045E42-7262-44CC-86BC-4E476A6B926C}" type="pres">
      <dgm:prSet presAssocID="{CAB7823E-7D8A-4126-8252-A455C375FEB2}" presName="desTx" presStyleLbl="alignAccFollowNode1" presStyleIdx="2" presStyleCnt="3">
        <dgm:presLayoutVars>
          <dgm:bulletEnabled val="1"/>
        </dgm:presLayoutVars>
      </dgm:prSet>
      <dgm:spPr/>
    </dgm:pt>
  </dgm:ptLst>
  <dgm:cxnLst>
    <dgm:cxn modelId="{7BD3780B-829C-4D84-BA24-94A019E6F09A}" srcId="{FE77C3D8-6F5C-4F4D-A077-48ED142FABDE}" destId="{66B2B98F-ECB2-4C5C-8531-973D662291E3}" srcOrd="4" destOrd="0" parTransId="{179B1341-14BA-4A5F-9964-4E9C2AB07308}" sibTransId="{B3E23CB4-7DD0-4A00-96D1-54CAE6CA0421}"/>
    <dgm:cxn modelId="{9A14801B-CAD0-4AC6-BE23-487B56AFD7F0}" type="presOf" srcId="{66B2B98F-ECB2-4C5C-8531-973D662291E3}" destId="{139A6F0D-B8EF-4250-8F75-78B939F3583F}" srcOrd="0" destOrd="4" presId="urn:microsoft.com/office/officeart/2005/8/layout/hList1"/>
    <dgm:cxn modelId="{8F27A11B-3089-48F8-9A83-7778D6B99F1C}" type="presOf" srcId="{B6E290CA-6412-4564-99E6-B9048ABC67A9}" destId="{139A6F0D-B8EF-4250-8F75-78B939F3583F}" srcOrd="0" destOrd="0" presId="urn:microsoft.com/office/officeart/2005/8/layout/hList1"/>
    <dgm:cxn modelId="{F74CCB1E-CAB2-4006-8772-639FBCB0B1B1}" srcId="{481C1A3B-8343-45F1-AABE-99E97A73C9FA}" destId="{FB40A6D0-5CAB-4EC7-8676-C29265706744}" srcOrd="1" destOrd="0" parTransId="{438DD9A8-F1DC-4AEF-AD1A-2CD4C6F962C1}" sibTransId="{E3CCE48A-CA92-44DA-BE32-E708346856C4}"/>
    <dgm:cxn modelId="{AE02D21F-8EB5-4BA0-BE87-EBC81D02DEAD}" type="presOf" srcId="{81038C20-09BE-4A2B-8554-5A347DCA6CBB}" destId="{139A6F0D-B8EF-4250-8F75-78B939F3583F}" srcOrd="0" destOrd="3" presId="urn:microsoft.com/office/officeart/2005/8/layout/hList1"/>
    <dgm:cxn modelId="{27DC7D28-ED44-4435-9696-92D5A89ED525}" srcId="{FE77C3D8-6F5C-4F4D-A077-48ED142FABDE}" destId="{B6E290CA-6412-4564-99E6-B9048ABC67A9}" srcOrd="0" destOrd="0" parTransId="{987FED23-DAF9-44DC-AB4E-FC3452891FFF}" sibTransId="{D3A19A83-5011-4B5E-82B8-CC55D810EF5F}"/>
    <dgm:cxn modelId="{CE4C412E-EA97-4F42-B502-ADCFFFC6CC48}" type="presOf" srcId="{481C1A3B-8343-45F1-AABE-99E97A73C9FA}" destId="{6CF1F402-DBDE-4B65-A3EC-65CD0C60188F}" srcOrd="0" destOrd="0" presId="urn:microsoft.com/office/officeart/2005/8/layout/hList1"/>
    <dgm:cxn modelId="{26FE1831-EB8D-4CFD-AAEB-79E74027DABA}" type="presOf" srcId="{59CC4922-B66F-45A2-A623-1F6773F0EC43}" destId="{139A6F0D-B8EF-4250-8F75-78B939F3583F}" srcOrd="0" destOrd="1" presId="urn:microsoft.com/office/officeart/2005/8/layout/hList1"/>
    <dgm:cxn modelId="{0CBE9442-D680-4AF1-950A-CEEC10E61C7D}" srcId="{481C1A3B-8343-45F1-AABE-99E97A73C9FA}" destId="{5C61A1C0-2244-48FF-95BF-3C6AB3A7B167}" srcOrd="4" destOrd="0" parTransId="{911BE409-CB2A-4D29-8212-4B33B0C56BB3}" sibTransId="{41B909FA-B188-434A-A438-7A5D99CDE39C}"/>
    <dgm:cxn modelId="{13045343-766E-49C8-9648-FCF03DBB4FD2}" srcId="{FE77C3D8-6F5C-4F4D-A077-48ED142FABDE}" destId="{81038C20-09BE-4A2B-8554-5A347DCA6CBB}" srcOrd="3" destOrd="0" parTransId="{D1F40FF6-1303-4E61-955A-CF7C76AB37B7}" sibTransId="{AC0C0DD0-8D79-43DE-85B7-44FFF1FD15BA}"/>
    <dgm:cxn modelId="{31EF7147-4CAC-4155-B7F9-06F0654A3C8D}" srcId="{F3535B61-D9DD-4C98-B161-0E01D692D463}" destId="{CAB7823E-7D8A-4126-8252-A455C375FEB2}" srcOrd="2" destOrd="0" parTransId="{FE235FAF-B8D0-4631-8886-A1642B65D90C}" sibTransId="{311030D4-1C70-4A6B-9FAF-49E540092F53}"/>
    <dgm:cxn modelId="{F5A21E56-68E5-4B60-A75E-BDCA3240D190}" srcId="{481C1A3B-8343-45F1-AABE-99E97A73C9FA}" destId="{FD583905-05EC-481F-813B-621CD90BBA5F}" srcOrd="3" destOrd="0" parTransId="{B576AAE1-D0A8-4CD5-A49E-177E34AE4FF1}" sibTransId="{14504585-82EE-46CC-BB9F-A148F596EAE9}"/>
    <dgm:cxn modelId="{E4CF7678-4AB9-4863-803E-053E81B5B73A}" srcId="{F3535B61-D9DD-4C98-B161-0E01D692D463}" destId="{481C1A3B-8343-45F1-AABE-99E97A73C9FA}" srcOrd="0" destOrd="0" parTransId="{203E1457-7A2F-40BD-81FD-BBF6DDD53442}" sibTransId="{3B8CC567-78C7-4E93-AEAB-42A13E704DAD}"/>
    <dgm:cxn modelId="{64BF367F-AE28-429A-91B7-DD211E4091AB}" srcId="{CAB7823E-7D8A-4126-8252-A455C375FEB2}" destId="{D4B60A04-DC56-46DC-BA23-610D30422B58}" srcOrd="0" destOrd="0" parTransId="{5260062C-8946-49C8-9DDC-BBD5C696AA62}" sibTransId="{3BA1732E-9D88-4B39-BE27-F28828684AE8}"/>
    <dgm:cxn modelId="{3603C382-1B1A-4371-8548-360E76A1EDC8}" srcId="{F3535B61-D9DD-4C98-B161-0E01D692D463}" destId="{FE77C3D8-6F5C-4F4D-A077-48ED142FABDE}" srcOrd="1" destOrd="0" parTransId="{DF1D5FC5-2AA0-485B-83E3-B5BD450CBB63}" sibTransId="{44105281-7BB0-4CC5-A492-F76346402014}"/>
    <dgm:cxn modelId="{EE76E284-2F98-4F0D-B990-2C138C2FD1F5}" type="presOf" srcId="{CAB7823E-7D8A-4126-8252-A455C375FEB2}" destId="{4CEBF87C-734E-4E67-91D9-411F1F25C6A0}" srcOrd="0" destOrd="0" presId="urn:microsoft.com/office/officeart/2005/8/layout/hList1"/>
    <dgm:cxn modelId="{35306492-E882-4E5E-9D30-837E8189C28B}" srcId="{FE77C3D8-6F5C-4F4D-A077-48ED142FABDE}" destId="{DE524263-C7BD-40D0-9C90-14361DD8D3D8}" srcOrd="2" destOrd="0" parTransId="{DA2A1A29-0818-41F5-98AE-2DDE46661A32}" sibTransId="{EB8BCB5C-050A-4657-953D-EE77D5E6C630}"/>
    <dgm:cxn modelId="{45762193-42B3-4CDA-A4C6-BBB2C281934E}" srcId="{FE77C3D8-6F5C-4F4D-A077-48ED142FABDE}" destId="{59CC4922-B66F-45A2-A623-1F6773F0EC43}" srcOrd="1" destOrd="0" parTransId="{9F7F131F-575B-4CF4-A323-59D324F80B2F}" sibTransId="{23F3FF27-4FE7-4CC4-8B0F-0CF4F0FF2122}"/>
    <dgm:cxn modelId="{E0A26AA6-557B-4533-A731-8BCAF8F7F355}" type="presOf" srcId="{F8894363-4AA4-4004-BF04-85E3B745EBCD}" destId="{ABF04535-9598-4334-84C2-E23ACD5D63D1}" srcOrd="0" destOrd="0" presId="urn:microsoft.com/office/officeart/2005/8/layout/hList1"/>
    <dgm:cxn modelId="{9E6A43AA-1CC4-476F-9050-EC3CE6300F77}" srcId="{481C1A3B-8343-45F1-AABE-99E97A73C9FA}" destId="{DAE4AB64-09E1-49DA-B3AB-6C37E7AE96EF}" srcOrd="2" destOrd="0" parTransId="{578002FC-053D-4DC8-8020-FF646763BB22}" sibTransId="{88EBEA3A-EB77-4A0D-8AC8-7770FF772E6E}"/>
    <dgm:cxn modelId="{63C5D9B1-2DF0-4CF6-BA88-06E623F68C67}" type="presOf" srcId="{DAE4AB64-09E1-49DA-B3AB-6C37E7AE96EF}" destId="{ABF04535-9598-4334-84C2-E23ACD5D63D1}" srcOrd="0" destOrd="2" presId="urn:microsoft.com/office/officeart/2005/8/layout/hList1"/>
    <dgm:cxn modelId="{15F955B7-D957-4BC4-BF8C-C1C39D2837FB}" type="presOf" srcId="{FB40A6D0-5CAB-4EC7-8676-C29265706744}" destId="{ABF04535-9598-4334-84C2-E23ACD5D63D1}" srcOrd="0" destOrd="1" presId="urn:microsoft.com/office/officeart/2005/8/layout/hList1"/>
    <dgm:cxn modelId="{CE2E48B8-FD4B-4EBD-995C-2DEC52423A7A}" type="presOf" srcId="{FE77C3D8-6F5C-4F4D-A077-48ED142FABDE}" destId="{49FCB5CD-8986-406F-BC29-CA83CE891801}" srcOrd="0" destOrd="0" presId="urn:microsoft.com/office/officeart/2005/8/layout/hList1"/>
    <dgm:cxn modelId="{DBB2DBC0-711C-4C1C-B93B-F1BA9DADE0B9}" srcId="{481C1A3B-8343-45F1-AABE-99E97A73C9FA}" destId="{F8894363-4AA4-4004-BF04-85E3B745EBCD}" srcOrd="0" destOrd="0" parTransId="{B9410CF8-400E-47DE-BC52-931B2DEDE6A1}" sibTransId="{50F41BEE-29A3-4AD8-BDD8-3F744BC79FBC}"/>
    <dgm:cxn modelId="{71C7E8D0-C019-4626-ADAC-6127D1D88487}" type="presOf" srcId="{F3535B61-D9DD-4C98-B161-0E01D692D463}" destId="{7E358B95-84A0-4369-B420-52FFEE719FB3}" srcOrd="0" destOrd="0" presId="urn:microsoft.com/office/officeart/2005/8/layout/hList1"/>
    <dgm:cxn modelId="{D64304D9-C170-4CF7-9C82-E768659066B0}" type="presOf" srcId="{5C61A1C0-2244-48FF-95BF-3C6AB3A7B167}" destId="{ABF04535-9598-4334-84C2-E23ACD5D63D1}" srcOrd="0" destOrd="4" presId="urn:microsoft.com/office/officeart/2005/8/layout/hList1"/>
    <dgm:cxn modelId="{3B3976D9-19E9-47CB-9364-9B0D42A6D247}" type="presOf" srcId="{DE524263-C7BD-40D0-9C90-14361DD8D3D8}" destId="{139A6F0D-B8EF-4250-8F75-78B939F3583F}" srcOrd="0" destOrd="2" presId="urn:microsoft.com/office/officeart/2005/8/layout/hList1"/>
    <dgm:cxn modelId="{B35D99DE-2917-43B4-8960-0185CFC24794}" type="presOf" srcId="{FD583905-05EC-481F-813B-621CD90BBA5F}" destId="{ABF04535-9598-4334-84C2-E23ACD5D63D1}" srcOrd="0" destOrd="3" presId="urn:microsoft.com/office/officeart/2005/8/layout/hList1"/>
    <dgm:cxn modelId="{6ACC26F9-3DE0-4B35-9B4D-6B1C7C786E75}" type="presOf" srcId="{D4B60A04-DC56-46DC-BA23-610D30422B58}" destId="{78045E42-7262-44CC-86BC-4E476A6B926C}" srcOrd="0" destOrd="0" presId="urn:microsoft.com/office/officeart/2005/8/layout/hList1"/>
    <dgm:cxn modelId="{6D515413-25B6-4F40-BF8A-1BD4F7112676}" type="presParOf" srcId="{7E358B95-84A0-4369-B420-52FFEE719FB3}" destId="{163E047A-1F0F-42CB-9FD6-EB3A99299721}" srcOrd="0" destOrd="0" presId="urn:microsoft.com/office/officeart/2005/8/layout/hList1"/>
    <dgm:cxn modelId="{FD8C30CF-341E-46AE-84FA-90BD3574D232}" type="presParOf" srcId="{163E047A-1F0F-42CB-9FD6-EB3A99299721}" destId="{6CF1F402-DBDE-4B65-A3EC-65CD0C60188F}" srcOrd="0" destOrd="0" presId="urn:microsoft.com/office/officeart/2005/8/layout/hList1"/>
    <dgm:cxn modelId="{B9A588F8-8549-4FC8-BF36-46CC543FAFFE}" type="presParOf" srcId="{163E047A-1F0F-42CB-9FD6-EB3A99299721}" destId="{ABF04535-9598-4334-84C2-E23ACD5D63D1}" srcOrd="1" destOrd="0" presId="urn:microsoft.com/office/officeart/2005/8/layout/hList1"/>
    <dgm:cxn modelId="{EF9B4CFA-A6A9-4449-AA2B-49D5DB718C5A}" type="presParOf" srcId="{7E358B95-84A0-4369-B420-52FFEE719FB3}" destId="{BCE6E13B-6D6D-4D68-B979-122E63F8CECA}" srcOrd="1" destOrd="0" presId="urn:microsoft.com/office/officeart/2005/8/layout/hList1"/>
    <dgm:cxn modelId="{9C9B9DE6-87D9-49A5-BD22-F7CDCD9954AD}" type="presParOf" srcId="{7E358B95-84A0-4369-B420-52FFEE719FB3}" destId="{25A715E1-FEFD-4C38-BD05-09F3582E18F4}" srcOrd="2" destOrd="0" presId="urn:microsoft.com/office/officeart/2005/8/layout/hList1"/>
    <dgm:cxn modelId="{CDF42110-890D-469E-8F12-CEA22CAF3E3B}" type="presParOf" srcId="{25A715E1-FEFD-4C38-BD05-09F3582E18F4}" destId="{49FCB5CD-8986-406F-BC29-CA83CE891801}" srcOrd="0" destOrd="0" presId="urn:microsoft.com/office/officeart/2005/8/layout/hList1"/>
    <dgm:cxn modelId="{C727D8F8-18FA-4995-9558-F883660EE393}" type="presParOf" srcId="{25A715E1-FEFD-4C38-BD05-09F3582E18F4}" destId="{139A6F0D-B8EF-4250-8F75-78B939F3583F}" srcOrd="1" destOrd="0" presId="urn:microsoft.com/office/officeart/2005/8/layout/hList1"/>
    <dgm:cxn modelId="{8D9BA717-F74C-4B06-A341-E481E76B4F74}" type="presParOf" srcId="{7E358B95-84A0-4369-B420-52FFEE719FB3}" destId="{5E1917A8-20E1-467D-8B45-29F730E73B43}" srcOrd="3" destOrd="0" presId="urn:microsoft.com/office/officeart/2005/8/layout/hList1"/>
    <dgm:cxn modelId="{B1710927-4451-45EA-A248-137CA388DD4C}" type="presParOf" srcId="{7E358B95-84A0-4369-B420-52FFEE719FB3}" destId="{824201A5-325A-4B8E-94FC-B39A9E0A6393}" srcOrd="4" destOrd="0" presId="urn:microsoft.com/office/officeart/2005/8/layout/hList1"/>
    <dgm:cxn modelId="{9E4C1EE2-BDB3-42F5-B8AB-A10055F2BE42}" type="presParOf" srcId="{824201A5-325A-4B8E-94FC-B39A9E0A6393}" destId="{4CEBF87C-734E-4E67-91D9-411F1F25C6A0}" srcOrd="0" destOrd="0" presId="urn:microsoft.com/office/officeart/2005/8/layout/hList1"/>
    <dgm:cxn modelId="{87167BCF-FB5F-4473-B8A7-304B9C614760}" type="presParOf" srcId="{824201A5-325A-4B8E-94FC-B39A9E0A6393}" destId="{78045E42-7262-44CC-86BC-4E476A6B926C}" srcOrd="1" destOrd="0" presId="urn:microsoft.com/office/officeart/2005/8/layout/hLis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DE0C7A9-0447-486A-A288-1419834CC8C2}">
      <dsp:nvSpPr>
        <dsp:cNvPr id="0" name=""/>
        <dsp:cNvSpPr/>
      </dsp:nvSpPr>
      <dsp:spPr>
        <a:xfrm>
          <a:off x="495061" y="645"/>
          <a:ext cx="2262336" cy="1357401"/>
        </a:xfrm>
        <a:prstGeom prst="rect">
          <a:avLst/>
        </a:prstGeom>
        <a:solidFill>
          <a:schemeClr val="accent5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kern="1200" dirty="0"/>
            <a:t>Eliminate Waste</a:t>
          </a:r>
        </a:p>
      </dsp:txBody>
      <dsp:txXfrm>
        <a:off x="495061" y="645"/>
        <a:ext cx="2262336" cy="1357401"/>
      </dsp:txXfrm>
    </dsp:sp>
    <dsp:sp modelId="{278DAD2A-5B15-4CDC-9B63-D234D22341C3}">
      <dsp:nvSpPr>
        <dsp:cNvPr id="0" name=""/>
        <dsp:cNvSpPr/>
      </dsp:nvSpPr>
      <dsp:spPr>
        <a:xfrm>
          <a:off x="2983631" y="645"/>
          <a:ext cx="2262336" cy="1357401"/>
        </a:xfrm>
        <a:prstGeom prst="rect">
          <a:avLst/>
        </a:prstGeom>
        <a:solidFill>
          <a:schemeClr val="accent5">
            <a:hueOff val="-844818"/>
            <a:satOff val="-2177"/>
            <a:lumOff val="-1471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kern="1200" dirty="0"/>
            <a:t>Improve workflow</a:t>
          </a:r>
        </a:p>
      </dsp:txBody>
      <dsp:txXfrm>
        <a:off x="2983631" y="645"/>
        <a:ext cx="2262336" cy="1357401"/>
      </dsp:txXfrm>
    </dsp:sp>
    <dsp:sp modelId="{DF9F290A-1A73-4129-BFA1-04F5A0E8B08C}">
      <dsp:nvSpPr>
        <dsp:cNvPr id="0" name=""/>
        <dsp:cNvSpPr/>
      </dsp:nvSpPr>
      <dsp:spPr>
        <a:xfrm>
          <a:off x="5472201" y="645"/>
          <a:ext cx="2262336" cy="1357401"/>
        </a:xfrm>
        <a:prstGeom prst="rect">
          <a:avLst/>
        </a:prstGeom>
        <a:solidFill>
          <a:schemeClr val="accent5">
            <a:hueOff val="-1689636"/>
            <a:satOff val="-4355"/>
            <a:lumOff val="-2941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kern="1200" dirty="0"/>
            <a:t>Optimize inventory</a:t>
          </a:r>
        </a:p>
      </dsp:txBody>
      <dsp:txXfrm>
        <a:off x="5472201" y="645"/>
        <a:ext cx="2262336" cy="1357401"/>
      </dsp:txXfrm>
    </dsp:sp>
    <dsp:sp modelId="{1F8BA1AE-074D-4299-955B-957B10487CC6}">
      <dsp:nvSpPr>
        <dsp:cNvPr id="0" name=""/>
        <dsp:cNvSpPr/>
      </dsp:nvSpPr>
      <dsp:spPr>
        <a:xfrm>
          <a:off x="495061" y="1584280"/>
          <a:ext cx="2262336" cy="1357401"/>
        </a:xfrm>
        <a:prstGeom prst="rect">
          <a:avLst/>
        </a:prstGeom>
        <a:solidFill>
          <a:schemeClr val="accent5">
            <a:hueOff val="-2534453"/>
            <a:satOff val="-6532"/>
            <a:lumOff val="-4412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kern="1200" dirty="0"/>
            <a:t>Enhance producer/customer relationship</a:t>
          </a:r>
        </a:p>
      </dsp:txBody>
      <dsp:txXfrm>
        <a:off x="495061" y="1584280"/>
        <a:ext cx="2262336" cy="1357401"/>
      </dsp:txXfrm>
    </dsp:sp>
    <dsp:sp modelId="{03DFE8C5-1E48-4011-9705-54ACAAA760A6}">
      <dsp:nvSpPr>
        <dsp:cNvPr id="0" name=""/>
        <dsp:cNvSpPr/>
      </dsp:nvSpPr>
      <dsp:spPr>
        <a:xfrm>
          <a:off x="2983631" y="1584280"/>
          <a:ext cx="2262336" cy="1357401"/>
        </a:xfrm>
        <a:prstGeom prst="rect">
          <a:avLst/>
        </a:prstGeom>
        <a:solidFill>
          <a:schemeClr val="accent5">
            <a:hueOff val="-3379271"/>
            <a:satOff val="-8710"/>
            <a:lumOff val="-5883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kern="1200" dirty="0"/>
            <a:t>Change the work environment</a:t>
          </a:r>
        </a:p>
      </dsp:txBody>
      <dsp:txXfrm>
        <a:off x="2983631" y="1584280"/>
        <a:ext cx="2262336" cy="1357401"/>
      </dsp:txXfrm>
    </dsp:sp>
    <dsp:sp modelId="{B52470B3-DA97-4CCD-A5CD-50501862C37A}">
      <dsp:nvSpPr>
        <dsp:cNvPr id="0" name=""/>
        <dsp:cNvSpPr/>
      </dsp:nvSpPr>
      <dsp:spPr>
        <a:xfrm>
          <a:off x="5472201" y="1584280"/>
          <a:ext cx="2262336" cy="1357401"/>
        </a:xfrm>
        <a:prstGeom prst="rect">
          <a:avLst/>
        </a:prstGeom>
        <a:solidFill>
          <a:schemeClr val="accent5">
            <a:hueOff val="-4224089"/>
            <a:satOff val="-10887"/>
            <a:lumOff val="-7353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kern="1200" dirty="0"/>
            <a:t>Manage time</a:t>
          </a:r>
        </a:p>
      </dsp:txBody>
      <dsp:txXfrm>
        <a:off x="5472201" y="1584280"/>
        <a:ext cx="2262336" cy="1357401"/>
      </dsp:txXfrm>
    </dsp:sp>
    <dsp:sp modelId="{F7805876-F745-4BE3-AF89-5C20A630E278}">
      <dsp:nvSpPr>
        <dsp:cNvPr id="0" name=""/>
        <dsp:cNvSpPr/>
      </dsp:nvSpPr>
      <dsp:spPr>
        <a:xfrm>
          <a:off x="495061" y="3167916"/>
          <a:ext cx="2262336" cy="1357401"/>
        </a:xfrm>
        <a:prstGeom prst="rect">
          <a:avLst/>
        </a:prstGeom>
        <a:solidFill>
          <a:schemeClr val="accent5">
            <a:hueOff val="-5068907"/>
            <a:satOff val="-13064"/>
            <a:lumOff val="-8824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kern="1200" dirty="0"/>
            <a:t>Manage variation</a:t>
          </a:r>
        </a:p>
      </dsp:txBody>
      <dsp:txXfrm>
        <a:off x="495061" y="3167916"/>
        <a:ext cx="2262336" cy="1357401"/>
      </dsp:txXfrm>
    </dsp:sp>
    <dsp:sp modelId="{92E2E38B-456D-4D16-BDD2-A713F61F5E1D}">
      <dsp:nvSpPr>
        <dsp:cNvPr id="0" name=""/>
        <dsp:cNvSpPr/>
      </dsp:nvSpPr>
      <dsp:spPr>
        <a:xfrm>
          <a:off x="2983631" y="3167916"/>
          <a:ext cx="2262336" cy="1357401"/>
        </a:xfrm>
        <a:prstGeom prst="rect">
          <a:avLst/>
        </a:prstGeom>
        <a:solidFill>
          <a:schemeClr val="accent5">
            <a:hueOff val="-5913725"/>
            <a:satOff val="-15242"/>
            <a:lumOff val="-10294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kern="1200" dirty="0"/>
            <a:t>Design systems to avoid mistakes </a:t>
          </a:r>
        </a:p>
      </dsp:txBody>
      <dsp:txXfrm>
        <a:off x="2983631" y="3167916"/>
        <a:ext cx="2262336" cy="1357401"/>
      </dsp:txXfrm>
    </dsp:sp>
    <dsp:sp modelId="{D99B5DBA-C3D5-4D03-9885-F4C47F08B48D}">
      <dsp:nvSpPr>
        <dsp:cNvPr id="0" name=""/>
        <dsp:cNvSpPr/>
      </dsp:nvSpPr>
      <dsp:spPr>
        <a:xfrm>
          <a:off x="5472201" y="3167916"/>
          <a:ext cx="2262336" cy="1357401"/>
        </a:xfrm>
        <a:prstGeom prst="rect">
          <a:avLst/>
        </a:prstGeom>
        <a:solidFill>
          <a:schemeClr val="accent5">
            <a:hueOff val="-6758543"/>
            <a:satOff val="-17419"/>
            <a:lumOff val="-11765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kern="1200" dirty="0"/>
            <a:t>Focus on product design/services </a:t>
          </a:r>
        </a:p>
      </dsp:txBody>
      <dsp:txXfrm>
        <a:off x="5472201" y="3167916"/>
        <a:ext cx="2262336" cy="1357401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CF1F402-DBDE-4B65-A3EC-65CD0C60188F}">
      <dsp:nvSpPr>
        <dsp:cNvPr id="0" name=""/>
        <dsp:cNvSpPr/>
      </dsp:nvSpPr>
      <dsp:spPr>
        <a:xfrm>
          <a:off x="2646" y="840813"/>
          <a:ext cx="2579970" cy="1010839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9136" tIns="113792" rIns="199136" bIns="113792" numCol="1" spcCol="1270" anchor="ctr" anchorCtr="0">
          <a:noAutofit/>
        </a:bodyPr>
        <a:lstStyle/>
        <a:p>
          <a:pPr marL="0" lvl="0" indent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800" kern="1200" dirty="0"/>
            <a:t>Stronger Actions</a:t>
          </a:r>
        </a:p>
      </dsp:txBody>
      <dsp:txXfrm>
        <a:off x="2646" y="840813"/>
        <a:ext cx="2579970" cy="1010839"/>
      </dsp:txXfrm>
    </dsp:sp>
    <dsp:sp modelId="{ABF04535-9598-4334-84C2-E23ACD5D63D1}">
      <dsp:nvSpPr>
        <dsp:cNvPr id="0" name=""/>
        <dsp:cNvSpPr/>
      </dsp:nvSpPr>
      <dsp:spPr>
        <a:xfrm>
          <a:off x="2646" y="1851653"/>
          <a:ext cx="2579970" cy="2613239"/>
        </a:xfrm>
        <a:prstGeom prst="rect">
          <a:avLst/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49352" tIns="149352" rIns="199136" bIns="224028" numCol="1" spcCol="1270" anchor="t" anchorCtr="0">
          <a:noAutofit/>
        </a:bodyPr>
        <a:lstStyle/>
        <a:p>
          <a:pPr marL="285750" lvl="1" indent="-285750" algn="l" defTabSz="12446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2800" b="1" kern="1200" dirty="0"/>
        </a:p>
        <a:p>
          <a:pPr marL="285750" lvl="1" indent="-285750" algn="l" defTabSz="12446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2800" b="1" kern="1200" dirty="0"/>
        </a:p>
        <a:p>
          <a:pPr marL="285750" lvl="1" indent="-285750" algn="l" defTabSz="12446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2800" b="1" kern="1200" dirty="0"/>
        </a:p>
        <a:p>
          <a:pPr marL="285750" lvl="1" indent="-285750" algn="l" defTabSz="12446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2800" b="1" kern="1200" dirty="0"/>
        </a:p>
        <a:p>
          <a:pPr marL="285750" lvl="1" indent="-285750" algn="l" defTabSz="12446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2800" b="1" kern="1200" dirty="0"/>
        </a:p>
      </dsp:txBody>
      <dsp:txXfrm>
        <a:off x="2646" y="1851653"/>
        <a:ext cx="2579970" cy="2613239"/>
      </dsp:txXfrm>
    </dsp:sp>
    <dsp:sp modelId="{49FCB5CD-8986-406F-BC29-CA83CE891801}">
      <dsp:nvSpPr>
        <dsp:cNvPr id="0" name=""/>
        <dsp:cNvSpPr/>
      </dsp:nvSpPr>
      <dsp:spPr>
        <a:xfrm>
          <a:off x="2943811" y="840813"/>
          <a:ext cx="2579970" cy="1010839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9136" tIns="113792" rIns="199136" bIns="113792" numCol="1" spcCol="1270" anchor="ctr" anchorCtr="0">
          <a:noAutofit/>
        </a:bodyPr>
        <a:lstStyle/>
        <a:p>
          <a:pPr marL="0" lvl="0" indent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800" kern="1200" dirty="0"/>
            <a:t>Intermediate Actions </a:t>
          </a:r>
        </a:p>
      </dsp:txBody>
      <dsp:txXfrm>
        <a:off x="2943811" y="840813"/>
        <a:ext cx="2579970" cy="1010839"/>
      </dsp:txXfrm>
    </dsp:sp>
    <dsp:sp modelId="{139A6F0D-B8EF-4250-8F75-78B939F3583F}">
      <dsp:nvSpPr>
        <dsp:cNvPr id="0" name=""/>
        <dsp:cNvSpPr/>
      </dsp:nvSpPr>
      <dsp:spPr>
        <a:xfrm>
          <a:off x="2943811" y="1851653"/>
          <a:ext cx="2579970" cy="2613239"/>
        </a:xfrm>
        <a:prstGeom prst="rect">
          <a:avLst/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49352" tIns="149352" rIns="199136" bIns="224028" numCol="1" spcCol="1270" anchor="t" anchorCtr="0">
          <a:noAutofit/>
        </a:bodyPr>
        <a:lstStyle/>
        <a:p>
          <a:pPr marL="285750" lvl="1" indent="-285750" algn="l" defTabSz="12446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2800" kern="1200" dirty="0"/>
        </a:p>
        <a:p>
          <a:pPr marL="285750" lvl="1" indent="-285750" algn="l" defTabSz="12446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2800" kern="1200" dirty="0"/>
        </a:p>
        <a:p>
          <a:pPr marL="285750" lvl="1" indent="-285750" algn="l" defTabSz="12446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2800" kern="1200" dirty="0"/>
        </a:p>
        <a:p>
          <a:pPr marL="285750" lvl="1" indent="-285750" algn="l" defTabSz="12446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2800" kern="1200" dirty="0"/>
        </a:p>
        <a:p>
          <a:pPr marL="285750" lvl="1" indent="-285750" algn="l" defTabSz="12446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2800" kern="1200" dirty="0"/>
        </a:p>
      </dsp:txBody>
      <dsp:txXfrm>
        <a:off x="2943811" y="1851653"/>
        <a:ext cx="2579970" cy="2613239"/>
      </dsp:txXfrm>
    </dsp:sp>
    <dsp:sp modelId="{4CEBF87C-734E-4E67-91D9-411F1F25C6A0}">
      <dsp:nvSpPr>
        <dsp:cNvPr id="0" name=""/>
        <dsp:cNvSpPr/>
      </dsp:nvSpPr>
      <dsp:spPr>
        <a:xfrm>
          <a:off x="5884977" y="840813"/>
          <a:ext cx="2579970" cy="1010839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9136" tIns="113792" rIns="199136" bIns="113792" numCol="1" spcCol="1270" anchor="ctr" anchorCtr="0">
          <a:noAutofit/>
        </a:bodyPr>
        <a:lstStyle/>
        <a:p>
          <a:pPr marL="0" lvl="0" indent="0" algn="ctr" defTabSz="12446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800" kern="1200" dirty="0"/>
            <a:t>Weaker Actions </a:t>
          </a:r>
        </a:p>
      </dsp:txBody>
      <dsp:txXfrm>
        <a:off x="5884977" y="840813"/>
        <a:ext cx="2579970" cy="1010839"/>
      </dsp:txXfrm>
    </dsp:sp>
    <dsp:sp modelId="{78045E42-7262-44CC-86BC-4E476A6B926C}">
      <dsp:nvSpPr>
        <dsp:cNvPr id="0" name=""/>
        <dsp:cNvSpPr/>
      </dsp:nvSpPr>
      <dsp:spPr>
        <a:xfrm>
          <a:off x="5884977" y="1851653"/>
          <a:ext cx="2579970" cy="2613239"/>
        </a:xfrm>
        <a:prstGeom prst="rect">
          <a:avLst/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49352" tIns="149352" rIns="199136" bIns="224028" numCol="1" spcCol="1270" anchor="t" anchorCtr="0">
          <a:noAutofit/>
        </a:bodyPr>
        <a:lstStyle/>
        <a:p>
          <a:pPr marL="285750" lvl="1" indent="-285750" algn="l" defTabSz="12446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endParaRPr lang="en-US" sz="2800" kern="1200" dirty="0"/>
        </a:p>
      </dsp:txBody>
      <dsp:txXfrm>
        <a:off x="5884977" y="1851653"/>
        <a:ext cx="2579970" cy="2613239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default">
  <dgm:title val=""/>
  <dgm:desc val=""/>
  <dgm:catLst>
    <dgm:cat type="list" pri="4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6" srcId="0" destId="1" srcOrd="0" destOrd="0"/>
        <dgm:cxn modelId="7" srcId="0" destId="2" srcOrd="1" destOrd="0"/>
        <dgm:cxn modelId="8" srcId="0" destId="3" srcOrd="2" destOrd="0"/>
        <dgm:cxn modelId="9" srcId="0" destId="4" srcOrd="3" destOrd="0"/>
        <dgm:cxn modelId="10" srcId="0" destId="5" srcOrd="4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  <dgm:pt modelId="5"/>
        <dgm:pt modelId="6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  <dgm:cxn modelId="11" srcId="0" destId="5" srcOrd="4" destOrd="0"/>
        <dgm:cxn modelId="12" srcId="0" destId="6" srcOrd="5" destOrd="0"/>
      </dgm:cxnLst>
      <dgm:bg/>
      <dgm:whole/>
    </dgm:dataModel>
  </dgm:clrData>
  <dgm:layoutNode name="diagram">
    <dgm:varLst>
      <dgm:dir/>
      <dgm:resizeHandles val="exact"/>
    </dgm:varLst>
    <dgm:choose name="Name0">
      <dgm:if name="Name1" func="var" arg="dir" op="equ" val="norm">
        <dgm:alg type="snake">
          <dgm:param type="grDir" val="tL"/>
          <dgm:param type="flowDir" val="row"/>
          <dgm:param type="contDir" val="sameDir"/>
          <dgm:param type="off" val="ctr"/>
        </dgm:alg>
      </dgm:if>
      <dgm:else name="Name2">
        <dgm:alg type="snake">
          <dgm:param type="grDir" val="tR"/>
          <dgm:param type="flowDir" val="row"/>
          <dgm:param type="contDir" val="sameDir"/>
          <dgm:param type="off" val="ct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node" refType="w"/>
      <dgm:constr type="h" for="ch" forName="node" refType="w" refFor="ch" refForName="node" fact="0.6"/>
      <dgm:constr type="w" for="ch" forName="sibTrans" refType="w" refFor="ch" refForName="node" fact="0.1"/>
      <dgm:constr type="sp" refType="w" refFor="ch" refForName="sibTrans"/>
      <dgm:constr type="primFontSz" for="ch" forName="node" op="equ" val="65"/>
    </dgm:constrLst>
    <dgm:ruleLst/>
    <dgm:forEach name="Name3" axis="ch" ptType="node">
      <dgm:layoutNode name="node">
        <dgm:varLst>
          <dgm:bulletEnabled val="1"/>
        </dgm:varLst>
        <dgm:alg type="tx"/>
        <dgm:shape xmlns:r="http://schemas.openxmlformats.org/officeDocument/2006/relationships" type="rect" r:blip="">
          <dgm:adjLst/>
        </dgm:shape>
        <dgm:presOf axis="desOrSelf" ptType="node"/>
        <dgm:constrLst>
          <dgm:constr type="lMarg" refType="primFontSz" fact="0.3"/>
          <dgm:constr type="rMarg" refType="primFontSz" fact="0.3"/>
          <dgm:constr type="tMarg" refType="primFontSz" fact="0.3"/>
          <dgm:constr type="bMarg" refType="primFontSz" fact="0.3"/>
        </dgm:constrLst>
        <dgm:ruleLst>
          <dgm:rule type="primFontSz" val="5" fact="NaN" max="NaN"/>
        </dgm:ruleLst>
      </dgm:layoutNode>
      <dgm:forEach name="Name4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hList1">
  <dgm:title val=""/>
  <dgm:desc val=""/>
  <dgm:catLst>
    <dgm:cat type="list" pri="5000"/>
    <dgm:cat type="convert" pri="5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>
          <dgm:prSet phldr="1"/>
        </dgm:pt>
        <dgm:pt modelId="2">
          <dgm:prSet phldr="1"/>
        </dgm:pt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  <dgm:pt modelId="4">
          <dgm:prSet phldr="1"/>
        </dgm:pt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h" for="ch" forName="composite" refType="h"/>
      <dgm:constr type="w" for="ch" forName="composite" refType="w"/>
      <dgm:constr type="w" for="des" forName="parTx"/>
      <dgm:constr type="h" for="des" forName="parTx" op="equ"/>
      <dgm:constr type="w" for="des" forName="desTx"/>
      <dgm:constr type="h" for="des" forName="desTx" op="equ"/>
      <dgm:constr type="primFontSz" for="des" forName="parTx" val="65"/>
      <dgm:constr type="secFontSz" for="des" forName="desTx" refType="primFontSz" refFor="des" refForName="parTx" op="equ"/>
      <dgm:constr type="h" for="des" forName="parTx" refType="primFontSz" refFor="des" refForName="parTx" fact="0.8"/>
      <dgm:constr type="h" for="des" forName="desTx" refType="primFontSz" refFor="des" refForName="parTx" fact="1.22"/>
      <dgm:constr type="w" for="ch" forName="space" refType="w" refFor="ch" refForName="composite" op="equ" fact="0.14"/>
    </dgm:constrLst>
    <dgm:ruleLst>
      <dgm:rule type="w" for="ch" forName="composite" val="0" fact="NaN" max="NaN"/>
      <dgm:rule type="primFontSz" for="des" forName="parTx" val="5" fact="NaN" max="NaN"/>
    </dgm:ruleLst>
    <dgm:forEach name="Name4" axis="ch" ptType="node">
      <dgm:layoutNode name="composite">
        <dgm:alg type="composite"/>
        <dgm:shape xmlns:r="http://schemas.openxmlformats.org/officeDocument/2006/relationships" r:blip="">
          <dgm:adjLst/>
        </dgm:shape>
        <dgm:presOf/>
        <dgm:constrLst>
          <dgm:constr type="l" for="ch" forName="parTx"/>
          <dgm:constr type="w" for="ch" forName="parTx" refType="w"/>
          <dgm:constr type="t" for="ch" forName="parTx"/>
          <dgm:constr type="l" for="ch" forName="desTx"/>
          <dgm:constr type="w" for="ch" forName="desTx" refType="w" refFor="ch" refForName="parTx"/>
          <dgm:constr type="t" for="ch" forName="desTx" refType="h" refFor="ch" refForName="parTx"/>
        </dgm:constrLst>
        <dgm:ruleLst>
          <dgm:rule type="h" val="INF" fact="NaN" max="NaN"/>
        </dgm:ruleLst>
        <dgm:layoutNode name="parTx" styleLbl="alignNode1">
          <dgm:varLst>
            <dgm:chMax val="0"/>
            <dgm:chPref val="0"/>
            <dgm:bulletEnabled val="1"/>
          </dgm:varLst>
          <dgm:alg type="tx"/>
          <dgm:shape xmlns:r="http://schemas.openxmlformats.org/officeDocument/2006/relationships" type="rect" r:blip="">
            <dgm:adjLst/>
          </dgm:shape>
          <dgm:presOf axis="self" ptType="node"/>
          <dgm:constrLst>
            <dgm:constr type="h" refType="w" op="lte" fact="0.4"/>
            <dgm:constr type="h"/>
            <dgm:constr type="tMarg" refType="primFontSz" fact="0.32"/>
            <dgm:constr type="bMarg" refType="primFontSz" fact="0.32"/>
          </dgm:constrLst>
          <dgm:ruleLst>
            <dgm:rule type="h" val="INF" fact="NaN" max="NaN"/>
          </dgm:ruleLst>
        </dgm:layoutNode>
        <dgm:layoutNode name="desTx" styleLbl="alignAccFollowNode1">
          <dgm:varLst>
            <dgm:bulletEnabled val="1"/>
          </dgm:varLst>
          <dgm:alg type="tx">
            <dgm:param type="stBulletLvl" val="1"/>
          </dgm:alg>
          <dgm:shape xmlns:r="http://schemas.openxmlformats.org/officeDocument/2006/relationships" type="rect" r:blip="">
            <dgm:adjLst/>
          </dgm:shape>
          <dgm:presOf axis="des" ptType="node"/>
          <dgm:constrLst>
            <dgm:constr type="secFontSz" val="65"/>
            <dgm:constr type="primFontSz" refType="secFontSz"/>
            <dgm:constr type="h"/>
            <dgm:constr type="lMarg" refType="primFontSz" fact="0.42"/>
            <dgm:constr type="tMarg" refType="primFontSz" fact="0.42"/>
            <dgm:constr type="bMarg" refType="primFontSz" fact="0.63"/>
          </dgm:constrLst>
          <dgm:ruleLst>
            <dgm:rule type="h" val="INF" fact="NaN" max="NaN"/>
          </dgm:ruleLst>
        </dgm:layoutNode>
      </dgm:layoutNode>
      <dgm:forEach name="Name5" axis="followSib" ptType="sibTrans" cnt="1">
        <dgm:layoutNode name="space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50DE40-7AA6-4FD7-966C-A7D4AD55BA3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E72882-B248-4F8D-B32E-17072BECBA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77958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E72882-B248-4F8D-B32E-17072BECBAE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870554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E72882-B248-4F8D-B32E-17072BECBAE7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2285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Draw.io is a free online website that helps to make flowchart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E72882-B248-4F8D-B32E-17072BECBAE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256398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an also use draw.io to make your process map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E72882-B248-4F8D-B32E-17072BECBAE7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8408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43B9B-87D0-4380-A962-F69BD125AC41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55472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MART statement (specific / measurable / achievable / relevant / time-boun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E72882-B248-4F8D-B32E-17072BECBAE7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26517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E72882-B248-4F8D-B32E-17072BECBAE7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8056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E72882-B248-4F8D-B32E-17072BECBAE7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373770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E72882-B248-4F8D-B32E-17072BECBAE7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60381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2C97F3-8926-4DBA-9D8F-1B52339352FB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1514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A14BE-73FD-4950-B3F6-6C849E23FB1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01A7F-1C30-4CFC-AA31-A5A516924B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77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A14BE-73FD-4950-B3F6-6C849E23FB1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01A7F-1C30-4CFC-AA31-A5A516924B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280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A14BE-73FD-4950-B3F6-6C849E23FB1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01A7F-1C30-4CFC-AA31-A5A516924B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7777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A14BE-73FD-4950-B3F6-6C849E23FB1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01A7F-1C30-4CFC-AA31-A5A516924B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549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A14BE-73FD-4950-B3F6-6C849E23FB1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01A7F-1C30-4CFC-AA31-A5A516924B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0411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A14BE-73FD-4950-B3F6-6C849E23FB1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01A7F-1C30-4CFC-AA31-A5A516924B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03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A14BE-73FD-4950-B3F6-6C849E23FB1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01A7F-1C30-4CFC-AA31-A5A516924B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572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A14BE-73FD-4950-B3F6-6C849E23FB1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01A7F-1C30-4CFC-AA31-A5A516924B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042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A14BE-73FD-4950-B3F6-6C849E23FB1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01A7F-1C30-4CFC-AA31-A5A516924B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8503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A14BE-73FD-4950-B3F6-6C849E23FB1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01A7F-1C30-4CFC-AA31-A5A516924B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3335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A14BE-73FD-4950-B3F6-6C849E23FB1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E01A7F-1C30-4CFC-AA31-A5A516924B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896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A14BE-73FD-4950-B3F6-6C849E23FB14}" type="datetimeFigureOut">
              <a:rPr lang="en-US" smtClean="0"/>
              <a:t>12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E01A7F-1C30-4CFC-AA31-A5A516924B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592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9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4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2.xml"/><Relationship Id="rId2" Type="http://schemas.openxmlformats.org/officeDocument/2006/relationships/diagramData" Target="../diagrams/data2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2.xml"/><Relationship Id="rId5" Type="http://schemas.openxmlformats.org/officeDocument/2006/relationships/diagramColors" Target="../diagrams/colors2.xml"/><Relationship Id="rId4" Type="http://schemas.openxmlformats.org/officeDocument/2006/relationships/diagramQuickStyle" Target="../diagrams/quickStyle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9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BCFE67-9421-48DE-A489-F9101ABE6234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br>
              <a:rPr lang="en-US" dirty="0"/>
            </a:br>
            <a:r>
              <a:rPr lang="en-US" dirty="0"/>
              <a:t>Quality Improvement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1826B1C-68F3-4E6D-A865-BC32F1066801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Resident Workbook</a:t>
            </a:r>
          </a:p>
          <a:p>
            <a:r>
              <a:rPr lang="en-US" dirty="0"/>
              <a:t>Name:</a:t>
            </a:r>
          </a:p>
          <a:p>
            <a:r>
              <a:rPr lang="en-US" dirty="0"/>
              <a:t>Mentor: </a:t>
            </a:r>
          </a:p>
        </p:txBody>
      </p:sp>
    </p:spTree>
    <p:extLst>
      <p:ext uri="{BB962C8B-B14F-4D97-AF65-F5344CB8AC3E}">
        <p14:creationId xmlns:p14="http://schemas.microsoft.com/office/powerpoint/2010/main" val="180594901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1443" y="186254"/>
            <a:ext cx="8204521" cy="1056384"/>
          </a:xfrm>
        </p:spPr>
        <p:txBody>
          <a:bodyPr/>
          <a:lstStyle/>
          <a:p>
            <a:r>
              <a:rPr lang="en-US" sz="4000" dirty="0"/>
              <a:t>3. Fishbone Diagram</a:t>
            </a:r>
          </a:p>
        </p:txBody>
      </p:sp>
      <p:cxnSp>
        <p:nvCxnSpPr>
          <p:cNvPr id="4" name="Straight Arrow Connector 3"/>
          <p:cNvCxnSpPr>
            <a:cxnSpLocks/>
          </p:cNvCxnSpPr>
          <p:nvPr/>
        </p:nvCxnSpPr>
        <p:spPr>
          <a:xfrm>
            <a:off x="1931502" y="3778685"/>
            <a:ext cx="5128596" cy="5191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 flipH="1">
            <a:off x="1223934" y="3778684"/>
            <a:ext cx="859971" cy="220009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940903" y="1553052"/>
            <a:ext cx="1143000" cy="222563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 flipH="1">
            <a:off x="4876800" y="3810000"/>
            <a:ext cx="791268" cy="2181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4519581" y="1436645"/>
            <a:ext cx="1126672" cy="23420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85800" y="6096002"/>
            <a:ext cx="1708386" cy="3388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Equipment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495800" y="6096000"/>
            <a:ext cx="17050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Methods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114800" y="1143000"/>
            <a:ext cx="15532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Environment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11736" y="1199973"/>
            <a:ext cx="20907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People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209485" y="1524002"/>
            <a:ext cx="321191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/>
              <a:buChar char="•"/>
            </a:pPr>
            <a:r>
              <a:rPr lang="en-US" dirty="0"/>
              <a:t>Write root cause here</a:t>
            </a:r>
          </a:p>
          <a:p>
            <a:pPr marL="171450" indent="-171450">
              <a:buFont typeface="Arial"/>
              <a:buChar char="•"/>
            </a:pPr>
            <a:endParaRPr lang="en-US" dirty="0"/>
          </a:p>
          <a:p>
            <a:pPr marL="171450" indent="-171450">
              <a:buFont typeface="Arial"/>
              <a:buChar char="•"/>
            </a:pPr>
            <a:endParaRPr lang="en-US" dirty="0"/>
          </a:p>
          <a:p>
            <a:endParaRPr lang="en-US" dirty="0"/>
          </a:p>
        </p:txBody>
      </p:sp>
      <p:cxnSp>
        <p:nvCxnSpPr>
          <p:cNvPr id="19" name="Straight Connector 18"/>
          <p:cNvCxnSpPr/>
          <p:nvPr/>
        </p:nvCxnSpPr>
        <p:spPr>
          <a:xfrm>
            <a:off x="991587" y="1657122"/>
            <a:ext cx="401433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Oval 29"/>
          <p:cNvSpPr/>
          <p:nvPr/>
        </p:nvSpPr>
        <p:spPr>
          <a:xfrm>
            <a:off x="7162800" y="2819400"/>
            <a:ext cx="1981200" cy="198120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3" name="Straight Connector 32"/>
          <p:cNvCxnSpPr/>
          <p:nvPr/>
        </p:nvCxnSpPr>
        <p:spPr>
          <a:xfrm>
            <a:off x="5008769" y="5638802"/>
            <a:ext cx="401433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5638800" y="3886202"/>
            <a:ext cx="137097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/>
              <a:buChar char="•"/>
            </a:pPr>
            <a:r>
              <a:rPr lang="en-US" dirty="0"/>
              <a:t>Write root cause here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600200" y="1524001"/>
            <a:ext cx="304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/>
              <a:buChar char="•"/>
            </a:pPr>
            <a:r>
              <a:rPr lang="en-US" dirty="0"/>
              <a:t>Write root cause here</a:t>
            </a:r>
          </a:p>
        </p:txBody>
      </p:sp>
      <p:cxnSp>
        <p:nvCxnSpPr>
          <p:cNvPr id="43" name="Straight Connector 42"/>
          <p:cNvCxnSpPr/>
          <p:nvPr/>
        </p:nvCxnSpPr>
        <p:spPr>
          <a:xfrm>
            <a:off x="4630451" y="1679144"/>
            <a:ext cx="401433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>
            <a:off x="1371602" y="5562602"/>
            <a:ext cx="401433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7315202" y="3563036"/>
            <a:ext cx="18287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rite problem here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969689" y="3810001"/>
            <a:ext cx="184031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/>
              <a:buChar char="•"/>
            </a:pPr>
            <a:r>
              <a:rPr lang="en-US" dirty="0"/>
              <a:t>Write root cause here</a:t>
            </a:r>
          </a:p>
          <a:p>
            <a:endParaRPr lang="en-US" dirty="0"/>
          </a:p>
        </p:txBody>
      </p:sp>
      <p:cxnSp>
        <p:nvCxnSpPr>
          <p:cNvPr id="22" name="Straight Connector 21"/>
          <p:cNvCxnSpPr/>
          <p:nvPr/>
        </p:nvCxnSpPr>
        <p:spPr>
          <a:xfrm flipH="1">
            <a:off x="3124200" y="3810000"/>
            <a:ext cx="791268" cy="218102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3276602" y="5638802"/>
            <a:ext cx="401433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3810000" y="3886202"/>
            <a:ext cx="17050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74320" indent="-285750">
              <a:buFont typeface="Arial"/>
              <a:buChar char="•"/>
            </a:pPr>
            <a:r>
              <a:rPr lang="en-US" dirty="0"/>
              <a:t>Write root cause here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624798" y="6096000"/>
            <a:ext cx="17050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Materials</a:t>
            </a:r>
          </a:p>
        </p:txBody>
      </p:sp>
    </p:spTree>
    <p:extLst>
      <p:ext uri="{BB962C8B-B14F-4D97-AF65-F5344CB8AC3E}">
        <p14:creationId xmlns:p14="http://schemas.microsoft.com/office/powerpoint/2010/main" val="287941909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2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EF7991-A039-4D47-B6E7-D336858B65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3. Make a fishbone diagra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C907D5-8802-42FA-8CF5-5DB1A00A8F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b="1" dirty="0"/>
              <a:t>What information do you need?</a:t>
            </a:r>
          </a:p>
          <a:p>
            <a:pPr lvl="1"/>
            <a:r>
              <a:rPr lang="en-US" dirty="0"/>
              <a:t>Who do you need to interview?</a:t>
            </a:r>
          </a:p>
          <a:p>
            <a:pPr lvl="1"/>
            <a:r>
              <a:rPr lang="en-US" dirty="0"/>
              <a:t>Where do you need to perform a </a:t>
            </a:r>
            <a:r>
              <a:rPr lang="en-US" dirty="0" err="1"/>
              <a:t>gemba</a:t>
            </a:r>
            <a:r>
              <a:rPr lang="en-US" dirty="0"/>
              <a:t> walk?</a:t>
            </a:r>
          </a:p>
          <a:p>
            <a:pPr lvl="1"/>
            <a:r>
              <a:rPr lang="en-US" dirty="0"/>
              <a:t>Which processes do you need to understand better?</a:t>
            </a:r>
          </a:p>
        </p:txBody>
      </p:sp>
    </p:spTree>
    <p:extLst>
      <p:ext uri="{BB962C8B-B14F-4D97-AF65-F5344CB8AC3E}">
        <p14:creationId xmlns:p14="http://schemas.microsoft.com/office/powerpoint/2010/main" val="245308982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381E50-9BF1-401B-9650-71E965C979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4. Write an aim statement 	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59872E-C6F3-470B-AEF1-339AEE629E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62579" y="1609725"/>
            <a:ext cx="7767021" cy="4220920"/>
          </a:xfrm>
        </p:spPr>
        <p:txBody>
          <a:bodyPr>
            <a:normAutofit lnSpcReduction="10000"/>
          </a:bodyPr>
          <a:lstStyle/>
          <a:p>
            <a:r>
              <a:rPr lang="en-US" b="1" dirty="0"/>
              <a:t>What?</a:t>
            </a:r>
            <a:r>
              <a:rPr lang="en-US" dirty="0"/>
              <a:t> What’s the problem or opportunity? Make sure it relates to a fundamental patient need</a:t>
            </a:r>
          </a:p>
          <a:p>
            <a:r>
              <a:rPr lang="en-US" b="1" dirty="0"/>
              <a:t>How much? </a:t>
            </a:r>
            <a:r>
              <a:rPr lang="en-US" dirty="0"/>
              <a:t>How much will you improve? </a:t>
            </a:r>
          </a:p>
          <a:p>
            <a:r>
              <a:rPr lang="en-US" b="1" dirty="0"/>
              <a:t>By when? </a:t>
            </a:r>
            <a:r>
              <a:rPr lang="en-US" dirty="0"/>
              <a:t>What is the date by which you will achieve the level of improvement you’ve set out to accomplish?</a:t>
            </a:r>
          </a:p>
          <a:p>
            <a:r>
              <a:rPr lang="en-US" b="1" dirty="0"/>
              <a:t>For whom? </a:t>
            </a:r>
            <a:r>
              <a:rPr lang="en-US" dirty="0"/>
              <a:t>Who is the population who will benefit from the improvement? </a:t>
            </a:r>
          </a:p>
          <a:p>
            <a:r>
              <a:rPr lang="en-US" b="1" dirty="0"/>
              <a:t>Where? </a:t>
            </a:r>
            <a:r>
              <a:rPr lang="en-US" dirty="0"/>
              <a:t>What are the boundaries of the process or system?</a:t>
            </a:r>
          </a:p>
        </p:txBody>
      </p:sp>
    </p:spTree>
    <p:extLst>
      <p:ext uri="{BB962C8B-B14F-4D97-AF65-F5344CB8AC3E}">
        <p14:creationId xmlns:p14="http://schemas.microsoft.com/office/powerpoint/2010/main" val="154643835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1F4507-F350-4790-AAFD-71A05FAA5B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4. Write an aim statem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A4EF3D-C460-432A-9CB7-76D89FE51D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US" b="1" dirty="0"/>
              <a:t>Answer each of the questions:</a:t>
            </a:r>
          </a:p>
          <a:p>
            <a:pPr lvl="1"/>
            <a:r>
              <a:rPr lang="en-US" dirty="0"/>
              <a:t>What?</a:t>
            </a:r>
          </a:p>
          <a:p>
            <a:pPr lvl="1"/>
            <a:r>
              <a:rPr lang="en-US" dirty="0"/>
              <a:t>How much?</a:t>
            </a:r>
          </a:p>
          <a:p>
            <a:pPr lvl="1"/>
            <a:r>
              <a:rPr lang="en-US" dirty="0"/>
              <a:t>By when?</a:t>
            </a:r>
          </a:p>
          <a:p>
            <a:pPr lvl="1"/>
            <a:r>
              <a:rPr lang="en-US" dirty="0"/>
              <a:t>For whom?</a:t>
            </a:r>
          </a:p>
          <a:p>
            <a:pPr lvl="1"/>
            <a:r>
              <a:rPr lang="en-US" dirty="0"/>
              <a:t>Where?</a:t>
            </a:r>
          </a:p>
          <a:p>
            <a:pPr lvl="1"/>
            <a:endParaRPr lang="en-US" dirty="0"/>
          </a:p>
          <a:p>
            <a:r>
              <a:rPr lang="en-US" b="1" dirty="0"/>
              <a:t>Aim statement example</a:t>
            </a:r>
            <a:r>
              <a:rPr lang="en-US" dirty="0"/>
              <a:t>: By May 20, 2021, we will decrease the number of Firm B ambulatory clinic patients with critical results after hours that are handled by the ED by 90%.</a:t>
            </a:r>
            <a:endParaRPr lang="en-US" b="1" dirty="0"/>
          </a:p>
          <a:p>
            <a:endParaRPr lang="en-US" b="1" dirty="0"/>
          </a:p>
          <a:p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66358739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8B2317-557E-4A07-827F-6E1DCD06FE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4. Aim Statem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F7FD96-9E4D-4349-BA4C-5CB7B9A82B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b="1" dirty="0"/>
              <a:t>Use your answers from the previous slide to write a complete aim statement</a:t>
            </a:r>
            <a:endParaRPr lang="en-US" dirty="0"/>
          </a:p>
          <a:p>
            <a:pPr lvl="1"/>
            <a:r>
              <a:rPr lang="en-US" i="1" dirty="0"/>
              <a:t>Hint</a:t>
            </a:r>
            <a:r>
              <a:rPr lang="en-US" dirty="0"/>
              <a:t>: Start your aim statement with a verb (</a:t>
            </a:r>
            <a:r>
              <a:rPr lang="en-US" dirty="0" err="1"/>
              <a:t>ie</a:t>
            </a:r>
            <a:r>
              <a:rPr lang="en-US" dirty="0"/>
              <a:t>: To eliminate, reduce, increase, </a:t>
            </a:r>
            <a:r>
              <a:rPr lang="en-US" dirty="0" err="1"/>
              <a:t>etc</a:t>
            </a:r>
            <a:r>
              <a:rPr lang="en-US" dirty="0"/>
              <a:t>)</a:t>
            </a:r>
          </a:p>
          <a:p>
            <a:pPr lvl="1"/>
            <a:r>
              <a:rPr lang="en-US" dirty="0"/>
              <a:t>Do not include causes or resolutions </a:t>
            </a:r>
          </a:p>
        </p:txBody>
      </p:sp>
    </p:spTree>
    <p:extLst>
      <p:ext uri="{BB962C8B-B14F-4D97-AF65-F5344CB8AC3E}">
        <p14:creationId xmlns:p14="http://schemas.microsoft.com/office/powerpoint/2010/main" val="87421249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2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DECAA5-3EE8-4F0A-8F50-01720E860A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4. Write an aim statem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5A87C4-191C-496E-A17E-F8AAEC97EA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heck yourself! Is your aim statement:</a:t>
            </a:r>
          </a:p>
          <a:p>
            <a:pPr lvl="1"/>
            <a:r>
              <a:rPr lang="en-US" dirty="0">
                <a:solidFill>
                  <a:srgbClr val="FF0000"/>
                </a:solidFill>
              </a:rPr>
              <a:t>S</a:t>
            </a:r>
            <a:r>
              <a:rPr lang="en-US" dirty="0"/>
              <a:t>pecific</a:t>
            </a:r>
          </a:p>
          <a:p>
            <a:pPr lvl="1"/>
            <a:r>
              <a:rPr lang="en-US" dirty="0">
                <a:solidFill>
                  <a:srgbClr val="FF0000"/>
                </a:solidFill>
              </a:rPr>
              <a:t>M</a:t>
            </a:r>
            <a:r>
              <a:rPr lang="en-US" dirty="0"/>
              <a:t>easurable</a:t>
            </a:r>
          </a:p>
          <a:p>
            <a:pPr lvl="1"/>
            <a:r>
              <a:rPr lang="en-US" dirty="0">
                <a:solidFill>
                  <a:srgbClr val="FF0000"/>
                </a:solidFill>
              </a:rPr>
              <a:t>A</a:t>
            </a:r>
            <a:r>
              <a:rPr lang="en-US" dirty="0"/>
              <a:t>chievable</a:t>
            </a:r>
          </a:p>
          <a:p>
            <a:pPr lvl="1"/>
            <a:r>
              <a:rPr lang="en-US" dirty="0">
                <a:solidFill>
                  <a:srgbClr val="FF0000"/>
                </a:solidFill>
              </a:rPr>
              <a:t>R</a:t>
            </a:r>
            <a:r>
              <a:rPr lang="en-US" dirty="0"/>
              <a:t>elevant</a:t>
            </a:r>
          </a:p>
          <a:p>
            <a:pPr lvl="1"/>
            <a:r>
              <a:rPr lang="en-US" dirty="0">
                <a:solidFill>
                  <a:srgbClr val="FF0000"/>
                </a:solidFill>
              </a:rPr>
              <a:t>T</a:t>
            </a:r>
            <a:r>
              <a:rPr lang="en-US" dirty="0"/>
              <a:t>ime-bound</a:t>
            </a:r>
          </a:p>
          <a:p>
            <a:pPr marL="457200" lvl="1" indent="0">
              <a:buNone/>
            </a:pPr>
            <a:endParaRPr lang="en-US" dirty="0"/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506979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2A191536-20A9-46DA-9B76-EDFE97E678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17856" y="2944090"/>
            <a:ext cx="4036334" cy="2387600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sz="5400" dirty="0"/>
              <a:t>Stop Here</a:t>
            </a:r>
          </a:p>
        </p:txBody>
      </p:sp>
      <p:pic>
        <p:nvPicPr>
          <p:cNvPr id="8" name="Graphic 7" descr="Stop sign">
            <a:extLst>
              <a:ext uri="{FF2B5EF4-FFF2-40B4-BE49-F238E27FC236}">
                <a16:creationId xmlns:a16="http://schemas.microsoft.com/office/drawing/2014/main" id="{7D55107B-1146-411D-B3F0-8F13C8B600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0" y="462334"/>
            <a:ext cx="5465791" cy="54657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299854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118DDA-0AA3-443C-A3C0-D25C9C1788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5. Choosing an intervention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97EEDA-0E99-4C53-937C-D97BD8D801D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51821" y="1825625"/>
            <a:ext cx="8433996" cy="4351338"/>
          </a:xfrm>
        </p:spPr>
        <p:txBody>
          <a:bodyPr>
            <a:normAutofit/>
          </a:bodyPr>
          <a:lstStyle/>
          <a:p>
            <a:r>
              <a:rPr lang="en-US" dirty="0"/>
              <a:t>Pick interventions based on your process map or fishbone diagram</a:t>
            </a:r>
          </a:p>
          <a:p>
            <a:r>
              <a:rPr lang="en-US" dirty="0"/>
              <a:t>Consider targeting one of the 8 wastes (next slide)</a:t>
            </a:r>
          </a:p>
          <a:p>
            <a:r>
              <a:rPr lang="en-US" dirty="0"/>
              <a:t>IHI change concepts can help generate intervention ideas</a:t>
            </a:r>
          </a:p>
          <a:p>
            <a:r>
              <a:rPr lang="en-US" dirty="0"/>
              <a:t>Use the Action Hierarchy to choose stronger interventions Organize potential interventions using the impact/effort grid</a:t>
            </a:r>
          </a:p>
        </p:txBody>
      </p:sp>
    </p:spTree>
    <p:extLst>
      <p:ext uri="{BB962C8B-B14F-4D97-AF65-F5344CB8AC3E}">
        <p14:creationId xmlns:p14="http://schemas.microsoft.com/office/powerpoint/2010/main" val="237750613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81AC9894-436A-4DD7-B09A-80862FFB25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rainstorming Interventions 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7728BC96-295D-4C6A-9BD1-6955248CD9AB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17657613"/>
              </p:ext>
            </p:extLst>
          </p:nvPr>
        </p:nvGraphicFramePr>
        <p:xfrm>
          <a:off x="457200" y="1600202"/>
          <a:ext cx="8229600" cy="452596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139902997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F1BBE3-B09E-4E3C-8CC9-E21900808C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5. Choosing an intervention</a:t>
            </a: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BA327DF6-97F4-4254-A023-A9839F23BA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Brainstorm intervention ideas here:</a:t>
            </a:r>
          </a:p>
        </p:txBody>
      </p:sp>
    </p:spTree>
    <p:extLst>
      <p:ext uri="{BB962C8B-B14F-4D97-AF65-F5344CB8AC3E}">
        <p14:creationId xmlns:p14="http://schemas.microsoft.com/office/powerpoint/2010/main" val="24709006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64C770-6551-4C6E-8216-C58DB160C9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ow to use the workbook	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1B9184-5B0B-4A38-A490-E04F7C26ED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/>
              <a:t>Please go through each of the slides and answer </a:t>
            </a:r>
            <a:r>
              <a:rPr lang="en-US" i="1" dirty="0"/>
              <a:t>all</a:t>
            </a:r>
            <a:r>
              <a:rPr lang="en-US" dirty="0"/>
              <a:t> questions to the best of your ability (You may type your responses into the workbook)</a:t>
            </a:r>
          </a:p>
          <a:p>
            <a:r>
              <a:rPr lang="en-US" dirty="0"/>
              <a:t>The slides in </a:t>
            </a:r>
            <a:r>
              <a:rPr lang="en-US" i="1" dirty="0"/>
              <a:t>orange</a:t>
            </a:r>
            <a:r>
              <a:rPr lang="en-US" dirty="0"/>
              <a:t> are places for you to take note of potential areas where you need to do more investigating</a:t>
            </a:r>
          </a:p>
          <a:p>
            <a:pPr lvl="1"/>
            <a:r>
              <a:rPr lang="en-US" dirty="0"/>
              <a:t>These questions are meant as prompts and may not be applicable to your project</a:t>
            </a:r>
          </a:p>
          <a:p>
            <a:r>
              <a:rPr lang="en-US" dirty="0"/>
              <a:t>By completing the workbook, your QI team will have a draft of a </a:t>
            </a:r>
            <a:r>
              <a:rPr lang="en-US" b="1" dirty="0"/>
              <a:t>problem statement, process map, fishbone diagram, and aim statement</a:t>
            </a:r>
          </a:p>
          <a:p>
            <a:pPr lvl="1"/>
            <a:r>
              <a:rPr lang="en-US" dirty="0"/>
              <a:t>The slides in </a:t>
            </a:r>
            <a:r>
              <a:rPr lang="en-US" i="1" dirty="0"/>
              <a:t>blue </a:t>
            </a:r>
            <a:r>
              <a:rPr lang="en-US" dirty="0"/>
              <a:t>are slides you can use for your work-in-progress presentation. Feel free to provide additional slides!</a:t>
            </a:r>
          </a:p>
          <a:p>
            <a:r>
              <a:rPr lang="en-US" dirty="0"/>
              <a:t>You will be given 1 hour to complete the workbook, and we will review each of the projects as a group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3472600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ECC9D7-A050-4061-9951-CBBB9014FF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5. Intervention Ideas</a:t>
            </a:r>
            <a:br>
              <a:rPr lang="en-US" dirty="0"/>
            </a:br>
            <a:r>
              <a:rPr lang="en-US" sz="2000" dirty="0"/>
              <a:t>Organize your interventions using the Impact/Effort grid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CB15BA40-E47B-4570-BD50-4F3A9799884C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455591651"/>
              </p:ext>
            </p:extLst>
          </p:nvPr>
        </p:nvGraphicFramePr>
        <p:xfrm>
          <a:off x="548640" y="1940454"/>
          <a:ext cx="7966710" cy="4552416"/>
        </p:xfrm>
        <a:graphic>
          <a:graphicData uri="http://schemas.openxmlformats.org/drawingml/2006/table">
            <a:tbl>
              <a:tblPr/>
              <a:tblGrid>
                <a:gridCol w="2655570">
                  <a:extLst>
                    <a:ext uri="{9D8B030D-6E8A-4147-A177-3AD203B41FA5}">
                      <a16:colId xmlns:a16="http://schemas.microsoft.com/office/drawing/2014/main" val="1882428755"/>
                    </a:ext>
                  </a:extLst>
                </a:gridCol>
                <a:gridCol w="2655570">
                  <a:extLst>
                    <a:ext uri="{9D8B030D-6E8A-4147-A177-3AD203B41FA5}">
                      <a16:colId xmlns:a16="http://schemas.microsoft.com/office/drawing/2014/main" val="4009223878"/>
                    </a:ext>
                  </a:extLst>
                </a:gridCol>
                <a:gridCol w="2655570">
                  <a:extLst>
                    <a:ext uri="{9D8B030D-6E8A-4147-A177-3AD203B41FA5}">
                      <a16:colId xmlns:a16="http://schemas.microsoft.com/office/drawing/2014/main" val="1439060953"/>
                    </a:ext>
                  </a:extLst>
                </a:gridCol>
              </a:tblGrid>
              <a:tr h="1517472">
                <a:tc>
                  <a:txBody>
                    <a:bodyPr/>
                    <a:lstStyle/>
                    <a:p>
                      <a:pPr algn="ctr" fontAlgn="auto"/>
                      <a:r>
                        <a:rPr lang="en-US" sz="35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</a:p>
                  </a:txBody>
                  <a:tcPr marL="88690" marR="88690" marT="44345" marB="44345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35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w Effort​</a:t>
                      </a:r>
                      <a:endParaRPr lang="en-US" sz="17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8690" marR="88690" marT="44345" marB="44345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35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gh Effort​</a:t>
                      </a:r>
                      <a:endParaRPr lang="en-US" sz="17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8690" marR="88690" marT="44345" marB="44345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870361"/>
                  </a:ext>
                </a:extLst>
              </a:tr>
              <a:tr h="1517472"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35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igh Impact​</a:t>
                      </a:r>
                      <a:endParaRPr lang="en-US" sz="1700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8690" marR="88690" marT="44345" marB="44345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7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</a:p>
                  </a:txBody>
                  <a:tcPr marL="88690" marR="88690" marT="44345" marB="44345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7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</a:p>
                  </a:txBody>
                  <a:tcPr marL="88690" marR="88690" marT="44345" marB="44345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79163715"/>
                  </a:ext>
                </a:extLst>
              </a:tr>
              <a:tr h="1517472">
                <a:tc>
                  <a:txBody>
                    <a:bodyPr/>
                    <a:lstStyle/>
                    <a:p>
                      <a:pPr algn="ctr" fontAlgn="base"/>
                      <a:r>
                        <a:rPr lang="en-US" sz="35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w Impact​</a:t>
                      </a:r>
                      <a:endParaRPr lang="en-US" sz="1700" b="0" i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88690" marR="88690" marT="44345" marB="44345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70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</a:p>
                  </a:txBody>
                  <a:tcPr marL="88690" marR="88690" marT="44345" marB="44345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70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​</a:t>
                      </a:r>
                    </a:p>
                  </a:txBody>
                  <a:tcPr marL="88690" marR="88690" marT="44345" marB="44345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84822256"/>
                  </a:ext>
                </a:extLst>
              </a:tr>
            </a:tbl>
          </a:graphicData>
        </a:graphic>
      </p:graphicFrame>
      <p:sp>
        <p:nvSpPr>
          <p:cNvPr id="5" name="Rectangle 7">
            <a:extLst>
              <a:ext uri="{FF2B5EF4-FFF2-40B4-BE49-F238E27FC236}">
                <a16:creationId xmlns:a16="http://schemas.microsoft.com/office/drawing/2014/main" id="{5EB70A46-2BB6-477C-ACD6-632167C5BE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-527050" y="1502461"/>
            <a:ext cx="1219200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altLang="en-US"/>
          </a:p>
          <a:p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6007542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B8AC6E-2751-4224-818C-89F30D6689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6. Assign Intervention/Action Hierarchy </a:t>
            </a:r>
          </a:p>
        </p:txBody>
      </p:sp>
      <p:graphicFrame>
        <p:nvGraphicFramePr>
          <p:cNvPr id="7" name="Diagram 6">
            <a:extLst>
              <a:ext uri="{FF2B5EF4-FFF2-40B4-BE49-F238E27FC236}">
                <a16:creationId xmlns:a16="http://schemas.microsoft.com/office/drawing/2014/main" id="{DF79CF7D-0513-4D93-B76B-F19FB5C67E5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820304622"/>
              </p:ext>
            </p:extLst>
          </p:nvPr>
        </p:nvGraphicFramePr>
        <p:xfrm>
          <a:off x="427651" y="1187167"/>
          <a:ext cx="8467594" cy="530570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72560252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2A191536-20A9-46DA-9B76-EDFE97E678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17856" y="2944090"/>
            <a:ext cx="4036334" cy="2387600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sz="5400" dirty="0"/>
              <a:t>Stop Here</a:t>
            </a:r>
          </a:p>
        </p:txBody>
      </p:sp>
      <p:pic>
        <p:nvPicPr>
          <p:cNvPr id="8" name="Graphic 7" descr="Stop sign">
            <a:extLst>
              <a:ext uri="{FF2B5EF4-FFF2-40B4-BE49-F238E27FC236}">
                <a16:creationId xmlns:a16="http://schemas.microsoft.com/office/drawing/2014/main" id="{7D55107B-1146-411D-B3F0-8F13C8B600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-131444" y="494607"/>
            <a:ext cx="5465791" cy="54657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507836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974541-9964-44B2-A33A-F829AC78ED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7. Form Data Collection Pla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05DE93-6709-4A43-84CF-BB34379519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18634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7531B8-E1AC-4298-A96E-6C2F9A30DE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cs typeface="Calibri Light"/>
              </a:rPr>
              <a:t>7. Data Collection plan</a:t>
            </a:r>
            <a:endParaRPr lang="en-US" dirty="0"/>
          </a:p>
        </p:txBody>
      </p:sp>
      <p:graphicFrame>
        <p:nvGraphicFramePr>
          <p:cNvPr id="5" name="Content Placeholder 4">
            <a:extLst>
              <a:ext uri="{FF2B5EF4-FFF2-40B4-BE49-F238E27FC236}">
                <a16:creationId xmlns:a16="http://schemas.microsoft.com/office/drawing/2014/main" id="{4D9B1045-1508-4CB4-953B-46E6DC494CB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53748476"/>
              </p:ext>
            </p:extLst>
          </p:nvPr>
        </p:nvGraphicFramePr>
        <p:xfrm>
          <a:off x="333488" y="2516038"/>
          <a:ext cx="8659905" cy="267116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00885">
                  <a:extLst>
                    <a:ext uri="{9D8B030D-6E8A-4147-A177-3AD203B41FA5}">
                      <a16:colId xmlns:a16="http://schemas.microsoft.com/office/drawing/2014/main" val="928327248"/>
                    </a:ext>
                  </a:extLst>
                </a:gridCol>
                <a:gridCol w="1141100">
                  <a:extLst>
                    <a:ext uri="{9D8B030D-6E8A-4147-A177-3AD203B41FA5}">
                      <a16:colId xmlns:a16="http://schemas.microsoft.com/office/drawing/2014/main" val="777006643"/>
                    </a:ext>
                  </a:extLst>
                </a:gridCol>
                <a:gridCol w="1366221">
                  <a:extLst>
                    <a:ext uri="{9D8B030D-6E8A-4147-A177-3AD203B41FA5}">
                      <a16:colId xmlns:a16="http://schemas.microsoft.com/office/drawing/2014/main" val="951157733"/>
                    </a:ext>
                  </a:extLst>
                </a:gridCol>
                <a:gridCol w="1281388">
                  <a:extLst>
                    <a:ext uri="{9D8B030D-6E8A-4147-A177-3AD203B41FA5}">
                      <a16:colId xmlns:a16="http://schemas.microsoft.com/office/drawing/2014/main" val="183737841"/>
                    </a:ext>
                  </a:extLst>
                </a:gridCol>
                <a:gridCol w="1224920">
                  <a:extLst>
                    <a:ext uri="{9D8B030D-6E8A-4147-A177-3AD203B41FA5}">
                      <a16:colId xmlns:a16="http://schemas.microsoft.com/office/drawing/2014/main" val="1544496959"/>
                    </a:ext>
                  </a:extLst>
                </a:gridCol>
                <a:gridCol w="1205930">
                  <a:extLst>
                    <a:ext uri="{9D8B030D-6E8A-4147-A177-3AD203B41FA5}">
                      <a16:colId xmlns:a16="http://schemas.microsoft.com/office/drawing/2014/main" val="2167398139"/>
                    </a:ext>
                  </a:extLst>
                </a:gridCol>
                <a:gridCol w="1139461">
                  <a:extLst>
                    <a:ext uri="{9D8B030D-6E8A-4147-A177-3AD203B41FA5}">
                      <a16:colId xmlns:a16="http://schemas.microsoft.com/office/drawing/2014/main" val="1766384293"/>
                    </a:ext>
                  </a:extLst>
                </a:gridCol>
              </a:tblGrid>
              <a:tr h="990955">
                <a:tc>
                  <a:txBody>
                    <a:bodyPr/>
                    <a:lstStyle/>
                    <a:p>
                      <a:pPr algn="l" fontAlgn="base"/>
                      <a:r>
                        <a:rPr lang="en-US" sz="1400" dirty="0">
                          <a:effectLst/>
                        </a:rPr>
                        <a:t>Type of Measure​</a:t>
                      </a:r>
                      <a:endParaRPr lang="en-US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400" dirty="0">
                          <a:effectLst/>
                        </a:rPr>
                        <a:t>Measure​</a:t>
                      </a:r>
                      <a:endParaRPr lang="en-US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400" dirty="0">
                          <a:effectLst/>
                        </a:rPr>
                        <a:t>Operational Definition​</a:t>
                      </a:r>
                      <a:endParaRPr lang="en-US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400" dirty="0">
                          <a:effectLst/>
                        </a:rPr>
                        <a:t>Datasource​</a:t>
                      </a:r>
                      <a:endParaRPr lang="en-US" dirty="0">
                        <a:effectLst/>
                      </a:endParaRPr>
                    </a:p>
                    <a:p>
                      <a:pPr algn="l" fontAlgn="base"/>
                      <a:r>
                        <a:rPr lang="en-US" sz="1400" dirty="0">
                          <a:effectLst/>
                        </a:rPr>
                        <a:t>(Where will the data come from?)​</a:t>
                      </a:r>
                      <a:endParaRPr lang="en-US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400" dirty="0">
                          <a:effectLst/>
                        </a:rPr>
                        <a:t>Frequency(How often will it be collected?)​</a:t>
                      </a:r>
                      <a:endParaRPr lang="en-US" dirty="0">
                        <a:effectLst/>
                      </a:endParaRPr>
                    </a:p>
                    <a:p>
                      <a:pPr algn="l" fontAlgn="base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400" dirty="0">
                          <a:effectLst/>
                        </a:rPr>
                        <a:t>Method(How will it be collected)​</a:t>
                      </a:r>
                      <a:endParaRPr lang="en-US" dirty="0">
                        <a:effectLst/>
                      </a:endParaRPr>
                    </a:p>
                    <a:p>
                      <a:pPr algn="l" fontAlgn="base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ase"/>
                      <a:r>
                        <a:rPr lang="en-US" sz="1400" dirty="0">
                          <a:effectLst/>
                        </a:rPr>
                        <a:t>Who will collect the data?​</a:t>
                      </a:r>
                      <a:endParaRPr lang="en-US" b="1" i="0" dirty="0">
                        <a:solidFill>
                          <a:srgbClr val="FFFFFF"/>
                        </a:solidFill>
                        <a:effectLst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70686798"/>
                  </a:ext>
                </a:extLst>
              </a:tr>
              <a:tr h="157779"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Outcome</a:t>
                      </a:r>
                    </a:p>
                    <a:p>
                      <a:pPr algn="l" fontAlgn="auto"/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45871560"/>
                  </a:ext>
                </a:extLst>
              </a:tr>
              <a:tr h="581025"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>
                          <a:effectLst/>
                        </a:rPr>
                        <a:t>​Process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84901275"/>
                  </a:ext>
                </a:extLst>
              </a:tr>
              <a:tr h="581025"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>
                          <a:effectLst/>
                        </a:rPr>
                        <a:t>​Balancing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auto"/>
                      <a:r>
                        <a:rPr lang="en-US" sz="1400" dirty="0">
                          <a:effectLst/>
                        </a:rPr>
                        <a:t>​</a:t>
                      </a:r>
                      <a:endParaRPr lang="en-US" sz="1400" b="0" i="0" dirty="0">
                        <a:solidFill>
                          <a:srgbClr val="000000"/>
                        </a:solidFill>
                        <a:effectLst/>
                        <a:latin typeface="Georgia" panose="02040502050405020303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193709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6DB7B22-95ED-4721-9F72-E9A90D04D1D0}"/>
              </a:ext>
            </a:extLst>
          </p:cNvPr>
          <p:cNvSpPr txBox="1"/>
          <p:nvPr/>
        </p:nvSpPr>
        <p:spPr>
          <a:xfrm>
            <a:off x="628650" y="1549365"/>
            <a:ext cx="2743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b="1" dirty="0"/>
              <a:t>Aim: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08319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BCE94E-4C92-47B4-9966-65BFEC4AD9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1. Write a problem statem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31F109-1BAF-4EFB-879D-8E00C1F529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b="1" dirty="0"/>
              <a:t>First answer each of these questions:</a:t>
            </a:r>
          </a:p>
          <a:p>
            <a:pPr lvl="1"/>
            <a:r>
              <a:rPr lang="en-US" dirty="0"/>
              <a:t>What isn’t working?</a:t>
            </a:r>
          </a:p>
          <a:p>
            <a:pPr lvl="1"/>
            <a:r>
              <a:rPr lang="en-US" dirty="0"/>
              <a:t>When and where?</a:t>
            </a:r>
          </a:p>
          <a:p>
            <a:pPr lvl="1"/>
            <a:r>
              <a:rPr lang="en-US" dirty="0"/>
              <a:t>What’s the magnitude?</a:t>
            </a:r>
          </a:p>
          <a:p>
            <a:pPr lvl="1"/>
            <a:r>
              <a:rPr lang="en-US" dirty="0"/>
              <a:t>What’s the impact?</a:t>
            </a:r>
          </a:p>
          <a:p>
            <a:pPr lvl="1"/>
            <a:r>
              <a:rPr lang="en-US" i="1" dirty="0"/>
              <a:t>Remember</a:t>
            </a:r>
            <a:r>
              <a:rPr lang="en-US" dirty="0"/>
              <a:t>: Never points a finger or contains a solution</a:t>
            </a:r>
          </a:p>
          <a:p>
            <a:pPr lvl="1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1063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EBA709-337B-4344-A4AA-C9D34C97DF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1. Problem Statement	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6BE5B8-83E9-4AD0-80CD-1575CFCB44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b="1" dirty="0"/>
              <a:t>Put your answers from the previous slide together in 1-2 sentences to complete your problem statement here: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530791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2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7983E1-3FE6-4C94-9BC0-10F1DC07DE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1. Write a problem statem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CFCF94-3BA6-41AE-B22D-D5D07D3A0F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b="1" dirty="0"/>
              <a:t>What information do you need?</a:t>
            </a:r>
          </a:p>
          <a:p>
            <a:pPr lvl="1"/>
            <a:r>
              <a:rPr lang="en-US" dirty="0"/>
              <a:t>Which of the questions were you unable to answer?</a:t>
            </a:r>
          </a:p>
          <a:p>
            <a:pPr lvl="1"/>
            <a:r>
              <a:rPr lang="en-US" dirty="0"/>
              <a:t>Do you need to collect more data?</a:t>
            </a:r>
          </a:p>
          <a:p>
            <a:pPr lvl="1"/>
            <a:r>
              <a:rPr lang="en-US" dirty="0"/>
              <a:t>Where should you collect your data?</a:t>
            </a:r>
          </a:p>
          <a:p>
            <a:pPr lvl="1"/>
            <a:r>
              <a:rPr lang="en-US" dirty="0"/>
              <a:t>Who do you need help from?</a:t>
            </a:r>
          </a:p>
        </p:txBody>
      </p:sp>
    </p:spTree>
    <p:extLst>
      <p:ext uri="{BB962C8B-B14F-4D97-AF65-F5344CB8AC3E}">
        <p14:creationId xmlns:p14="http://schemas.microsoft.com/office/powerpoint/2010/main" val="24030520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41A195-AE29-4CBF-95E5-9FC1CE33AE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86094" y="311860"/>
            <a:ext cx="8645934" cy="1460500"/>
          </a:xfrm>
        </p:spPr>
        <p:txBody>
          <a:bodyPr/>
          <a:lstStyle/>
          <a:p>
            <a:r>
              <a:rPr lang="en-US" dirty="0"/>
              <a:t>2. Make a process map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7FC2F0-E573-4E11-A227-A642A01509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2400" b="1" dirty="0"/>
              <a:t>Process Map</a:t>
            </a:r>
            <a:r>
              <a:rPr lang="en-US" sz="2400" dirty="0"/>
              <a:t>: A graphical depiction of key processes </a:t>
            </a:r>
          </a:p>
          <a:p>
            <a:r>
              <a:rPr lang="en-US" sz="2400" dirty="0"/>
              <a:t>What the process </a:t>
            </a:r>
            <a:r>
              <a:rPr lang="en-US" sz="2400" i="1" dirty="0"/>
              <a:t>currently</a:t>
            </a:r>
            <a:r>
              <a:rPr lang="en-US" sz="2400" dirty="0"/>
              <a:t> looks like, not what it </a:t>
            </a:r>
            <a:r>
              <a:rPr lang="en-US" sz="2400" i="1" dirty="0"/>
              <a:t>should</a:t>
            </a:r>
            <a:r>
              <a:rPr lang="en-US" sz="2400" dirty="0"/>
              <a:t> be</a:t>
            </a:r>
          </a:p>
          <a:p>
            <a:pPr marL="457200" indent="-457200"/>
            <a:r>
              <a:rPr lang="en-US" sz="2400" dirty="0"/>
              <a:t>Types:</a:t>
            </a:r>
          </a:p>
          <a:p>
            <a:pPr marL="857250" lvl="1" indent="-457200"/>
            <a:r>
              <a:rPr lang="en-US" dirty="0"/>
              <a:t>Simple flow chart</a:t>
            </a:r>
          </a:p>
          <a:p>
            <a:pPr marL="857250" lvl="1" indent="-457200"/>
            <a:r>
              <a:rPr lang="en-US" dirty="0"/>
              <a:t>Swim lanes </a:t>
            </a:r>
          </a:p>
          <a:p>
            <a:pPr marL="602763" indent="-457200"/>
            <a:r>
              <a:rPr lang="en-US" sz="2682" dirty="0"/>
              <a:t>Key:</a:t>
            </a:r>
          </a:p>
          <a:p>
            <a:endParaRPr lang="en-US" dirty="0"/>
          </a:p>
        </p:txBody>
      </p:sp>
      <p:sp>
        <p:nvSpPr>
          <p:cNvPr id="6" name="Flowchart: Connector 5">
            <a:extLst>
              <a:ext uri="{FF2B5EF4-FFF2-40B4-BE49-F238E27FC236}">
                <a16:creationId xmlns:a16="http://schemas.microsoft.com/office/drawing/2014/main" id="{EA2AC3E8-ABA5-4CFB-AD88-41D0F439CA4D}"/>
              </a:ext>
            </a:extLst>
          </p:cNvPr>
          <p:cNvSpPr/>
          <p:nvPr/>
        </p:nvSpPr>
        <p:spPr bwMode="auto">
          <a:xfrm>
            <a:off x="540914" y="4793235"/>
            <a:ext cx="1402669" cy="1330463"/>
          </a:xfrm>
          <a:prstGeom prst="flowChartConnector">
            <a:avLst/>
          </a:prstGeom>
          <a:solidFill>
            <a:schemeClr val="accent1"/>
          </a:solidFill>
          <a:ln w="254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endParaRPr lang="en-US" sz="5800">
              <a:solidFill>
                <a:srgbClr val="000000"/>
              </a:solidFill>
              <a:latin typeface="Gill Sans" charset="0"/>
              <a:ea typeface="ヒラギノ角ゴ ProN W3" charset="0"/>
              <a:cs typeface="ヒラギノ角ゴ ProN W3" charset="0"/>
              <a:sym typeface="Gill Sans" charset="0"/>
            </a:endParaRPr>
          </a:p>
        </p:txBody>
      </p:sp>
      <p:sp>
        <p:nvSpPr>
          <p:cNvPr id="7" name="Flowchart: Process 6">
            <a:extLst>
              <a:ext uri="{FF2B5EF4-FFF2-40B4-BE49-F238E27FC236}">
                <a16:creationId xmlns:a16="http://schemas.microsoft.com/office/drawing/2014/main" id="{EE59F035-AACF-4D6F-8891-98048144DC1D}"/>
              </a:ext>
            </a:extLst>
          </p:cNvPr>
          <p:cNvSpPr/>
          <p:nvPr/>
        </p:nvSpPr>
        <p:spPr bwMode="auto">
          <a:xfrm>
            <a:off x="2566861" y="4781752"/>
            <a:ext cx="1347395" cy="1330462"/>
          </a:xfrm>
          <a:prstGeom prst="flowChartProcess">
            <a:avLst/>
          </a:prstGeom>
          <a:solidFill>
            <a:schemeClr val="accent1"/>
          </a:solidFill>
          <a:ln w="254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endParaRPr lang="en-US" sz="5800">
              <a:solidFill>
                <a:srgbClr val="000000"/>
              </a:solidFill>
              <a:latin typeface="Gill Sans" charset="0"/>
              <a:ea typeface="ヒラギノ角ゴ ProN W3" charset="0"/>
              <a:cs typeface="ヒラギノ角ゴ ProN W3" charset="0"/>
              <a:sym typeface="Gill Sans" charset="0"/>
            </a:endParaRPr>
          </a:p>
        </p:txBody>
      </p:sp>
      <p:sp>
        <p:nvSpPr>
          <p:cNvPr id="8" name="Diamond 7">
            <a:extLst>
              <a:ext uri="{FF2B5EF4-FFF2-40B4-BE49-F238E27FC236}">
                <a16:creationId xmlns:a16="http://schemas.microsoft.com/office/drawing/2014/main" id="{F82C1AC3-D7FC-4969-9071-2FB9B3DBE591}"/>
              </a:ext>
            </a:extLst>
          </p:cNvPr>
          <p:cNvSpPr/>
          <p:nvPr/>
        </p:nvSpPr>
        <p:spPr bwMode="auto">
          <a:xfrm>
            <a:off x="4610025" y="4785325"/>
            <a:ext cx="1591683" cy="1388375"/>
          </a:xfrm>
          <a:prstGeom prst="diamond">
            <a:avLst/>
          </a:prstGeom>
          <a:solidFill>
            <a:schemeClr val="accent1"/>
          </a:solidFill>
          <a:ln w="254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endParaRPr lang="en-US" sz="5800">
              <a:solidFill>
                <a:srgbClr val="000000"/>
              </a:solidFill>
              <a:latin typeface="Gill Sans" charset="0"/>
              <a:ea typeface="ヒラギノ角ゴ ProN W3" charset="0"/>
              <a:cs typeface="ヒラギノ角ゴ ProN W3" charset="0"/>
              <a:sym typeface="Gill Sans" charset="0"/>
            </a:endParaRPr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AD5F2C0D-FF7C-49BF-B3A8-C7E6BCFD581F}"/>
              </a:ext>
            </a:extLst>
          </p:cNvPr>
          <p:cNvSpPr/>
          <p:nvPr/>
        </p:nvSpPr>
        <p:spPr bwMode="auto">
          <a:xfrm>
            <a:off x="6807443" y="5184289"/>
            <a:ext cx="1772529" cy="432526"/>
          </a:xfrm>
          <a:prstGeom prst="rightArrow">
            <a:avLst/>
          </a:prstGeom>
          <a:solidFill>
            <a:schemeClr val="accent1"/>
          </a:solidFill>
          <a:ln w="254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endParaRPr lang="en-US" sz="5800">
              <a:solidFill>
                <a:srgbClr val="000000"/>
              </a:solidFill>
              <a:latin typeface="Gill Sans" charset="0"/>
              <a:ea typeface="ヒラギノ角ゴ ProN W3" charset="0"/>
              <a:cs typeface="ヒラギノ角ゴ ProN W3" charset="0"/>
              <a:sym typeface="Gill Sans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D0ADEC-B0E3-433B-9A9E-E0A372E48EE5}"/>
              </a:ext>
            </a:extLst>
          </p:cNvPr>
          <p:cNvSpPr txBox="1"/>
          <p:nvPr/>
        </p:nvSpPr>
        <p:spPr>
          <a:xfrm>
            <a:off x="769171" y="5152053"/>
            <a:ext cx="86284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+mj-lt"/>
              </a:rPr>
              <a:t>Start/</a:t>
            </a:r>
          </a:p>
          <a:p>
            <a:r>
              <a:rPr lang="en-US" sz="1600" dirty="0">
                <a:latin typeface="+mj-lt"/>
              </a:rPr>
              <a:t>En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184B9C0-4D55-4A16-9BFA-4C869550CAFA}"/>
              </a:ext>
            </a:extLst>
          </p:cNvPr>
          <p:cNvSpPr txBox="1"/>
          <p:nvPr/>
        </p:nvSpPr>
        <p:spPr>
          <a:xfrm>
            <a:off x="2771412" y="5231275"/>
            <a:ext cx="862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+mj-lt"/>
              </a:rPr>
              <a:t>Task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4D899EB-1A69-4417-B054-6C31077D8485}"/>
              </a:ext>
            </a:extLst>
          </p:cNvPr>
          <p:cNvSpPr txBox="1"/>
          <p:nvPr/>
        </p:nvSpPr>
        <p:spPr>
          <a:xfrm>
            <a:off x="4925786" y="5108165"/>
            <a:ext cx="103621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+mj-lt"/>
              </a:rPr>
              <a:t>Review/</a:t>
            </a:r>
          </a:p>
          <a:p>
            <a:r>
              <a:rPr lang="en-US" sz="1600" dirty="0">
                <a:latin typeface="+mj-lt"/>
              </a:rPr>
              <a:t>Decisio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D9C22F6-9F04-4CC6-BEF5-010550D9B7DE}"/>
              </a:ext>
            </a:extLst>
          </p:cNvPr>
          <p:cNvSpPr txBox="1"/>
          <p:nvPr/>
        </p:nvSpPr>
        <p:spPr>
          <a:xfrm>
            <a:off x="7075438" y="5231275"/>
            <a:ext cx="11953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+mj-lt"/>
              </a:rPr>
              <a:t>Direction</a:t>
            </a:r>
          </a:p>
        </p:txBody>
      </p:sp>
    </p:spTree>
    <p:extLst>
      <p:ext uri="{BB962C8B-B14F-4D97-AF65-F5344CB8AC3E}">
        <p14:creationId xmlns:p14="http://schemas.microsoft.com/office/powerpoint/2010/main" val="40852075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892D2F56-1EA5-4810-ACE3-34AEFF122D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0722" y="388629"/>
            <a:ext cx="10515600" cy="949325"/>
          </a:xfrm>
        </p:spPr>
        <p:txBody>
          <a:bodyPr/>
          <a:lstStyle/>
          <a:p>
            <a:r>
              <a:rPr lang="en-US" dirty="0"/>
              <a:t>2. Process Map</a:t>
            </a:r>
          </a:p>
        </p:txBody>
      </p:sp>
      <p:sp>
        <p:nvSpPr>
          <p:cNvPr id="3" name="Flowchart: Connector 2">
            <a:extLst>
              <a:ext uri="{FF2B5EF4-FFF2-40B4-BE49-F238E27FC236}">
                <a16:creationId xmlns:a16="http://schemas.microsoft.com/office/drawing/2014/main" id="{4BED164F-5C7F-4196-B3D0-AA9D8FF5F0F8}"/>
              </a:ext>
            </a:extLst>
          </p:cNvPr>
          <p:cNvSpPr/>
          <p:nvPr/>
        </p:nvSpPr>
        <p:spPr bwMode="auto">
          <a:xfrm>
            <a:off x="387186" y="1667076"/>
            <a:ext cx="1402669" cy="1330463"/>
          </a:xfrm>
          <a:prstGeom prst="flowChartConnector">
            <a:avLst/>
          </a:prstGeom>
          <a:solidFill>
            <a:schemeClr val="accent1"/>
          </a:solidFill>
          <a:ln w="254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endParaRPr lang="en-US" sz="5800">
              <a:solidFill>
                <a:srgbClr val="000000"/>
              </a:solidFill>
              <a:latin typeface="Gill Sans" charset="0"/>
              <a:ea typeface="ヒラギノ角ゴ ProN W3" charset="0"/>
              <a:cs typeface="ヒラギノ角ゴ ProN W3" charset="0"/>
              <a:sym typeface="Gill Sans" charset="0"/>
            </a:endParaRPr>
          </a:p>
        </p:txBody>
      </p:sp>
      <p:sp>
        <p:nvSpPr>
          <p:cNvPr id="5" name="Flowchart: Process 4">
            <a:extLst>
              <a:ext uri="{FF2B5EF4-FFF2-40B4-BE49-F238E27FC236}">
                <a16:creationId xmlns:a16="http://schemas.microsoft.com/office/drawing/2014/main" id="{D7E85303-2934-4F2D-9129-D9124F06A07B}"/>
              </a:ext>
            </a:extLst>
          </p:cNvPr>
          <p:cNvSpPr/>
          <p:nvPr/>
        </p:nvSpPr>
        <p:spPr bwMode="auto">
          <a:xfrm>
            <a:off x="2277800" y="1667076"/>
            <a:ext cx="1347395" cy="1330462"/>
          </a:xfrm>
          <a:prstGeom prst="flowChartProcess">
            <a:avLst/>
          </a:prstGeom>
          <a:solidFill>
            <a:schemeClr val="accent1"/>
          </a:solidFill>
          <a:ln w="254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endParaRPr lang="en-US" sz="5800">
              <a:solidFill>
                <a:srgbClr val="000000"/>
              </a:solidFill>
              <a:latin typeface="Gill Sans" charset="0"/>
              <a:ea typeface="ヒラギノ角ゴ ProN W3" charset="0"/>
              <a:cs typeface="ヒラギノ角ゴ ProN W3" charset="0"/>
              <a:sym typeface="Gill Sans" charset="0"/>
            </a:endParaRPr>
          </a:p>
        </p:txBody>
      </p:sp>
      <p:sp>
        <p:nvSpPr>
          <p:cNvPr id="6" name="Diamond 5">
            <a:extLst>
              <a:ext uri="{FF2B5EF4-FFF2-40B4-BE49-F238E27FC236}">
                <a16:creationId xmlns:a16="http://schemas.microsoft.com/office/drawing/2014/main" id="{F983E1A3-4820-4EFB-A7A0-C7C90D1C191E}"/>
              </a:ext>
            </a:extLst>
          </p:cNvPr>
          <p:cNvSpPr/>
          <p:nvPr/>
        </p:nvSpPr>
        <p:spPr bwMode="auto">
          <a:xfrm>
            <a:off x="3990900" y="1670650"/>
            <a:ext cx="1591683" cy="1388375"/>
          </a:xfrm>
          <a:prstGeom prst="diamond">
            <a:avLst/>
          </a:prstGeom>
          <a:solidFill>
            <a:schemeClr val="accent1"/>
          </a:solidFill>
          <a:ln w="254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endParaRPr lang="en-US" sz="5800">
              <a:solidFill>
                <a:srgbClr val="000000"/>
              </a:solidFill>
              <a:latin typeface="Gill Sans" charset="0"/>
              <a:ea typeface="ヒラギノ角ゴ ProN W3" charset="0"/>
              <a:cs typeface="ヒラギノ角ゴ ProN W3" charset="0"/>
              <a:sym typeface="Gill Sans" charset="0"/>
            </a:endParaRPr>
          </a:p>
        </p:txBody>
      </p:sp>
      <p:sp>
        <p:nvSpPr>
          <p:cNvPr id="7" name="Arrow: Right 6">
            <a:extLst>
              <a:ext uri="{FF2B5EF4-FFF2-40B4-BE49-F238E27FC236}">
                <a16:creationId xmlns:a16="http://schemas.microsoft.com/office/drawing/2014/main" id="{8C22146B-E93A-40E8-AE3D-4F6FD46641F7}"/>
              </a:ext>
            </a:extLst>
          </p:cNvPr>
          <p:cNvSpPr/>
          <p:nvPr/>
        </p:nvSpPr>
        <p:spPr bwMode="auto">
          <a:xfrm>
            <a:off x="6188318" y="2069614"/>
            <a:ext cx="1772529" cy="432526"/>
          </a:xfrm>
          <a:prstGeom prst="rightArrow">
            <a:avLst/>
          </a:prstGeom>
          <a:solidFill>
            <a:schemeClr val="accent1"/>
          </a:solidFill>
          <a:ln w="254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algn="ctr" fontAlgn="base">
              <a:spcBef>
                <a:spcPct val="0"/>
              </a:spcBef>
              <a:spcAft>
                <a:spcPct val="0"/>
              </a:spcAft>
            </a:pPr>
            <a:endParaRPr lang="en-US" sz="5800">
              <a:solidFill>
                <a:srgbClr val="000000"/>
              </a:solidFill>
              <a:latin typeface="Gill Sans" charset="0"/>
              <a:ea typeface="ヒラギノ角ゴ ProN W3" charset="0"/>
              <a:cs typeface="ヒラギノ角ゴ ProN W3" charset="0"/>
              <a:sym typeface="Gill Sans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CDAAA64-8A70-40E4-88F7-5B540A4E848E}"/>
              </a:ext>
            </a:extLst>
          </p:cNvPr>
          <p:cNvSpPr txBox="1"/>
          <p:nvPr/>
        </p:nvSpPr>
        <p:spPr>
          <a:xfrm>
            <a:off x="615444" y="2025894"/>
            <a:ext cx="86284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+mj-lt"/>
              </a:rPr>
              <a:t>Start/</a:t>
            </a:r>
          </a:p>
          <a:p>
            <a:r>
              <a:rPr lang="en-US" sz="1600" dirty="0">
                <a:latin typeface="+mj-lt"/>
              </a:rPr>
              <a:t>En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EB8B133-C8A8-4652-8B2D-B781B082E764}"/>
              </a:ext>
            </a:extLst>
          </p:cNvPr>
          <p:cNvSpPr txBox="1"/>
          <p:nvPr/>
        </p:nvSpPr>
        <p:spPr>
          <a:xfrm>
            <a:off x="2482351" y="2116599"/>
            <a:ext cx="8628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+mj-lt"/>
              </a:rPr>
              <a:t>Task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1571A5C-3BD2-4145-AD6D-CFE40CC23084}"/>
              </a:ext>
            </a:extLst>
          </p:cNvPr>
          <p:cNvSpPr txBox="1"/>
          <p:nvPr/>
        </p:nvSpPr>
        <p:spPr>
          <a:xfrm>
            <a:off x="4306661" y="1993490"/>
            <a:ext cx="103621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+mj-lt"/>
              </a:rPr>
              <a:t>Review/</a:t>
            </a:r>
          </a:p>
          <a:p>
            <a:r>
              <a:rPr lang="en-US" sz="1600" dirty="0">
                <a:latin typeface="+mj-lt"/>
              </a:rPr>
              <a:t>Decisio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F8B3654-C97F-40A1-BB1C-369EE24611FD}"/>
              </a:ext>
            </a:extLst>
          </p:cNvPr>
          <p:cNvSpPr txBox="1"/>
          <p:nvPr/>
        </p:nvSpPr>
        <p:spPr>
          <a:xfrm>
            <a:off x="6456313" y="2116600"/>
            <a:ext cx="11953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+mj-lt"/>
              </a:rPr>
              <a:t>Direction</a:t>
            </a:r>
          </a:p>
        </p:txBody>
      </p:sp>
    </p:spTree>
    <p:extLst>
      <p:ext uri="{BB962C8B-B14F-4D97-AF65-F5344CB8AC3E}">
        <p14:creationId xmlns:p14="http://schemas.microsoft.com/office/powerpoint/2010/main" val="18162351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2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FB0763-CADD-4B6F-BF93-531BAD60B4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2. Make a process map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5688F2-5EA8-4F54-A45C-4335C2CE5C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What information is missing?</a:t>
            </a:r>
          </a:p>
          <a:p>
            <a:pPr lvl="1"/>
            <a:r>
              <a:rPr lang="en-US" dirty="0"/>
              <a:t>Are there any steps that you are not sure about?</a:t>
            </a:r>
          </a:p>
          <a:p>
            <a:pPr lvl="1"/>
            <a:r>
              <a:rPr lang="en-US" dirty="0"/>
              <a:t>Where do you need to perform a </a:t>
            </a:r>
            <a:r>
              <a:rPr lang="en-US" dirty="0" err="1"/>
              <a:t>gemba</a:t>
            </a:r>
            <a:r>
              <a:rPr lang="en-US" dirty="0"/>
              <a:t> walk?</a:t>
            </a:r>
          </a:p>
          <a:p>
            <a:pPr lvl="1"/>
            <a:r>
              <a:rPr lang="en-US" dirty="0"/>
              <a:t>Who do you need to follow on a </a:t>
            </a:r>
            <a:r>
              <a:rPr lang="en-US" dirty="0" err="1"/>
              <a:t>gemba</a:t>
            </a:r>
            <a:r>
              <a:rPr lang="en-US" dirty="0"/>
              <a:t> walk?</a:t>
            </a:r>
          </a:p>
          <a:p>
            <a:pPr lvl="1"/>
            <a:r>
              <a:rPr lang="en-US" dirty="0"/>
              <a:t>Who do you need to interview to understand every step in the process?</a:t>
            </a:r>
          </a:p>
        </p:txBody>
      </p:sp>
    </p:spTree>
    <p:extLst>
      <p:ext uri="{BB962C8B-B14F-4D97-AF65-F5344CB8AC3E}">
        <p14:creationId xmlns:p14="http://schemas.microsoft.com/office/powerpoint/2010/main" val="7330080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DE273B-FDFC-4BA5-B094-32B7B33867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3. Make a fishbone diagra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7381EA-D022-470B-B3C6-C6ACB87A0E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US" sz="2400" b="1" dirty="0"/>
              <a:t>Purpose</a:t>
            </a:r>
            <a:r>
              <a:rPr lang="en-US" sz="2400" dirty="0"/>
              <a:t>: visual representation of all the root causes of the problem</a:t>
            </a:r>
          </a:p>
          <a:p>
            <a:r>
              <a:rPr lang="en-US" sz="2400" b="1" dirty="0"/>
              <a:t>Head of fish</a:t>
            </a:r>
            <a:r>
              <a:rPr lang="en-US" sz="2400" dirty="0"/>
              <a:t>: your problem</a:t>
            </a:r>
          </a:p>
          <a:p>
            <a:r>
              <a:rPr lang="en-US" sz="2400" b="1" dirty="0"/>
              <a:t>Scales</a:t>
            </a:r>
            <a:r>
              <a:rPr lang="en-US" sz="2400" dirty="0"/>
              <a:t>: Root causes</a:t>
            </a:r>
          </a:p>
          <a:p>
            <a:r>
              <a:rPr lang="en-US" sz="2400" dirty="0"/>
              <a:t>Organize root causes into your own groups or use suggested settings:</a:t>
            </a:r>
          </a:p>
          <a:p>
            <a:pPr lvl="1"/>
            <a:r>
              <a:rPr lang="en-US" dirty="0"/>
              <a:t>People (can break down further, </a:t>
            </a:r>
            <a:r>
              <a:rPr lang="en-US" dirty="0" err="1"/>
              <a:t>ie</a:t>
            </a:r>
            <a:r>
              <a:rPr lang="en-US" dirty="0"/>
              <a:t>: staff/provider, patient…)</a:t>
            </a:r>
          </a:p>
          <a:p>
            <a:pPr lvl="1"/>
            <a:r>
              <a:rPr lang="en-US" dirty="0"/>
              <a:t>Environment</a:t>
            </a:r>
          </a:p>
          <a:p>
            <a:pPr lvl="1"/>
            <a:r>
              <a:rPr lang="en-US" dirty="0"/>
              <a:t>Materials</a:t>
            </a:r>
          </a:p>
          <a:p>
            <a:pPr lvl="1"/>
            <a:r>
              <a:rPr lang="en-US" dirty="0"/>
              <a:t>Methods</a:t>
            </a:r>
          </a:p>
          <a:p>
            <a:pPr lvl="1"/>
            <a:r>
              <a:rPr lang="en-US" dirty="0"/>
              <a:t>Equipment</a:t>
            </a:r>
          </a:p>
          <a:p>
            <a:pPr lvl="1"/>
            <a:r>
              <a:rPr lang="en-US" dirty="0"/>
              <a:t>Other suggestions: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31911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0</TotalTime>
  <Words>974</Words>
  <Application>Microsoft Office PowerPoint</Application>
  <PresentationFormat>On-screen Show (4:3)</PresentationFormat>
  <Paragraphs>189</Paragraphs>
  <Slides>24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4</vt:i4>
      </vt:variant>
    </vt:vector>
  </HeadingPairs>
  <TitlesOfParts>
    <vt:vector size="31" baseType="lpstr">
      <vt:lpstr>Arial</vt:lpstr>
      <vt:lpstr>Calibri</vt:lpstr>
      <vt:lpstr>Calibri Light</vt:lpstr>
      <vt:lpstr>Georgia</vt:lpstr>
      <vt:lpstr>Gill Sans</vt:lpstr>
      <vt:lpstr>Times New Roman</vt:lpstr>
      <vt:lpstr>Office Theme</vt:lpstr>
      <vt:lpstr> Quality Improvement</vt:lpstr>
      <vt:lpstr>How to use the workbook </vt:lpstr>
      <vt:lpstr>1. Write a problem statement</vt:lpstr>
      <vt:lpstr>1. Problem Statement </vt:lpstr>
      <vt:lpstr>1. Write a problem statement</vt:lpstr>
      <vt:lpstr>2. Make a process map</vt:lpstr>
      <vt:lpstr>2. Process Map</vt:lpstr>
      <vt:lpstr>2. Make a process map </vt:lpstr>
      <vt:lpstr>3. Make a fishbone diagram</vt:lpstr>
      <vt:lpstr>3. Fishbone Diagram</vt:lpstr>
      <vt:lpstr>3. Make a fishbone diagram</vt:lpstr>
      <vt:lpstr>4. Write an aim statement  </vt:lpstr>
      <vt:lpstr>4. Write an aim statement</vt:lpstr>
      <vt:lpstr>4. Aim Statement</vt:lpstr>
      <vt:lpstr>4. Write an aim statement</vt:lpstr>
      <vt:lpstr>Stop Here</vt:lpstr>
      <vt:lpstr>5. Choosing an intervention </vt:lpstr>
      <vt:lpstr>Brainstorming Interventions </vt:lpstr>
      <vt:lpstr>5. Choosing an intervention</vt:lpstr>
      <vt:lpstr>5. Intervention Ideas Organize your interventions using the Impact/Effort grid</vt:lpstr>
      <vt:lpstr>6. Assign Intervention/Action Hierarchy </vt:lpstr>
      <vt:lpstr>Stop Here</vt:lpstr>
      <vt:lpstr>7. Form Data Collection Plan</vt:lpstr>
      <vt:lpstr>7. Data Collection pla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Quality Improvement Session 2</dc:title>
  <dc:creator>Gruen, Jadry</dc:creator>
  <cp:lastModifiedBy>Xiang,Jenny Jing</cp:lastModifiedBy>
  <cp:revision>18</cp:revision>
  <dcterms:created xsi:type="dcterms:W3CDTF">2020-09-03T16:33:47Z</dcterms:created>
  <dcterms:modified xsi:type="dcterms:W3CDTF">2022-12-16T21:06:01Z</dcterms:modified>
</cp:coreProperties>
</file>